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66" r:id="rId1"/>
  </p:sldMasterIdLst>
  <p:notesMasterIdLst>
    <p:notesMasterId r:id="rId3"/>
  </p:notesMasterIdLst>
  <p:handoutMasterIdLst>
    <p:handoutMasterId r:id="rId4"/>
  </p:handoutMasterIdLst>
  <p:sldIdLst>
    <p:sldId id="770" r:id="rId2"/>
  </p:sldIdLst>
  <p:sldSz cx="21599525" cy="14400213"/>
  <p:notesSz cx="6735763" cy="9872663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sz="5400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1pPr>
    <a:lvl2pPr marL="1028553" algn="l" rtl="0" fontAlgn="base">
      <a:spcBef>
        <a:spcPct val="0"/>
      </a:spcBef>
      <a:spcAft>
        <a:spcPct val="0"/>
      </a:spcAft>
      <a:defRPr kumimoji="1" sz="5400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2pPr>
    <a:lvl3pPr marL="2057105" algn="l" rtl="0" fontAlgn="base">
      <a:spcBef>
        <a:spcPct val="0"/>
      </a:spcBef>
      <a:spcAft>
        <a:spcPct val="0"/>
      </a:spcAft>
      <a:defRPr kumimoji="1" sz="5400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3pPr>
    <a:lvl4pPr marL="3085658" algn="l" rtl="0" fontAlgn="base">
      <a:spcBef>
        <a:spcPct val="0"/>
      </a:spcBef>
      <a:spcAft>
        <a:spcPct val="0"/>
      </a:spcAft>
      <a:defRPr kumimoji="1" sz="5400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4pPr>
    <a:lvl5pPr marL="4114209" algn="l" rtl="0" fontAlgn="base">
      <a:spcBef>
        <a:spcPct val="0"/>
      </a:spcBef>
      <a:spcAft>
        <a:spcPct val="0"/>
      </a:spcAft>
      <a:defRPr kumimoji="1" sz="5400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5pPr>
    <a:lvl6pPr marL="5142762" algn="l" defTabSz="2057105" rtl="0" eaLnBrk="1" latinLnBrk="0" hangingPunct="1">
      <a:defRPr kumimoji="1" sz="5400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6pPr>
    <a:lvl7pPr marL="6171314" algn="l" defTabSz="2057105" rtl="0" eaLnBrk="1" latinLnBrk="0" hangingPunct="1">
      <a:defRPr kumimoji="1" sz="5400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7pPr>
    <a:lvl8pPr marL="7199867" algn="l" defTabSz="2057105" rtl="0" eaLnBrk="1" latinLnBrk="0" hangingPunct="1">
      <a:defRPr kumimoji="1" sz="5400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8pPr>
    <a:lvl9pPr marL="8228418" algn="l" defTabSz="2057105" rtl="0" eaLnBrk="1" latinLnBrk="0" hangingPunct="1">
      <a:defRPr kumimoji="1" sz="5400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536" userDrawn="1">
          <p15:clr>
            <a:srgbClr val="A4A3A4"/>
          </p15:clr>
        </p15:guide>
        <p15:guide id="2" pos="680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辻尾 元" initials="辻尾" lastIdx="1" clrIdx="0">
    <p:extLst>
      <p:ext uri="{19B8F6BF-5375-455C-9EA6-DF929625EA0E}">
        <p15:presenceInfo xmlns:p15="http://schemas.microsoft.com/office/powerpoint/2012/main" userId="5b38a7427de62951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6D9F1"/>
    <a:srgbClr val="0070C0"/>
    <a:srgbClr val="C0504D"/>
    <a:srgbClr val="FFFF66"/>
    <a:srgbClr val="FFFF99"/>
    <a:srgbClr val="FF0000"/>
    <a:srgbClr val="FFFF00"/>
    <a:srgbClr val="BB353F"/>
    <a:srgbClr val="953735"/>
    <a:srgbClr val="FF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775DCB02-9BB8-47FD-8907-85C794F793BA}" styleName="テーマ スタイル 1 - アクセント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85BE263C-DBD7-4A20-BB59-AAB30ACAA65A}" styleName="中間スタイル 3 - アクセント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9DCAF9ED-07DC-4A11-8D7F-57B35C25682E}" styleName="中間スタイル 1 - アクセント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2">
              <a:tint val="20000"/>
            </a:schemeClr>
          </a:solidFill>
        </a:fill>
      </a:tcStyle>
    </a:band1H>
    <a:band1V>
      <a:tcStyle>
        <a:tcBdr/>
        <a:fill>
          <a:solidFill>
            <a:schemeClr val="accent2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0E3FDE45-AF77-4B5C-9715-49D594BDF05E}" styleName="淡色 1 - アクセント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D7AC3CCA-C797-4891-BE02-D94E43425B78}" styleName="スタイル (中間)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196" autoAdjust="0"/>
    <p:restoredTop sz="95797" autoAdjust="0"/>
  </p:normalViewPr>
  <p:slideViewPr>
    <p:cSldViewPr>
      <p:cViewPr varScale="1">
        <p:scale>
          <a:sx n="44" d="100"/>
          <a:sy n="44" d="100"/>
        </p:scale>
        <p:origin x="609" y="72"/>
      </p:cViewPr>
      <p:guideLst>
        <p:guide orient="horz" pos="4536"/>
        <p:guide pos="680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25" d="100"/>
        <a:sy n="125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18830" cy="493634"/>
          </a:xfrm>
          <a:prstGeom prst="rect">
            <a:avLst/>
          </a:prstGeom>
        </p:spPr>
        <p:txBody>
          <a:bodyPr vert="horz" lIns="90789" tIns="45396" rIns="90789" bIns="45396" rtlCol="0"/>
          <a:lstStyle>
            <a:lvl1pPr algn="l" eaLnBrk="0" hangingPunct="0">
              <a:defRPr sz="12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815375" y="0"/>
            <a:ext cx="2918830" cy="493634"/>
          </a:xfrm>
          <a:prstGeom prst="rect">
            <a:avLst/>
          </a:prstGeom>
        </p:spPr>
        <p:txBody>
          <a:bodyPr vert="horz" lIns="90789" tIns="45396" rIns="90789" bIns="45396" rtlCol="0"/>
          <a:lstStyle>
            <a:lvl1pPr algn="r" eaLnBrk="0" hangingPunct="0">
              <a:defRPr sz="120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charset="0"/>
              </a:defRPr>
            </a:lvl1pPr>
          </a:lstStyle>
          <a:p>
            <a:pPr>
              <a:defRPr/>
            </a:pPr>
            <a:fld id="{BAB24137-5742-4B3E-A79A-3684648F81CC}" type="datetimeFigureOut">
              <a:rPr lang="ja-JP" altLang="en-US"/>
              <a:pPr>
                <a:defRPr/>
              </a:pPr>
              <a:t>2022/5/6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1" y="9377317"/>
            <a:ext cx="2918830" cy="493634"/>
          </a:xfrm>
          <a:prstGeom prst="rect">
            <a:avLst/>
          </a:prstGeom>
        </p:spPr>
        <p:txBody>
          <a:bodyPr vert="horz" lIns="90789" tIns="45396" rIns="90789" bIns="45396" rtlCol="0" anchor="b"/>
          <a:lstStyle>
            <a:lvl1pPr algn="l" eaLnBrk="0" hangingPunct="0">
              <a:defRPr sz="12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815375" y="9377317"/>
            <a:ext cx="2918830" cy="493634"/>
          </a:xfrm>
          <a:prstGeom prst="rect">
            <a:avLst/>
          </a:prstGeom>
        </p:spPr>
        <p:txBody>
          <a:bodyPr vert="horz" lIns="90789" tIns="45396" rIns="90789" bIns="45396" rtlCol="0" anchor="b"/>
          <a:lstStyle>
            <a:lvl1pPr algn="r" eaLnBrk="0" hangingPunct="0">
              <a:defRPr sz="120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charset="0"/>
              </a:defRPr>
            </a:lvl1pPr>
          </a:lstStyle>
          <a:p>
            <a:pPr>
              <a:defRPr/>
            </a:pPr>
            <a:fld id="{7B7994E9-A89E-46A0-AADA-2EAFA61754C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14171224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565" cy="494186"/>
          </a:xfrm>
          <a:prstGeom prst="rect">
            <a:avLst/>
          </a:prstGeom>
        </p:spPr>
        <p:txBody>
          <a:bodyPr vert="horz" lIns="90789" tIns="45396" rIns="90789" bIns="45396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14627" y="0"/>
            <a:ext cx="2919565" cy="494186"/>
          </a:xfrm>
          <a:prstGeom prst="rect">
            <a:avLst/>
          </a:prstGeom>
        </p:spPr>
        <p:txBody>
          <a:bodyPr vert="horz" lIns="90789" tIns="45396" rIns="90789" bIns="45396" rtlCol="0"/>
          <a:lstStyle>
            <a:lvl1pPr algn="r">
              <a:defRPr sz="1200"/>
            </a:lvl1pPr>
          </a:lstStyle>
          <a:p>
            <a:fld id="{775A4D1E-C180-47C5-90C2-EC31E2EF606E}" type="datetimeFigureOut">
              <a:rPr kumimoji="1" lang="ja-JP" altLang="en-US" smtClean="0"/>
              <a:pPr/>
              <a:t>2022/5/6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590550" y="739775"/>
            <a:ext cx="5554663" cy="37036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789" tIns="45396" rIns="90789" bIns="45396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73263" y="4689239"/>
            <a:ext cx="5389240" cy="4442935"/>
          </a:xfrm>
          <a:prstGeom prst="rect">
            <a:avLst/>
          </a:prstGeom>
        </p:spPr>
        <p:txBody>
          <a:bodyPr vert="horz" lIns="90789" tIns="45396" rIns="90789" bIns="45396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9376900"/>
            <a:ext cx="2919565" cy="494185"/>
          </a:xfrm>
          <a:prstGeom prst="rect">
            <a:avLst/>
          </a:prstGeom>
        </p:spPr>
        <p:txBody>
          <a:bodyPr vert="horz" lIns="90789" tIns="45396" rIns="90789" bIns="45396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14627" y="9376900"/>
            <a:ext cx="2919565" cy="494185"/>
          </a:xfrm>
          <a:prstGeom prst="rect">
            <a:avLst/>
          </a:prstGeom>
        </p:spPr>
        <p:txBody>
          <a:bodyPr vert="horz" lIns="90789" tIns="45396" rIns="90789" bIns="45396" rtlCol="0" anchor="b"/>
          <a:lstStyle>
            <a:lvl1pPr algn="r">
              <a:defRPr sz="1200"/>
            </a:lvl1pPr>
          </a:lstStyle>
          <a:p>
            <a:fld id="{6A956877-6CB6-4043-A64C-60D60965A96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52307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2057105" rtl="0" eaLnBrk="1" latinLnBrk="0" hangingPunct="1">
      <a:defRPr kumimoji="1" sz="2700" kern="1200">
        <a:solidFill>
          <a:schemeClr val="tx1"/>
        </a:solidFill>
        <a:latin typeface="+mn-lt"/>
        <a:ea typeface="+mn-ea"/>
        <a:cs typeface="+mn-cs"/>
      </a:defRPr>
    </a:lvl1pPr>
    <a:lvl2pPr marL="1028553" algn="l" defTabSz="2057105" rtl="0" eaLnBrk="1" latinLnBrk="0" hangingPunct="1">
      <a:defRPr kumimoji="1" sz="2700" kern="1200">
        <a:solidFill>
          <a:schemeClr val="tx1"/>
        </a:solidFill>
        <a:latin typeface="+mn-lt"/>
        <a:ea typeface="+mn-ea"/>
        <a:cs typeface="+mn-cs"/>
      </a:defRPr>
    </a:lvl2pPr>
    <a:lvl3pPr marL="2057105" algn="l" defTabSz="2057105" rtl="0" eaLnBrk="1" latinLnBrk="0" hangingPunct="1">
      <a:defRPr kumimoji="1" sz="2700" kern="1200">
        <a:solidFill>
          <a:schemeClr val="tx1"/>
        </a:solidFill>
        <a:latin typeface="+mn-lt"/>
        <a:ea typeface="+mn-ea"/>
        <a:cs typeface="+mn-cs"/>
      </a:defRPr>
    </a:lvl3pPr>
    <a:lvl4pPr marL="3085658" algn="l" defTabSz="2057105" rtl="0" eaLnBrk="1" latinLnBrk="0" hangingPunct="1">
      <a:defRPr kumimoji="1" sz="2700" kern="1200">
        <a:solidFill>
          <a:schemeClr val="tx1"/>
        </a:solidFill>
        <a:latin typeface="+mn-lt"/>
        <a:ea typeface="+mn-ea"/>
        <a:cs typeface="+mn-cs"/>
      </a:defRPr>
    </a:lvl4pPr>
    <a:lvl5pPr marL="4114209" algn="l" defTabSz="2057105" rtl="0" eaLnBrk="1" latinLnBrk="0" hangingPunct="1">
      <a:defRPr kumimoji="1" sz="2700" kern="1200">
        <a:solidFill>
          <a:schemeClr val="tx1"/>
        </a:solidFill>
        <a:latin typeface="+mn-lt"/>
        <a:ea typeface="+mn-ea"/>
        <a:cs typeface="+mn-cs"/>
      </a:defRPr>
    </a:lvl5pPr>
    <a:lvl6pPr marL="5142762" algn="l" defTabSz="2057105" rtl="0" eaLnBrk="1" latinLnBrk="0" hangingPunct="1">
      <a:defRPr kumimoji="1" sz="2700" kern="1200">
        <a:solidFill>
          <a:schemeClr val="tx1"/>
        </a:solidFill>
        <a:latin typeface="+mn-lt"/>
        <a:ea typeface="+mn-ea"/>
        <a:cs typeface="+mn-cs"/>
      </a:defRPr>
    </a:lvl6pPr>
    <a:lvl7pPr marL="6171314" algn="l" defTabSz="2057105" rtl="0" eaLnBrk="1" latinLnBrk="0" hangingPunct="1">
      <a:defRPr kumimoji="1" sz="2700" kern="1200">
        <a:solidFill>
          <a:schemeClr val="tx1"/>
        </a:solidFill>
        <a:latin typeface="+mn-lt"/>
        <a:ea typeface="+mn-ea"/>
        <a:cs typeface="+mn-cs"/>
      </a:defRPr>
    </a:lvl7pPr>
    <a:lvl8pPr marL="7199867" algn="l" defTabSz="2057105" rtl="0" eaLnBrk="1" latinLnBrk="0" hangingPunct="1">
      <a:defRPr kumimoji="1" sz="2700" kern="1200">
        <a:solidFill>
          <a:schemeClr val="tx1"/>
        </a:solidFill>
        <a:latin typeface="+mn-lt"/>
        <a:ea typeface="+mn-ea"/>
        <a:cs typeface="+mn-cs"/>
      </a:defRPr>
    </a:lvl8pPr>
    <a:lvl9pPr marL="8228418" algn="l" defTabSz="2057105" rtl="0" eaLnBrk="1" latinLnBrk="0" hangingPunct="1">
      <a:defRPr kumimoji="1" sz="27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619965" y="4473400"/>
            <a:ext cx="18359597" cy="3086713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3239930" y="8160120"/>
            <a:ext cx="15119667" cy="368005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999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19996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7999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3999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9999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59990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1998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7998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220AC469-71BB-41B1-8997-C223F682A29D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B1E8B467-97F0-4AFF-B85C-018988F47EB3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15659657" y="576678"/>
            <a:ext cx="4859893" cy="12286848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1079976" y="576678"/>
            <a:ext cx="14219687" cy="12286848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23FFF35B-6AC4-4245-8DC7-DE93781B32D4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D3C9CD2D-B439-4FF2-A893-B6DEF1DB56B8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06213" y="9253471"/>
            <a:ext cx="18359597" cy="2860042"/>
          </a:xfrm>
        </p:spPr>
        <p:txBody>
          <a:bodyPr anchor="t"/>
          <a:lstStyle>
            <a:lvl1pPr algn="l">
              <a:defRPr sz="5249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1706213" y="6103426"/>
            <a:ext cx="18359597" cy="3150045"/>
          </a:xfrm>
        </p:spPr>
        <p:txBody>
          <a:bodyPr anchor="b"/>
          <a:lstStyle>
            <a:lvl1pPr marL="0" indent="0">
              <a:buNone/>
              <a:defRPr sz="2625">
                <a:solidFill>
                  <a:schemeClr val="tx1">
                    <a:tint val="75000"/>
                  </a:schemeClr>
                </a:solidFill>
              </a:defRPr>
            </a:lvl1pPr>
            <a:lvl2pPr marL="599984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2pPr>
            <a:lvl3pPr marL="1199967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3pPr>
            <a:lvl4pPr marL="1799951" indent="0">
              <a:buNone/>
              <a:defRPr sz="1837">
                <a:solidFill>
                  <a:schemeClr val="tx1">
                    <a:tint val="75000"/>
                  </a:schemeClr>
                </a:solidFill>
              </a:defRPr>
            </a:lvl4pPr>
            <a:lvl5pPr marL="2399934" indent="0">
              <a:buNone/>
              <a:defRPr sz="1837">
                <a:solidFill>
                  <a:schemeClr val="tx1">
                    <a:tint val="75000"/>
                  </a:schemeClr>
                </a:solidFill>
              </a:defRPr>
            </a:lvl5pPr>
            <a:lvl6pPr marL="2999918" indent="0">
              <a:buNone/>
              <a:defRPr sz="1837">
                <a:solidFill>
                  <a:schemeClr val="tx1">
                    <a:tint val="75000"/>
                  </a:schemeClr>
                </a:solidFill>
              </a:defRPr>
            </a:lvl6pPr>
            <a:lvl7pPr marL="3599901" indent="0">
              <a:buNone/>
              <a:defRPr sz="1837">
                <a:solidFill>
                  <a:schemeClr val="tx1">
                    <a:tint val="75000"/>
                  </a:schemeClr>
                </a:solidFill>
              </a:defRPr>
            </a:lvl7pPr>
            <a:lvl8pPr marL="4199885" indent="0">
              <a:buNone/>
              <a:defRPr sz="1837">
                <a:solidFill>
                  <a:schemeClr val="tx1">
                    <a:tint val="75000"/>
                  </a:schemeClr>
                </a:solidFill>
              </a:defRPr>
            </a:lvl8pPr>
            <a:lvl9pPr marL="4799868" indent="0">
              <a:buNone/>
              <a:defRPr sz="183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4D17199A-61D9-4C6D-BBE0-36679B930E94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1079977" y="3360052"/>
            <a:ext cx="9539790" cy="9503475"/>
          </a:xfrm>
        </p:spPr>
        <p:txBody>
          <a:bodyPr/>
          <a:lstStyle>
            <a:lvl1pPr>
              <a:defRPr sz="3674"/>
            </a:lvl1pPr>
            <a:lvl2pPr>
              <a:defRPr sz="3150"/>
            </a:lvl2pPr>
            <a:lvl3pPr>
              <a:defRPr sz="2625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10979759" y="3360052"/>
            <a:ext cx="9539790" cy="9503475"/>
          </a:xfrm>
        </p:spPr>
        <p:txBody>
          <a:bodyPr/>
          <a:lstStyle>
            <a:lvl1pPr>
              <a:defRPr sz="3674"/>
            </a:lvl1pPr>
            <a:lvl2pPr>
              <a:defRPr sz="3150"/>
            </a:lvl2pPr>
            <a:lvl3pPr>
              <a:defRPr sz="2625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6B76B9CD-2920-4F76-8EB8-F358130F25A7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1079977" y="3223381"/>
            <a:ext cx="9543541" cy="1343353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1079977" y="4566735"/>
            <a:ext cx="9543541" cy="8296790"/>
          </a:xfrm>
        </p:spPr>
        <p:txBody>
          <a:bodyPr/>
          <a:lstStyle>
            <a:lvl1pPr>
              <a:defRPr sz="3150"/>
            </a:lvl1pPr>
            <a:lvl2pPr>
              <a:defRPr sz="2625"/>
            </a:lvl2pPr>
            <a:lvl3pPr>
              <a:defRPr sz="2362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10972261" y="3223381"/>
            <a:ext cx="9547290" cy="1343353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10972261" y="4566735"/>
            <a:ext cx="9547290" cy="8296790"/>
          </a:xfrm>
        </p:spPr>
        <p:txBody>
          <a:bodyPr/>
          <a:lstStyle>
            <a:lvl1pPr>
              <a:defRPr sz="3150"/>
            </a:lvl1pPr>
            <a:lvl2pPr>
              <a:defRPr sz="2625"/>
            </a:lvl2pPr>
            <a:lvl3pPr>
              <a:defRPr sz="2362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2859AA0E-4CB9-4CC5-BCF5-28865F401718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13670466-03AE-43EE-A795-21E3DD220E67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A4344379-6777-4264-92F5-784CF98DA49B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9977" y="573342"/>
            <a:ext cx="7106095" cy="2440037"/>
          </a:xfrm>
        </p:spPr>
        <p:txBody>
          <a:bodyPr anchor="b"/>
          <a:lstStyle>
            <a:lvl1pPr algn="l">
              <a:defRPr sz="2625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8444815" y="573344"/>
            <a:ext cx="12074735" cy="12290182"/>
          </a:xfrm>
        </p:spPr>
        <p:txBody>
          <a:bodyPr/>
          <a:lstStyle>
            <a:lvl1pPr>
              <a:defRPr sz="4199"/>
            </a:lvl1pPr>
            <a:lvl2pPr>
              <a:defRPr sz="3674"/>
            </a:lvl2pPr>
            <a:lvl3pPr>
              <a:defRPr sz="3150"/>
            </a:lvl3pPr>
            <a:lvl4pPr>
              <a:defRPr sz="2625"/>
            </a:lvl4pPr>
            <a:lvl5pPr>
              <a:defRPr sz="2625"/>
            </a:lvl5pPr>
            <a:lvl6pPr>
              <a:defRPr sz="2625"/>
            </a:lvl6pPr>
            <a:lvl7pPr>
              <a:defRPr sz="2625"/>
            </a:lvl7pPr>
            <a:lvl8pPr>
              <a:defRPr sz="2625"/>
            </a:lvl8pPr>
            <a:lvl9pPr>
              <a:defRPr sz="2625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079977" y="3013379"/>
            <a:ext cx="7106095" cy="9850147"/>
          </a:xfrm>
        </p:spPr>
        <p:txBody>
          <a:bodyPr/>
          <a:lstStyle>
            <a:lvl1pPr marL="0" indent="0">
              <a:buNone/>
              <a:defRPr sz="1837"/>
            </a:lvl1pPr>
            <a:lvl2pPr marL="599984" indent="0">
              <a:buNone/>
              <a:defRPr sz="1575"/>
            </a:lvl2pPr>
            <a:lvl3pPr marL="1199967" indent="0">
              <a:buNone/>
              <a:defRPr sz="1312"/>
            </a:lvl3pPr>
            <a:lvl4pPr marL="1799951" indent="0">
              <a:buNone/>
              <a:defRPr sz="1181"/>
            </a:lvl4pPr>
            <a:lvl5pPr marL="2399934" indent="0">
              <a:buNone/>
              <a:defRPr sz="1181"/>
            </a:lvl5pPr>
            <a:lvl6pPr marL="2999918" indent="0">
              <a:buNone/>
              <a:defRPr sz="1181"/>
            </a:lvl6pPr>
            <a:lvl7pPr marL="3599901" indent="0">
              <a:buNone/>
              <a:defRPr sz="1181"/>
            </a:lvl7pPr>
            <a:lvl8pPr marL="4199885" indent="0">
              <a:buNone/>
              <a:defRPr sz="1181"/>
            </a:lvl8pPr>
            <a:lvl9pPr marL="4799868" indent="0">
              <a:buNone/>
              <a:defRPr sz="118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1D929B7F-72A6-46AA-B866-EB5034C22E24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233658" y="10080150"/>
            <a:ext cx="12959715" cy="1190018"/>
          </a:xfrm>
        </p:spPr>
        <p:txBody>
          <a:bodyPr anchor="b"/>
          <a:lstStyle>
            <a:lvl1pPr algn="l">
              <a:defRPr sz="2625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4233658" y="1286686"/>
            <a:ext cx="12959715" cy="8640128"/>
          </a:xfrm>
        </p:spPr>
        <p:txBody>
          <a:bodyPr/>
          <a:lstStyle>
            <a:lvl1pPr marL="0" indent="0">
              <a:buNone/>
              <a:defRPr sz="4199"/>
            </a:lvl1pPr>
            <a:lvl2pPr marL="599984" indent="0">
              <a:buNone/>
              <a:defRPr sz="3674"/>
            </a:lvl2pPr>
            <a:lvl3pPr marL="1199967" indent="0">
              <a:buNone/>
              <a:defRPr sz="3150"/>
            </a:lvl3pPr>
            <a:lvl4pPr marL="1799951" indent="0">
              <a:buNone/>
              <a:defRPr sz="2625"/>
            </a:lvl4pPr>
            <a:lvl5pPr marL="2399934" indent="0">
              <a:buNone/>
              <a:defRPr sz="2625"/>
            </a:lvl5pPr>
            <a:lvl6pPr marL="2999918" indent="0">
              <a:buNone/>
              <a:defRPr sz="2625"/>
            </a:lvl6pPr>
            <a:lvl7pPr marL="3599901" indent="0">
              <a:buNone/>
              <a:defRPr sz="2625"/>
            </a:lvl7pPr>
            <a:lvl8pPr marL="4199885" indent="0">
              <a:buNone/>
              <a:defRPr sz="2625"/>
            </a:lvl8pPr>
            <a:lvl9pPr marL="4799868" indent="0">
              <a:buNone/>
              <a:defRPr sz="2625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233658" y="11270168"/>
            <a:ext cx="12959715" cy="1690024"/>
          </a:xfrm>
        </p:spPr>
        <p:txBody>
          <a:bodyPr/>
          <a:lstStyle>
            <a:lvl1pPr marL="0" indent="0">
              <a:buNone/>
              <a:defRPr sz="1837"/>
            </a:lvl1pPr>
            <a:lvl2pPr marL="599984" indent="0">
              <a:buNone/>
              <a:defRPr sz="1575"/>
            </a:lvl2pPr>
            <a:lvl3pPr marL="1199967" indent="0">
              <a:buNone/>
              <a:defRPr sz="1312"/>
            </a:lvl3pPr>
            <a:lvl4pPr marL="1799951" indent="0">
              <a:buNone/>
              <a:defRPr sz="1181"/>
            </a:lvl4pPr>
            <a:lvl5pPr marL="2399934" indent="0">
              <a:buNone/>
              <a:defRPr sz="1181"/>
            </a:lvl5pPr>
            <a:lvl6pPr marL="2999918" indent="0">
              <a:buNone/>
              <a:defRPr sz="1181"/>
            </a:lvl6pPr>
            <a:lvl7pPr marL="3599901" indent="0">
              <a:buNone/>
              <a:defRPr sz="1181"/>
            </a:lvl7pPr>
            <a:lvl8pPr marL="4199885" indent="0">
              <a:buNone/>
              <a:defRPr sz="1181"/>
            </a:lvl8pPr>
            <a:lvl9pPr marL="4799868" indent="0">
              <a:buNone/>
              <a:defRPr sz="118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D08F180D-083C-4552-863A-21173A54C15A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1079977" y="576677"/>
            <a:ext cx="19439573" cy="24000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1079977" y="3360052"/>
            <a:ext cx="19439573" cy="950347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1079976" y="13346865"/>
            <a:ext cx="503989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7379838" y="13346865"/>
            <a:ext cx="683985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15479660" y="13346865"/>
            <a:ext cx="503989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3FF6C96D-6AD5-404C-BADF-0C9A094A0A73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7" r:id="rId1"/>
    <p:sldLayoutId id="2147483668" r:id="rId2"/>
    <p:sldLayoutId id="2147483669" r:id="rId3"/>
    <p:sldLayoutId id="2147483670" r:id="rId4"/>
    <p:sldLayoutId id="2147483671" r:id="rId5"/>
    <p:sldLayoutId id="2147483672" r:id="rId6"/>
    <p:sldLayoutId id="2147483673" r:id="rId7"/>
    <p:sldLayoutId id="2147483674" r:id="rId8"/>
    <p:sldLayoutId id="2147483675" r:id="rId9"/>
    <p:sldLayoutId id="2147483676" r:id="rId10"/>
    <p:sldLayoutId id="2147483677" r:id="rId11"/>
  </p:sldLayoutIdLst>
  <p:txStyles>
    <p:titleStyle>
      <a:lvl1pPr algn="ctr" defTabSz="1199967" rtl="0" eaLnBrk="1" latinLnBrk="0" hangingPunct="1">
        <a:spcBef>
          <a:spcPct val="0"/>
        </a:spcBef>
        <a:buNone/>
        <a:defRPr kumimoji="1" sz="577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49988" indent="-449988" algn="l" defTabSz="1199967" rtl="0" eaLnBrk="1" latinLnBrk="0" hangingPunct="1">
        <a:spcBef>
          <a:spcPct val="20000"/>
        </a:spcBef>
        <a:buFont typeface="Arial" pitchFamily="34" charset="0"/>
        <a:buChar char="•"/>
        <a:defRPr kumimoji="1" sz="4199" kern="1200">
          <a:solidFill>
            <a:schemeClr val="tx1"/>
          </a:solidFill>
          <a:latin typeface="+mn-lt"/>
          <a:ea typeface="+mn-ea"/>
          <a:cs typeface="+mn-cs"/>
        </a:defRPr>
      </a:lvl1pPr>
      <a:lvl2pPr marL="974973" indent="-374990" algn="l" defTabSz="1199967" rtl="0" eaLnBrk="1" latinLnBrk="0" hangingPunct="1">
        <a:spcBef>
          <a:spcPct val="20000"/>
        </a:spcBef>
        <a:buFont typeface="Arial" pitchFamily="34" charset="0"/>
        <a:buChar char="–"/>
        <a:defRPr kumimoji="1" sz="3674" kern="1200">
          <a:solidFill>
            <a:schemeClr val="tx1"/>
          </a:solidFill>
          <a:latin typeface="+mn-lt"/>
          <a:ea typeface="+mn-ea"/>
          <a:cs typeface="+mn-cs"/>
        </a:defRPr>
      </a:lvl2pPr>
      <a:lvl3pPr marL="1499959" indent="-299992" algn="l" defTabSz="1199967" rtl="0" eaLnBrk="1" latinLnBrk="0" hangingPunct="1">
        <a:spcBef>
          <a:spcPct val="20000"/>
        </a:spcBef>
        <a:buFont typeface="Arial" pitchFamily="34" charset="0"/>
        <a:buChar char="•"/>
        <a:defRPr kumimoji="1" sz="3150" kern="1200">
          <a:solidFill>
            <a:schemeClr val="tx1"/>
          </a:solidFill>
          <a:latin typeface="+mn-lt"/>
          <a:ea typeface="+mn-ea"/>
          <a:cs typeface="+mn-cs"/>
        </a:defRPr>
      </a:lvl3pPr>
      <a:lvl4pPr marL="2099942" indent="-299992" algn="l" defTabSz="1199967" rtl="0" eaLnBrk="1" latinLnBrk="0" hangingPunct="1">
        <a:spcBef>
          <a:spcPct val="20000"/>
        </a:spcBef>
        <a:buFont typeface="Arial" pitchFamily="34" charset="0"/>
        <a:buChar char="–"/>
        <a:defRPr kumimoji="1" sz="2625" kern="1200">
          <a:solidFill>
            <a:schemeClr val="tx1"/>
          </a:solidFill>
          <a:latin typeface="+mn-lt"/>
          <a:ea typeface="+mn-ea"/>
          <a:cs typeface="+mn-cs"/>
        </a:defRPr>
      </a:lvl4pPr>
      <a:lvl5pPr marL="2699926" indent="-299992" algn="l" defTabSz="1199967" rtl="0" eaLnBrk="1" latinLnBrk="0" hangingPunct="1">
        <a:spcBef>
          <a:spcPct val="20000"/>
        </a:spcBef>
        <a:buFont typeface="Arial" pitchFamily="34" charset="0"/>
        <a:buChar char="»"/>
        <a:defRPr kumimoji="1" sz="2625" kern="1200">
          <a:solidFill>
            <a:schemeClr val="tx1"/>
          </a:solidFill>
          <a:latin typeface="+mn-lt"/>
          <a:ea typeface="+mn-ea"/>
          <a:cs typeface="+mn-cs"/>
        </a:defRPr>
      </a:lvl5pPr>
      <a:lvl6pPr marL="3299910" indent="-299992" algn="l" defTabSz="1199967" rtl="0" eaLnBrk="1" latinLnBrk="0" hangingPunct="1">
        <a:spcBef>
          <a:spcPct val="20000"/>
        </a:spcBef>
        <a:buFont typeface="Arial" pitchFamily="34" charset="0"/>
        <a:buChar char="•"/>
        <a:defRPr kumimoji="1" sz="2625" kern="1200">
          <a:solidFill>
            <a:schemeClr val="tx1"/>
          </a:solidFill>
          <a:latin typeface="+mn-lt"/>
          <a:ea typeface="+mn-ea"/>
          <a:cs typeface="+mn-cs"/>
        </a:defRPr>
      </a:lvl6pPr>
      <a:lvl7pPr marL="3899893" indent="-299992" algn="l" defTabSz="1199967" rtl="0" eaLnBrk="1" latinLnBrk="0" hangingPunct="1">
        <a:spcBef>
          <a:spcPct val="20000"/>
        </a:spcBef>
        <a:buFont typeface="Arial" pitchFamily="34" charset="0"/>
        <a:buChar char="•"/>
        <a:defRPr kumimoji="1" sz="2625" kern="1200">
          <a:solidFill>
            <a:schemeClr val="tx1"/>
          </a:solidFill>
          <a:latin typeface="+mn-lt"/>
          <a:ea typeface="+mn-ea"/>
          <a:cs typeface="+mn-cs"/>
        </a:defRPr>
      </a:lvl7pPr>
      <a:lvl8pPr marL="4499877" indent="-299992" algn="l" defTabSz="1199967" rtl="0" eaLnBrk="1" latinLnBrk="0" hangingPunct="1">
        <a:spcBef>
          <a:spcPct val="20000"/>
        </a:spcBef>
        <a:buFont typeface="Arial" pitchFamily="34" charset="0"/>
        <a:buChar char="•"/>
        <a:defRPr kumimoji="1" sz="2625" kern="1200">
          <a:solidFill>
            <a:schemeClr val="tx1"/>
          </a:solidFill>
          <a:latin typeface="+mn-lt"/>
          <a:ea typeface="+mn-ea"/>
          <a:cs typeface="+mn-cs"/>
        </a:defRPr>
      </a:lvl8pPr>
      <a:lvl9pPr marL="5099860" indent="-299992" algn="l" defTabSz="1199967" rtl="0" eaLnBrk="1" latinLnBrk="0" hangingPunct="1">
        <a:spcBef>
          <a:spcPct val="20000"/>
        </a:spcBef>
        <a:buFont typeface="Arial" pitchFamily="34" charset="0"/>
        <a:buChar char="•"/>
        <a:defRPr kumimoji="1" sz="262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1pPr>
      <a:lvl2pPr marL="599984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99967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799951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399934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2999918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599901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199885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4799868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5" name="テキスト ボックス 1">
            <a:extLst>
              <a:ext uri="{FF2B5EF4-FFF2-40B4-BE49-F238E27FC236}">
                <a16:creationId xmlns:a16="http://schemas.microsoft.com/office/drawing/2014/main" id="{ADDCD3C9-E094-436B-B0CD-04EA08E836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46286" y="1983146"/>
            <a:ext cx="432048" cy="58477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 anchor="ctr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/>
            <a:r>
              <a:rPr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437" name="テキスト ボックス 1">
            <a:extLst>
              <a:ext uri="{FF2B5EF4-FFF2-40B4-BE49-F238E27FC236}">
                <a16:creationId xmlns:a16="http://schemas.microsoft.com/office/drawing/2014/main" id="{C17024D5-074C-4705-B2E9-981C261026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75826" y="1984195"/>
            <a:ext cx="432048" cy="58477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 anchor="ctr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/>
            <a:r>
              <a:rPr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310" name="テキスト ボックス 309">
            <a:extLst>
              <a:ext uri="{FF2B5EF4-FFF2-40B4-BE49-F238E27FC236}">
                <a16:creationId xmlns:a16="http://schemas.microsoft.com/office/drawing/2014/main" id="{96C5BBD5-BA0E-4D34-8722-D68097A01CC0}"/>
              </a:ext>
            </a:extLst>
          </p:cNvPr>
          <p:cNvSpPr txBox="1"/>
          <p:nvPr/>
        </p:nvSpPr>
        <p:spPr>
          <a:xfrm>
            <a:off x="7975546" y="503362"/>
            <a:ext cx="6748215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b="1" dirty="0"/>
              <a:t>Supplement Figure 1</a:t>
            </a: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A632FDA9-EF14-4A10-B66B-88A2EC4CB2BA}"/>
              </a:ext>
            </a:extLst>
          </p:cNvPr>
          <p:cNvGrpSpPr/>
          <p:nvPr/>
        </p:nvGrpSpPr>
        <p:grpSpPr>
          <a:xfrm>
            <a:off x="2245204" y="2897262"/>
            <a:ext cx="7762470" cy="7120881"/>
            <a:chOff x="2245204" y="4697462"/>
            <a:chExt cx="7762470" cy="7120881"/>
          </a:xfrm>
        </p:grpSpPr>
        <p:sp>
          <p:nvSpPr>
            <p:cNvPr id="446" name="Rectangle 578">
              <a:extLst>
                <a:ext uri="{FF2B5EF4-FFF2-40B4-BE49-F238E27FC236}">
                  <a16:creationId xmlns:a16="http://schemas.microsoft.com/office/drawing/2014/main" id="{7DD9DBF3-F210-4C0A-81DD-672DC3A10C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35209" y="4697462"/>
              <a:ext cx="4413068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28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RBB2</a:t>
              </a:r>
              <a:r>
                <a:rPr kumimoji="0" lang="en-US" altLang="ja-JP" sz="2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positive cases (n=76)</a:t>
              </a:r>
              <a:endParaRPr kumimoji="0" lang="ja-JP" altLang="ja-JP" sz="2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2" name="Rectangle 578">
              <a:extLst>
                <a:ext uri="{FF2B5EF4-FFF2-40B4-BE49-F238E27FC236}">
                  <a16:creationId xmlns:a16="http://schemas.microsoft.com/office/drawing/2014/main" id="{5E922433-3C18-423B-A402-0A0386CA30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7241" y="9032563"/>
              <a:ext cx="5920433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2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AD2</a:t>
              </a:r>
              <a:r>
                <a:rPr kumimoji="0" lang="en-US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negative and/or </a:t>
              </a:r>
              <a:r>
                <a:rPr kumimoji="0" lang="en-US" altLang="ja-JP" sz="2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</a:t>
              </a:r>
              <a:r>
                <a:rPr kumimoji="0" lang="en-US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negative (n=74)</a:t>
              </a:r>
              <a:endParaRPr kumimoji="0" lang="ja-JP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3" name="Rectangle 578">
              <a:extLst>
                <a:ext uri="{FF2B5EF4-FFF2-40B4-BE49-F238E27FC236}">
                  <a16:creationId xmlns:a16="http://schemas.microsoft.com/office/drawing/2014/main" id="{75AD64BF-EB52-449B-98A9-48BBF1C0E2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7053" y="5822129"/>
              <a:ext cx="5420621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2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AD2</a:t>
              </a:r>
              <a:r>
                <a:rPr kumimoji="0" lang="en-US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ositive and</a:t>
              </a:r>
              <a:r>
                <a:rPr kumimoji="0" lang="ja-JP" altLang="en-US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ja-JP" sz="2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</a:t>
              </a:r>
              <a:r>
                <a:rPr kumimoji="0" lang="en-US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ositive (n=2)</a:t>
              </a:r>
              <a:endParaRPr kumimoji="0" lang="ja-JP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4" name="Rectangle 578">
              <a:extLst>
                <a:ext uri="{FF2B5EF4-FFF2-40B4-BE49-F238E27FC236}">
                  <a16:creationId xmlns:a16="http://schemas.microsoft.com/office/drawing/2014/main" id="{C91DCFEB-6B26-46AA-B84D-E646BA8C68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33388" y="11387456"/>
              <a:ext cx="2708306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2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ears after surgery</a:t>
              </a:r>
              <a:endParaRPr kumimoji="0" lang="ja-JP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5" name="Rectangle 578">
              <a:extLst>
                <a:ext uri="{FF2B5EF4-FFF2-40B4-BE49-F238E27FC236}">
                  <a16:creationId xmlns:a16="http://schemas.microsoft.com/office/drawing/2014/main" id="{D0ABB3B2-A78A-4755-AA74-87555860995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300074" y="8134506"/>
              <a:ext cx="2321148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2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 survival</a:t>
              </a:r>
              <a:endParaRPr kumimoji="0" lang="ja-JP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2" name="Rectangle 578">
              <a:extLst>
                <a:ext uri="{FF2B5EF4-FFF2-40B4-BE49-F238E27FC236}">
                  <a16:creationId xmlns:a16="http://schemas.microsoft.com/office/drawing/2014/main" id="{9645E7C0-A74F-42CB-8F75-267063CB43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95471" y="7084763"/>
              <a:ext cx="1189428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2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=0.304</a:t>
              </a:r>
              <a:endParaRPr kumimoji="0" lang="ja-JP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Line 7">
              <a:extLst>
                <a:ext uri="{FF2B5EF4-FFF2-40B4-BE49-F238E27FC236}">
                  <a16:creationId xmlns:a16="http://schemas.microsoft.com/office/drawing/2014/main" id="{4B93BFB4-A032-430F-86FC-CC083D87AC4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27449" y="10292146"/>
              <a:ext cx="55562" cy="0"/>
            </a:xfrm>
            <a:prstGeom prst="line">
              <a:avLst/>
            </a:prstGeom>
            <a:noFill/>
            <a:ln w="19050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" name="Line 8">
              <a:extLst>
                <a:ext uri="{FF2B5EF4-FFF2-40B4-BE49-F238E27FC236}">
                  <a16:creationId xmlns:a16="http://schemas.microsoft.com/office/drawing/2014/main" id="{D81094BC-3807-4FB8-A5C6-AC9D907065F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27449" y="9425371"/>
              <a:ext cx="55562" cy="0"/>
            </a:xfrm>
            <a:prstGeom prst="line">
              <a:avLst/>
            </a:prstGeom>
            <a:noFill/>
            <a:ln w="19050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" name="Line 9">
              <a:extLst>
                <a:ext uri="{FF2B5EF4-FFF2-40B4-BE49-F238E27FC236}">
                  <a16:creationId xmlns:a16="http://schemas.microsoft.com/office/drawing/2014/main" id="{9BD9F57C-1478-480B-926A-6ADB0617A05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27449" y="8558596"/>
              <a:ext cx="55562" cy="0"/>
            </a:xfrm>
            <a:prstGeom prst="line">
              <a:avLst/>
            </a:prstGeom>
            <a:noFill/>
            <a:ln w="19050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" name="Line 10">
              <a:extLst>
                <a:ext uri="{FF2B5EF4-FFF2-40B4-BE49-F238E27FC236}">
                  <a16:creationId xmlns:a16="http://schemas.microsoft.com/office/drawing/2014/main" id="{C27F1109-67B9-4A3F-9195-F0C80918B07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27449" y="7691821"/>
              <a:ext cx="55562" cy="0"/>
            </a:xfrm>
            <a:prstGeom prst="line">
              <a:avLst/>
            </a:prstGeom>
            <a:noFill/>
            <a:ln w="19050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" name="Line 11">
              <a:extLst>
                <a:ext uri="{FF2B5EF4-FFF2-40B4-BE49-F238E27FC236}">
                  <a16:creationId xmlns:a16="http://schemas.microsoft.com/office/drawing/2014/main" id="{98CB28D6-9B9E-4836-A054-51085968ACB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27449" y="6825046"/>
              <a:ext cx="55562" cy="0"/>
            </a:xfrm>
            <a:prstGeom prst="line">
              <a:avLst/>
            </a:prstGeom>
            <a:noFill/>
            <a:ln w="19050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" name="Line 12">
              <a:extLst>
                <a:ext uri="{FF2B5EF4-FFF2-40B4-BE49-F238E27FC236}">
                  <a16:creationId xmlns:a16="http://schemas.microsoft.com/office/drawing/2014/main" id="{B7F1251C-C95F-40E3-A5B9-74A42957C71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73474" y="10725533"/>
              <a:ext cx="109537" cy="0"/>
            </a:xfrm>
            <a:prstGeom prst="line">
              <a:avLst/>
            </a:prstGeom>
            <a:noFill/>
            <a:ln w="19050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" name="Line 13">
              <a:extLst>
                <a:ext uri="{FF2B5EF4-FFF2-40B4-BE49-F238E27FC236}">
                  <a16:creationId xmlns:a16="http://schemas.microsoft.com/office/drawing/2014/main" id="{B6D22EFF-BA64-49A2-9FC8-42C761DD0BB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73474" y="9858758"/>
              <a:ext cx="109537" cy="0"/>
            </a:xfrm>
            <a:prstGeom prst="line">
              <a:avLst/>
            </a:prstGeom>
            <a:noFill/>
            <a:ln w="19050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" name="Line 14">
              <a:extLst>
                <a:ext uri="{FF2B5EF4-FFF2-40B4-BE49-F238E27FC236}">
                  <a16:creationId xmlns:a16="http://schemas.microsoft.com/office/drawing/2014/main" id="{8A2E893B-E98E-4FBA-A53B-00B381E04E9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73474" y="8991983"/>
              <a:ext cx="109537" cy="0"/>
            </a:xfrm>
            <a:prstGeom prst="line">
              <a:avLst/>
            </a:prstGeom>
            <a:noFill/>
            <a:ln w="19050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" name="Line 15">
              <a:extLst>
                <a:ext uri="{FF2B5EF4-FFF2-40B4-BE49-F238E27FC236}">
                  <a16:creationId xmlns:a16="http://schemas.microsoft.com/office/drawing/2014/main" id="{375393F1-1987-48ED-ACB7-36EDD7273C5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73474" y="8125208"/>
              <a:ext cx="109537" cy="0"/>
            </a:xfrm>
            <a:prstGeom prst="line">
              <a:avLst/>
            </a:prstGeom>
            <a:noFill/>
            <a:ln w="19050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" name="Line 16">
              <a:extLst>
                <a:ext uri="{FF2B5EF4-FFF2-40B4-BE49-F238E27FC236}">
                  <a16:creationId xmlns:a16="http://schemas.microsoft.com/office/drawing/2014/main" id="{63A1C3E9-7196-48EA-92DE-6CBF8850910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73474" y="7258433"/>
              <a:ext cx="109537" cy="0"/>
            </a:xfrm>
            <a:prstGeom prst="line">
              <a:avLst/>
            </a:prstGeom>
            <a:noFill/>
            <a:ln w="19050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" name="Line 17">
              <a:extLst>
                <a:ext uri="{FF2B5EF4-FFF2-40B4-BE49-F238E27FC236}">
                  <a16:creationId xmlns:a16="http://schemas.microsoft.com/office/drawing/2014/main" id="{000A4F73-0C9F-4330-80FE-50409F9F4DE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73474" y="6391658"/>
              <a:ext cx="109537" cy="0"/>
            </a:xfrm>
            <a:prstGeom prst="line">
              <a:avLst/>
            </a:prstGeom>
            <a:noFill/>
            <a:ln w="19050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" name="Rectangle 18">
              <a:extLst>
                <a:ext uri="{FF2B5EF4-FFF2-40B4-BE49-F238E27FC236}">
                  <a16:creationId xmlns:a16="http://schemas.microsoft.com/office/drawing/2014/main" id="{AA0BA41A-2B49-4C93-BF7A-DD2C96AC3E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8871" y="10563608"/>
              <a:ext cx="32060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2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Rectangle 19">
              <a:extLst>
                <a:ext uri="{FF2B5EF4-FFF2-40B4-BE49-F238E27FC236}">
                  <a16:creationId xmlns:a16="http://schemas.microsoft.com/office/drawing/2014/main" id="{024860C7-13D1-49E8-B574-2F910AD78B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8871" y="9696833"/>
              <a:ext cx="32060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2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20">
              <a:extLst>
                <a:ext uri="{FF2B5EF4-FFF2-40B4-BE49-F238E27FC236}">
                  <a16:creationId xmlns:a16="http://schemas.microsoft.com/office/drawing/2014/main" id="{61DA51F6-52F6-4C50-9EF5-DB9A5B7449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8871" y="8830058"/>
              <a:ext cx="32060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2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Rectangle 21">
              <a:extLst>
                <a:ext uri="{FF2B5EF4-FFF2-40B4-BE49-F238E27FC236}">
                  <a16:creationId xmlns:a16="http://schemas.microsoft.com/office/drawing/2014/main" id="{F4DDF968-2A5D-4150-BF62-3911590ACD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8871" y="7963283"/>
              <a:ext cx="32060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2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Rectangle 22">
              <a:extLst>
                <a:ext uri="{FF2B5EF4-FFF2-40B4-BE49-F238E27FC236}">
                  <a16:creationId xmlns:a16="http://schemas.microsoft.com/office/drawing/2014/main" id="{DCE777BE-F273-47A6-900E-321FFA6351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8871" y="7096508"/>
              <a:ext cx="32060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2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Rectangle 23">
              <a:extLst>
                <a:ext uri="{FF2B5EF4-FFF2-40B4-BE49-F238E27FC236}">
                  <a16:creationId xmlns:a16="http://schemas.microsoft.com/office/drawing/2014/main" id="{5136EEA9-1A23-4488-A938-D83FE038B1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8871" y="6229733"/>
              <a:ext cx="32060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2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Freeform 26">
              <a:extLst>
                <a:ext uri="{FF2B5EF4-FFF2-40B4-BE49-F238E27FC236}">
                  <a16:creationId xmlns:a16="http://schemas.microsoft.com/office/drawing/2014/main" id="{4FBD97DB-DD21-4CDB-A2F3-9E7A3E1A9F88}"/>
                </a:ext>
              </a:extLst>
            </p:cNvPr>
            <p:cNvSpPr>
              <a:spLocks/>
            </p:cNvSpPr>
            <p:nvPr/>
          </p:nvSpPr>
          <p:spPr bwMode="auto">
            <a:xfrm>
              <a:off x="3373487" y="6383721"/>
              <a:ext cx="6423025" cy="2365375"/>
            </a:xfrm>
            <a:custGeom>
              <a:avLst/>
              <a:gdLst>
                <a:gd name="T0" fmla="*/ 15 w 4046"/>
                <a:gd name="T1" fmla="*/ 0 h 1490"/>
                <a:gd name="T2" fmla="*/ 67 w 4046"/>
                <a:gd name="T3" fmla="*/ 0 h 1490"/>
                <a:gd name="T4" fmla="*/ 126 w 4046"/>
                <a:gd name="T5" fmla="*/ 39 h 1490"/>
                <a:gd name="T6" fmla="*/ 171 w 4046"/>
                <a:gd name="T7" fmla="*/ 39 h 1490"/>
                <a:gd name="T8" fmla="*/ 180 w 4046"/>
                <a:gd name="T9" fmla="*/ 79 h 1490"/>
                <a:gd name="T10" fmla="*/ 204 w 4046"/>
                <a:gd name="T11" fmla="*/ 119 h 1490"/>
                <a:gd name="T12" fmla="*/ 235 w 4046"/>
                <a:gd name="T13" fmla="*/ 160 h 1490"/>
                <a:gd name="T14" fmla="*/ 306 w 4046"/>
                <a:gd name="T15" fmla="*/ 201 h 1490"/>
                <a:gd name="T16" fmla="*/ 399 w 4046"/>
                <a:gd name="T17" fmla="*/ 201 h 1490"/>
                <a:gd name="T18" fmla="*/ 444 w 4046"/>
                <a:gd name="T19" fmla="*/ 242 h 1490"/>
                <a:gd name="T20" fmla="*/ 454 w 4046"/>
                <a:gd name="T21" fmla="*/ 285 h 1490"/>
                <a:gd name="T22" fmla="*/ 521 w 4046"/>
                <a:gd name="T23" fmla="*/ 327 h 1490"/>
                <a:gd name="T24" fmla="*/ 539 w 4046"/>
                <a:gd name="T25" fmla="*/ 369 h 1490"/>
                <a:gd name="T26" fmla="*/ 581 w 4046"/>
                <a:gd name="T27" fmla="*/ 411 h 1490"/>
                <a:gd name="T28" fmla="*/ 610 w 4046"/>
                <a:gd name="T29" fmla="*/ 453 h 1490"/>
                <a:gd name="T30" fmla="*/ 630 w 4046"/>
                <a:gd name="T31" fmla="*/ 495 h 1490"/>
                <a:gd name="T32" fmla="*/ 641 w 4046"/>
                <a:gd name="T33" fmla="*/ 538 h 1490"/>
                <a:gd name="T34" fmla="*/ 758 w 4046"/>
                <a:gd name="T35" fmla="*/ 580 h 1490"/>
                <a:gd name="T36" fmla="*/ 812 w 4046"/>
                <a:gd name="T37" fmla="*/ 580 h 1490"/>
                <a:gd name="T38" fmla="*/ 816 w 4046"/>
                <a:gd name="T39" fmla="*/ 625 h 1490"/>
                <a:gd name="T40" fmla="*/ 849 w 4046"/>
                <a:gd name="T41" fmla="*/ 625 h 1490"/>
                <a:gd name="T42" fmla="*/ 863 w 4046"/>
                <a:gd name="T43" fmla="*/ 672 h 1490"/>
                <a:gd name="T44" fmla="*/ 878 w 4046"/>
                <a:gd name="T45" fmla="*/ 720 h 1490"/>
                <a:gd name="T46" fmla="*/ 929 w 4046"/>
                <a:gd name="T47" fmla="*/ 720 h 1490"/>
                <a:gd name="T48" fmla="*/ 949 w 4046"/>
                <a:gd name="T49" fmla="*/ 772 h 1490"/>
                <a:gd name="T50" fmla="*/ 974 w 4046"/>
                <a:gd name="T51" fmla="*/ 772 h 1490"/>
                <a:gd name="T52" fmla="*/ 998 w 4046"/>
                <a:gd name="T53" fmla="*/ 826 h 1490"/>
                <a:gd name="T54" fmla="*/ 1077 w 4046"/>
                <a:gd name="T55" fmla="*/ 826 h 1490"/>
                <a:gd name="T56" fmla="*/ 1204 w 4046"/>
                <a:gd name="T57" fmla="*/ 826 h 1490"/>
                <a:gd name="T58" fmla="*/ 1229 w 4046"/>
                <a:gd name="T59" fmla="*/ 892 h 1490"/>
                <a:gd name="T60" fmla="*/ 1271 w 4046"/>
                <a:gd name="T61" fmla="*/ 1023 h 1490"/>
                <a:gd name="T62" fmla="*/ 1315 w 4046"/>
                <a:gd name="T63" fmla="*/ 1023 h 1490"/>
                <a:gd name="T64" fmla="*/ 1410 w 4046"/>
                <a:gd name="T65" fmla="*/ 1023 h 1490"/>
                <a:gd name="T66" fmla="*/ 1419 w 4046"/>
                <a:gd name="T67" fmla="*/ 1109 h 1490"/>
                <a:gd name="T68" fmla="*/ 1445 w 4046"/>
                <a:gd name="T69" fmla="*/ 1194 h 1490"/>
                <a:gd name="T70" fmla="*/ 1579 w 4046"/>
                <a:gd name="T71" fmla="*/ 1194 h 1490"/>
                <a:gd name="T72" fmla="*/ 1636 w 4046"/>
                <a:gd name="T73" fmla="*/ 1284 h 1490"/>
                <a:gd name="T74" fmla="*/ 1756 w 4046"/>
                <a:gd name="T75" fmla="*/ 1284 h 1490"/>
                <a:gd name="T76" fmla="*/ 1953 w 4046"/>
                <a:gd name="T77" fmla="*/ 1387 h 1490"/>
                <a:gd name="T78" fmla="*/ 2197 w 4046"/>
                <a:gd name="T79" fmla="*/ 1490 h 1490"/>
                <a:gd name="T80" fmla="*/ 2252 w 4046"/>
                <a:gd name="T81" fmla="*/ 1490 h 1490"/>
                <a:gd name="T82" fmla="*/ 2457 w 4046"/>
                <a:gd name="T83" fmla="*/ 1490 h 1490"/>
                <a:gd name="T84" fmla="*/ 3747 w 4046"/>
                <a:gd name="T85" fmla="*/ 1490 h 14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</a:cxnLst>
              <a:rect l="0" t="0" r="r" b="b"/>
              <a:pathLst>
                <a:path w="4046" h="1490">
                  <a:moveTo>
                    <a:pt x="0" y="0"/>
                  </a:moveTo>
                  <a:lnTo>
                    <a:pt x="15" y="0"/>
                  </a:lnTo>
                  <a:lnTo>
                    <a:pt x="35" y="0"/>
                  </a:lnTo>
                  <a:lnTo>
                    <a:pt x="67" y="0"/>
                  </a:lnTo>
                  <a:lnTo>
                    <a:pt x="126" y="0"/>
                  </a:lnTo>
                  <a:lnTo>
                    <a:pt x="126" y="39"/>
                  </a:lnTo>
                  <a:lnTo>
                    <a:pt x="142" y="39"/>
                  </a:lnTo>
                  <a:lnTo>
                    <a:pt x="171" y="39"/>
                  </a:lnTo>
                  <a:lnTo>
                    <a:pt x="180" y="39"/>
                  </a:lnTo>
                  <a:lnTo>
                    <a:pt x="180" y="79"/>
                  </a:lnTo>
                  <a:lnTo>
                    <a:pt x="182" y="119"/>
                  </a:lnTo>
                  <a:lnTo>
                    <a:pt x="204" y="119"/>
                  </a:lnTo>
                  <a:lnTo>
                    <a:pt x="235" y="119"/>
                  </a:lnTo>
                  <a:lnTo>
                    <a:pt x="235" y="160"/>
                  </a:lnTo>
                  <a:lnTo>
                    <a:pt x="306" y="160"/>
                  </a:lnTo>
                  <a:lnTo>
                    <a:pt x="306" y="201"/>
                  </a:lnTo>
                  <a:lnTo>
                    <a:pt x="364" y="201"/>
                  </a:lnTo>
                  <a:lnTo>
                    <a:pt x="399" y="201"/>
                  </a:lnTo>
                  <a:lnTo>
                    <a:pt x="399" y="242"/>
                  </a:lnTo>
                  <a:lnTo>
                    <a:pt x="444" y="242"/>
                  </a:lnTo>
                  <a:lnTo>
                    <a:pt x="454" y="242"/>
                  </a:lnTo>
                  <a:lnTo>
                    <a:pt x="454" y="285"/>
                  </a:lnTo>
                  <a:lnTo>
                    <a:pt x="521" y="285"/>
                  </a:lnTo>
                  <a:lnTo>
                    <a:pt x="521" y="327"/>
                  </a:lnTo>
                  <a:lnTo>
                    <a:pt x="539" y="327"/>
                  </a:lnTo>
                  <a:lnTo>
                    <a:pt x="539" y="369"/>
                  </a:lnTo>
                  <a:lnTo>
                    <a:pt x="581" y="369"/>
                  </a:lnTo>
                  <a:lnTo>
                    <a:pt x="581" y="411"/>
                  </a:lnTo>
                  <a:lnTo>
                    <a:pt x="610" y="411"/>
                  </a:lnTo>
                  <a:lnTo>
                    <a:pt x="610" y="453"/>
                  </a:lnTo>
                  <a:lnTo>
                    <a:pt x="619" y="495"/>
                  </a:lnTo>
                  <a:lnTo>
                    <a:pt x="630" y="495"/>
                  </a:lnTo>
                  <a:lnTo>
                    <a:pt x="630" y="538"/>
                  </a:lnTo>
                  <a:lnTo>
                    <a:pt x="641" y="538"/>
                  </a:lnTo>
                  <a:lnTo>
                    <a:pt x="641" y="580"/>
                  </a:lnTo>
                  <a:lnTo>
                    <a:pt x="758" y="580"/>
                  </a:lnTo>
                  <a:lnTo>
                    <a:pt x="794" y="580"/>
                  </a:lnTo>
                  <a:lnTo>
                    <a:pt x="812" y="580"/>
                  </a:lnTo>
                  <a:lnTo>
                    <a:pt x="812" y="625"/>
                  </a:lnTo>
                  <a:lnTo>
                    <a:pt x="816" y="625"/>
                  </a:lnTo>
                  <a:lnTo>
                    <a:pt x="840" y="625"/>
                  </a:lnTo>
                  <a:lnTo>
                    <a:pt x="849" y="625"/>
                  </a:lnTo>
                  <a:lnTo>
                    <a:pt x="863" y="625"/>
                  </a:lnTo>
                  <a:lnTo>
                    <a:pt x="863" y="672"/>
                  </a:lnTo>
                  <a:lnTo>
                    <a:pt x="878" y="672"/>
                  </a:lnTo>
                  <a:lnTo>
                    <a:pt x="878" y="720"/>
                  </a:lnTo>
                  <a:lnTo>
                    <a:pt x="887" y="720"/>
                  </a:lnTo>
                  <a:lnTo>
                    <a:pt x="929" y="720"/>
                  </a:lnTo>
                  <a:lnTo>
                    <a:pt x="936" y="772"/>
                  </a:lnTo>
                  <a:lnTo>
                    <a:pt x="949" y="772"/>
                  </a:lnTo>
                  <a:lnTo>
                    <a:pt x="962" y="772"/>
                  </a:lnTo>
                  <a:lnTo>
                    <a:pt x="974" y="772"/>
                  </a:lnTo>
                  <a:lnTo>
                    <a:pt x="974" y="826"/>
                  </a:lnTo>
                  <a:lnTo>
                    <a:pt x="998" y="826"/>
                  </a:lnTo>
                  <a:lnTo>
                    <a:pt x="1055" y="826"/>
                  </a:lnTo>
                  <a:lnTo>
                    <a:pt x="1077" y="826"/>
                  </a:lnTo>
                  <a:lnTo>
                    <a:pt x="1155" y="826"/>
                  </a:lnTo>
                  <a:lnTo>
                    <a:pt x="1204" y="826"/>
                  </a:lnTo>
                  <a:lnTo>
                    <a:pt x="1204" y="892"/>
                  </a:lnTo>
                  <a:lnTo>
                    <a:pt x="1229" y="892"/>
                  </a:lnTo>
                  <a:lnTo>
                    <a:pt x="1229" y="1023"/>
                  </a:lnTo>
                  <a:lnTo>
                    <a:pt x="1271" y="1023"/>
                  </a:lnTo>
                  <a:lnTo>
                    <a:pt x="1279" y="1023"/>
                  </a:lnTo>
                  <a:lnTo>
                    <a:pt x="1315" y="1023"/>
                  </a:lnTo>
                  <a:lnTo>
                    <a:pt x="1377" y="1023"/>
                  </a:lnTo>
                  <a:lnTo>
                    <a:pt x="1410" y="1023"/>
                  </a:lnTo>
                  <a:lnTo>
                    <a:pt x="1419" y="1023"/>
                  </a:lnTo>
                  <a:lnTo>
                    <a:pt x="1419" y="1109"/>
                  </a:lnTo>
                  <a:lnTo>
                    <a:pt x="1445" y="1109"/>
                  </a:lnTo>
                  <a:lnTo>
                    <a:pt x="1445" y="1194"/>
                  </a:lnTo>
                  <a:lnTo>
                    <a:pt x="1504" y="1194"/>
                  </a:lnTo>
                  <a:lnTo>
                    <a:pt x="1579" y="1194"/>
                  </a:lnTo>
                  <a:lnTo>
                    <a:pt x="1579" y="1284"/>
                  </a:lnTo>
                  <a:lnTo>
                    <a:pt x="1636" y="1284"/>
                  </a:lnTo>
                  <a:lnTo>
                    <a:pt x="1741" y="1284"/>
                  </a:lnTo>
                  <a:lnTo>
                    <a:pt x="1756" y="1284"/>
                  </a:lnTo>
                  <a:lnTo>
                    <a:pt x="1756" y="1387"/>
                  </a:lnTo>
                  <a:lnTo>
                    <a:pt x="1953" y="1387"/>
                  </a:lnTo>
                  <a:lnTo>
                    <a:pt x="1953" y="1490"/>
                  </a:lnTo>
                  <a:lnTo>
                    <a:pt x="2197" y="1490"/>
                  </a:lnTo>
                  <a:lnTo>
                    <a:pt x="2217" y="1490"/>
                  </a:lnTo>
                  <a:lnTo>
                    <a:pt x="2252" y="1490"/>
                  </a:lnTo>
                  <a:lnTo>
                    <a:pt x="2268" y="1490"/>
                  </a:lnTo>
                  <a:lnTo>
                    <a:pt x="2457" y="1490"/>
                  </a:lnTo>
                  <a:lnTo>
                    <a:pt x="2523" y="1490"/>
                  </a:lnTo>
                  <a:lnTo>
                    <a:pt x="3747" y="1490"/>
                  </a:lnTo>
                  <a:lnTo>
                    <a:pt x="4046" y="1490"/>
                  </a:lnTo>
                </a:path>
              </a:pathLst>
            </a:custGeom>
            <a:noFill/>
            <a:ln w="12700" cap="flat">
              <a:solidFill>
                <a:schemeClr val="tx1"/>
              </a:solidFill>
              <a:prstDash val="sys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" name="Freeform 27">
              <a:extLst>
                <a:ext uri="{FF2B5EF4-FFF2-40B4-BE49-F238E27FC236}">
                  <a16:creationId xmlns:a16="http://schemas.microsoft.com/office/drawing/2014/main" id="{04BE32F6-C3EC-438E-AADE-99E1D4650B41}"/>
                </a:ext>
              </a:extLst>
            </p:cNvPr>
            <p:cNvSpPr>
              <a:spLocks/>
            </p:cNvSpPr>
            <p:nvPr/>
          </p:nvSpPr>
          <p:spPr bwMode="auto">
            <a:xfrm>
              <a:off x="3383012" y="6391658"/>
              <a:ext cx="4673600" cy="0"/>
            </a:xfrm>
            <a:custGeom>
              <a:avLst/>
              <a:gdLst>
                <a:gd name="T0" fmla="*/ 0 w 2944"/>
                <a:gd name="T1" fmla="*/ 863 w 2944"/>
                <a:gd name="T2" fmla="*/ 2944 w 294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944">
                  <a:moveTo>
                    <a:pt x="0" y="0"/>
                  </a:moveTo>
                  <a:lnTo>
                    <a:pt x="863" y="0"/>
                  </a:lnTo>
                  <a:lnTo>
                    <a:pt x="2944" y="0"/>
                  </a:lnTo>
                </a:path>
              </a:pathLst>
            </a:custGeom>
            <a:noFill/>
            <a:ln w="1270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" name="Oval 29">
              <a:extLst>
                <a:ext uri="{FF2B5EF4-FFF2-40B4-BE49-F238E27FC236}">
                  <a16:creationId xmlns:a16="http://schemas.microsoft.com/office/drawing/2014/main" id="{F1B347D7-8854-4026-9656-BE1CA8838D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84429" y="870883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" name="Oval 31">
              <a:extLst>
                <a:ext uri="{FF2B5EF4-FFF2-40B4-BE49-F238E27FC236}">
                  <a16:creationId xmlns:a16="http://schemas.microsoft.com/office/drawing/2014/main" id="{C06863F9-D541-425F-B140-1E24052662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69729" y="653395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" name="Oval 32">
              <a:extLst>
                <a:ext uri="{FF2B5EF4-FFF2-40B4-BE49-F238E27FC236}">
                  <a16:creationId xmlns:a16="http://schemas.microsoft.com/office/drawing/2014/main" id="{0EA070E4-D5ED-4292-B84C-8BC0378CD3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68304" y="765473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" name="Oval 33">
              <a:extLst>
                <a:ext uri="{FF2B5EF4-FFF2-40B4-BE49-F238E27FC236}">
                  <a16:creationId xmlns:a16="http://schemas.microsoft.com/office/drawing/2014/main" id="{002B78E7-D71E-4CB5-B1C5-4BE16C92E1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1829" y="666254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" name="Oval 35">
              <a:extLst>
                <a:ext uri="{FF2B5EF4-FFF2-40B4-BE49-F238E27FC236}">
                  <a16:creationId xmlns:a16="http://schemas.microsoft.com/office/drawing/2014/main" id="{B5824D7F-F094-452D-89DF-4B2398FE4B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71716" y="870883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" name="Oval 37">
              <a:extLst>
                <a:ext uri="{FF2B5EF4-FFF2-40B4-BE49-F238E27FC236}">
                  <a16:creationId xmlns:a16="http://schemas.microsoft.com/office/drawing/2014/main" id="{7AF48EE8-21F6-491E-B648-4768DFAAEF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9966" y="796747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" name="Oval 39">
              <a:extLst>
                <a:ext uri="{FF2B5EF4-FFF2-40B4-BE49-F238E27FC236}">
                  <a16:creationId xmlns:a16="http://schemas.microsoft.com/office/drawing/2014/main" id="{9B04B9EA-791B-461B-8BF7-6A4CA5855C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77804" y="741025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" name="Oval 40">
              <a:extLst>
                <a:ext uri="{FF2B5EF4-FFF2-40B4-BE49-F238E27FC236}">
                  <a16:creationId xmlns:a16="http://schemas.microsoft.com/office/drawing/2014/main" id="{BB1E25A6-E16E-489D-A8D3-48BC5AD1BF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92091" y="748645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" name="Oval 41">
              <a:extLst>
                <a:ext uri="{FF2B5EF4-FFF2-40B4-BE49-F238E27FC236}">
                  <a16:creationId xmlns:a16="http://schemas.microsoft.com/office/drawing/2014/main" id="{89ED6DCF-8B77-4890-B286-4BB09A157E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79379" y="733405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" name="Oval 42">
              <a:extLst>
                <a:ext uri="{FF2B5EF4-FFF2-40B4-BE49-F238E27FC236}">
                  <a16:creationId xmlns:a16="http://schemas.microsoft.com/office/drawing/2014/main" id="{7CB478A6-7C47-4C87-9D0E-2DF402FF2E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07829" y="653237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" name="Oval 43">
              <a:extLst>
                <a:ext uri="{FF2B5EF4-FFF2-40B4-BE49-F238E27FC236}">
                  <a16:creationId xmlns:a16="http://schemas.microsoft.com/office/drawing/2014/main" id="{DF2E697E-378F-4184-8DCA-A87A74E47D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25504" y="796747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" name="Oval 44">
              <a:extLst>
                <a:ext uri="{FF2B5EF4-FFF2-40B4-BE49-F238E27FC236}">
                  <a16:creationId xmlns:a16="http://schemas.microsoft.com/office/drawing/2014/main" id="{6DDC1AB6-B4E6-4761-B8D6-306E596C7C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14391" y="796747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" name="Oval 47">
              <a:extLst>
                <a:ext uri="{FF2B5EF4-FFF2-40B4-BE49-F238E27FC236}">
                  <a16:creationId xmlns:a16="http://schemas.microsoft.com/office/drawing/2014/main" id="{B448ADC1-99F3-4898-BE36-4D3E7B69B9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807004" y="870883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" name="Oval 48">
              <a:extLst>
                <a:ext uri="{FF2B5EF4-FFF2-40B4-BE49-F238E27FC236}">
                  <a16:creationId xmlns:a16="http://schemas.microsoft.com/office/drawing/2014/main" id="{8CB9F059-2E2C-42A7-9350-210D71C7AE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01691" y="796747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0" name="Oval 49">
              <a:extLst>
                <a:ext uri="{FF2B5EF4-FFF2-40B4-BE49-F238E27FC236}">
                  <a16:creationId xmlns:a16="http://schemas.microsoft.com/office/drawing/2014/main" id="{BF4AC454-6B04-4ECA-A735-4B5E46105E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25479" y="765473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1" name="Oval 50">
              <a:extLst>
                <a:ext uri="{FF2B5EF4-FFF2-40B4-BE49-F238E27FC236}">
                  <a16:creationId xmlns:a16="http://schemas.microsoft.com/office/drawing/2014/main" id="{CBE258DB-E55A-4D50-B8A3-D17A3CBE69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95304" y="765473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" name="Oval 51">
              <a:extLst>
                <a:ext uri="{FF2B5EF4-FFF2-40B4-BE49-F238E27FC236}">
                  <a16:creationId xmlns:a16="http://schemas.microsoft.com/office/drawing/2014/main" id="{4A7DB0FD-2CBC-4493-996C-B9599E7583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95241" y="726420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3" name="Oval 52">
              <a:extLst>
                <a:ext uri="{FF2B5EF4-FFF2-40B4-BE49-F238E27FC236}">
                  <a16:creationId xmlns:a16="http://schemas.microsoft.com/office/drawing/2014/main" id="{77B3330A-0046-47C4-8114-3189238A0F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71541" y="796747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5" name="Oval 54">
              <a:extLst>
                <a:ext uri="{FF2B5EF4-FFF2-40B4-BE49-F238E27FC236}">
                  <a16:creationId xmlns:a16="http://schemas.microsoft.com/office/drawing/2014/main" id="{E03B1452-03ED-47BF-9A60-35B27970A6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22354" y="796747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6" name="Oval 55">
              <a:extLst>
                <a:ext uri="{FF2B5EF4-FFF2-40B4-BE49-F238E27FC236}">
                  <a16:creationId xmlns:a16="http://schemas.microsoft.com/office/drawing/2014/main" id="{4039CDEE-F8F9-4BB0-91DB-0B9FC051FD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11154" y="756900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7" name="Oval 56">
              <a:extLst>
                <a:ext uri="{FF2B5EF4-FFF2-40B4-BE49-F238E27FC236}">
                  <a16:creationId xmlns:a16="http://schemas.microsoft.com/office/drawing/2014/main" id="{6D2AAB32-D56F-4501-96A7-73B618E11A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82879" y="870883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8" name="Oval 57">
              <a:extLst>
                <a:ext uri="{FF2B5EF4-FFF2-40B4-BE49-F238E27FC236}">
                  <a16:creationId xmlns:a16="http://schemas.microsoft.com/office/drawing/2014/main" id="{693FD057-816E-4AEE-A305-408A813E7A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58766" y="748645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9" name="Oval 58">
              <a:extLst>
                <a:ext uri="{FF2B5EF4-FFF2-40B4-BE49-F238E27FC236}">
                  <a16:creationId xmlns:a16="http://schemas.microsoft.com/office/drawing/2014/main" id="{089ED600-974D-4D07-8C23-BC0F06A266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8891" y="726420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0" name="Oval 59">
              <a:extLst>
                <a:ext uri="{FF2B5EF4-FFF2-40B4-BE49-F238E27FC236}">
                  <a16:creationId xmlns:a16="http://schemas.microsoft.com/office/drawing/2014/main" id="{C260E737-5B1E-4ECD-A18A-1BA508AE9B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69991" y="823893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1" name="Oval 60">
              <a:extLst>
                <a:ext uri="{FF2B5EF4-FFF2-40B4-BE49-F238E27FC236}">
                  <a16:creationId xmlns:a16="http://schemas.microsoft.com/office/drawing/2014/main" id="{629DF3A3-B300-4354-A17F-8BDB95775B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58791" y="765473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3" name="Oval 62">
              <a:extLst>
                <a:ext uri="{FF2B5EF4-FFF2-40B4-BE49-F238E27FC236}">
                  <a16:creationId xmlns:a16="http://schemas.microsoft.com/office/drawing/2014/main" id="{B4D75644-F2EF-4510-A73D-5540A5257A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7241" y="672922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6" name="Oval 65">
              <a:extLst>
                <a:ext uri="{FF2B5EF4-FFF2-40B4-BE49-F238E27FC236}">
                  <a16:creationId xmlns:a16="http://schemas.microsoft.com/office/drawing/2014/main" id="{7932DC90-4F20-47AB-8A93-899692D8D6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81129" y="838180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7" name="Oval 66">
              <a:extLst>
                <a:ext uri="{FF2B5EF4-FFF2-40B4-BE49-F238E27FC236}">
                  <a16:creationId xmlns:a16="http://schemas.microsoft.com/office/drawing/2014/main" id="{7D7D0CDB-300C-4B9E-8E2B-305F8FA87A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46229" y="838180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8" name="Oval 67">
              <a:extLst>
                <a:ext uri="{FF2B5EF4-FFF2-40B4-BE49-F238E27FC236}">
                  <a16:creationId xmlns:a16="http://schemas.microsoft.com/office/drawing/2014/main" id="{A859A9C1-9C61-4A62-A1CB-81297D9171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44454" y="726420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9" name="Oval 68">
              <a:extLst>
                <a:ext uri="{FF2B5EF4-FFF2-40B4-BE49-F238E27FC236}">
                  <a16:creationId xmlns:a16="http://schemas.microsoft.com/office/drawing/2014/main" id="{5FE3D269-67BB-4A83-B28C-FD92B9E482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87541" y="870883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0" name="Oval 69">
              <a:extLst>
                <a:ext uri="{FF2B5EF4-FFF2-40B4-BE49-F238E27FC236}">
                  <a16:creationId xmlns:a16="http://schemas.microsoft.com/office/drawing/2014/main" id="{4DC78C00-6300-4A33-8A0A-AB51BB2C55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90516" y="756900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1" name="Oval 70">
              <a:extLst>
                <a:ext uri="{FF2B5EF4-FFF2-40B4-BE49-F238E27FC236}">
                  <a16:creationId xmlns:a16="http://schemas.microsoft.com/office/drawing/2014/main" id="{1295A6ED-E328-4CFB-9957-C524869231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59029" y="870883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2" name="Oval 71">
              <a:extLst>
                <a:ext uri="{FF2B5EF4-FFF2-40B4-BE49-F238E27FC236}">
                  <a16:creationId xmlns:a16="http://schemas.microsoft.com/office/drawing/2014/main" id="{2912FB99-7861-466C-B2B0-EE012E52E3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17479" y="733405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4" name="Oval 73">
              <a:extLst>
                <a:ext uri="{FF2B5EF4-FFF2-40B4-BE49-F238E27FC236}">
                  <a16:creationId xmlns:a16="http://schemas.microsoft.com/office/drawing/2014/main" id="{BB17FBD9-96F1-4F36-ADD1-166F7E44B7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33354" y="733405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5" name="Oval 74">
              <a:extLst>
                <a:ext uri="{FF2B5EF4-FFF2-40B4-BE49-F238E27FC236}">
                  <a16:creationId xmlns:a16="http://schemas.microsoft.com/office/drawing/2014/main" id="{ABFC759D-46AD-4C2F-992F-88B0DD0BFA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9904" y="765473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9" name="Oval 78">
              <a:extLst>
                <a:ext uri="{FF2B5EF4-FFF2-40B4-BE49-F238E27FC236}">
                  <a16:creationId xmlns:a16="http://schemas.microsoft.com/office/drawing/2014/main" id="{5331F311-B08E-47D9-BBA3-5E88077F7F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89241" y="870883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6" name="Oval 85">
              <a:extLst>
                <a:ext uri="{FF2B5EF4-FFF2-40B4-BE49-F238E27FC236}">
                  <a16:creationId xmlns:a16="http://schemas.microsoft.com/office/drawing/2014/main" id="{0725CFFD-4115-4EF5-9FA5-AEB96082C5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807004" y="870883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7" name="Oval 86">
              <a:extLst>
                <a:ext uri="{FF2B5EF4-FFF2-40B4-BE49-F238E27FC236}">
                  <a16:creationId xmlns:a16="http://schemas.microsoft.com/office/drawing/2014/main" id="{26C2C56A-D2BA-42C9-A09A-1AF26852A9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03466" y="870883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9" name="Oval 88">
              <a:extLst>
                <a:ext uri="{FF2B5EF4-FFF2-40B4-BE49-F238E27FC236}">
                  <a16:creationId xmlns:a16="http://schemas.microsoft.com/office/drawing/2014/main" id="{D4529472-F86C-4926-8690-219B4A722A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332341" y="870883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3" name="Oval 91">
              <a:extLst>
                <a:ext uri="{FF2B5EF4-FFF2-40B4-BE49-F238E27FC236}">
                  <a16:creationId xmlns:a16="http://schemas.microsoft.com/office/drawing/2014/main" id="{CCD1ECE0-1184-426E-8F9A-5413CBBF38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807004" y="870883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8" name="Oval 93">
              <a:extLst>
                <a:ext uri="{FF2B5EF4-FFF2-40B4-BE49-F238E27FC236}">
                  <a16:creationId xmlns:a16="http://schemas.microsoft.com/office/drawing/2014/main" id="{B74AE1A1-EEEE-4ACF-8497-93E6FA9937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11404" y="870883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9" name="Oval 94">
              <a:extLst>
                <a:ext uri="{FF2B5EF4-FFF2-40B4-BE49-F238E27FC236}">
                  <a16:creationId xmlns:a16="http://schemas.microsoft.com/office/drawing/2014/main" id="{3558E23C-6523-486D-A419-C4131F801A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17541" y="765473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1" name="Rectangle 96">
              <a:extLst>
                <a:ext uri="{FF2B5EF4-FFF2-40B4-BE49-F238E27FC236}">
                  <a16:creationId xmlns:a16="http://schemas.microsoft.com/office/drawing/2014/main" id="{F996B569-77C2-4685-B6FC-E611ED7C9C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83012" y="6391659"/>
              <a:ext cx="6421437" cy="4336026"/>
            </a:xfrm>
            <a:custGeom>
              <a:avLst/>
              <a:gdLst>
                <a:gd name="connsiteX0" fmla="*/ 0 w 6421437"/>
                <a:gd name="connsiteY0" fmla="*/ 0 h 4333875"/>
                <a:gd name="connsiteX1" fmla="*/ 6421437 w 6421437"/>
                <a:gd name="connsiteY1" fmla="*/ 0 h 4333875"/>
                <a:gd name="connsiteX2" fmla="*/ 6421437 w 6421437"/>
                <a:gd name="connsiteY2" fmla="*/ 4333875 h 4333875"/>
                <a:gd name="connsiteX3" fmla="*/ 0 w 6421437"/>
                <a:gd name="connsiteY3" fmla="*/ 4333875 h 4333875"/>
                <a:gd name="connsiteX4" fmla="*/ 0 w 6421437"/>
                <a:gd name="connsiteY4" fmla="*/ 0 h 4333875"/>
                <a:gd name="connsiteX0" fmla="*/ 0 w 6421437"/>
                <a:gd name="connsiteY0" fmla="*/ 0 h 4336026"/>
                <a:gd name="connsiteX1" fmla="*/ 2939 w 6421437"/>
                <a:gd name="connsiteY1" fmla="*/ 4336026 h 4336026"/>
                <a:gd name="connsiteX2" fmla="*/ 6421437 w 6421437"/>
                <a:gd name="connsiteY2" fmla="*/ 4333875 h 4336026"/>
                <a:gd name="connsiteX3" fmla="*/ 0 w 6421437"/>
                <a:gd name="connsiteY3" fmla="*/ 4333875 h 4336026"/>
                <a:gd name="connsiteX4" fmla="*/ 0 w 6421437"/>
                <a:gd name="connsiteY4" fmla="*/ 0 h 433602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6421437" h="4336026">
                  <a:moveTo>
                    <a:pt x="0" y="0"/>
                  </a:moveTo>
                  <a:cubicBezTo>
                    <a:pt x="980" y="1445342"/>
                    <a:pt x="1959" y="2890684"/>
                    <a:pt x="2939" y="4336026"/>
                  </a:cubicBezTo>
                  <a:lnTo>
                    <a:pt x="6421437" y="4333875"/>
                  </a:lnTo>
                  <a:lnTo>
                    <a:pt x="0" y="4333875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9050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9" name="Line 103">
              <a:extLst>
                <a:ext uri="{FF2B5EF4-FFF2-40B4-BE49-F238E27FC236}">
                  <a16:creationId xmlns:a16="http://schemas.microsoft.com/office/drawing/2014/main" id="{4B966EF3-623B-46A4-B530-7396B4D3252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83012" y="10725533"/>
              <a:ext cx="0" cy="107950"/>
            </a:xfrm>
            <a:prstGeom prst="line">
              <a:avLst/>
            </a:prstGeom>
            <a:noFill/>
            <a:ln w="19050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6" name="Rectangle 110">
              <a:extLst>
                <a:ext uri="{FF2B5EF4-FFF2-40B4-BE49-F238E27FC236}">
                  <a16:creationId xmlns:a16="http://schemas.microsoft.com/office/drawing/2014/main" id="{43FF3C77-FB38-4CFF-A24B-625D1A8589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4820" y="10825094"/>
              <a:ext cx="12824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2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1" name="Oval 91">
              <a:extLst>
                <a:ext uri="{FF2B5EF4-FFF2-40B4-BE49-F238E27FC236}">
                  <a16:creationId xmlns:a16="http://schemas.microsoft.com/office/drawing/2014/main" id="{B74E5F63-B0CD-456D-B06C-B427450B34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35066" y="6353524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2" name="Line 1570">
              <a:extLst>
                <a:ext uri="{FF2B5EF4-FFF2-40B4-BE49-F238E27FC236}">
                  <a16:creationId xmlns:a16="http://schemas.microsoft.com/office/drawing/2014/main" id="{B20AEA89-1222-47B5-B46A-75AE7AD718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22365" y="10736675"/>
              <a:ext cx="0" cy="107950"/>
            </a:xfrm>
            <a:prstGeom prst="line">
              <a:avLst/>
            </a:prstGeom>
            <a:noFill/>
            <a:ln w="17463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3" name="Line 1571">
              <a:extLst>
                <a:ext uri="{FF2B5EF4-FFF2-40B4-BE49-F238E27FC236}">
                  <a16:creationId xmlns:a16="http://schemas.microsoft.com/office/drawing/2014/main" id="{AD8467D2-5B6A-4AB6-B30B-E100FC994F0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39373" y="10737877"/>
              <a:ext cx="0" cy="107950"/>
            </a:xfrm>
            <a:prstGeom prst="line">
              <a:avLst/>
            </a:prstGeom>
            <a:noFill/>
            <a:ln w="17463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4" name="Line 1572">
              <a:extLst>
                <a:ext uri="{FF2B5EF4-FFF2-40B4-BE49-F238E27FC236}">
                  <a16:creationId xmlns:a16="http://schemas.microsoft.com/office/drawing/2014/main" id="{C0DDC2F9-C9BE-4475-B82B-17335841930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566652" y="10727200"/>
              <a:ext cx="0" cy="107950"/>
            </a:xfrm>
            <a:prstGeom prst="line">
              <a:avLst/>
            </a:prstGeom>
            <a:noFill/>
            <a:ln w="17463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5" name="Line 1573">
              <a:extLst>
                <a:ext uri="{FF2B5EF4-FFF2-40B4-BE49-F238E27FC236}">
                  <a16:creationId xmlns:a16="http://schemas.microsoft.com/office/drawing/2014/main" id="{B50256CE-36DC-479D-8D31-022A49154E3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789176" y="10732937"/>
              <a:ext cx="0" cy="107950"/>
            </a:xfrm>
            <a:prstGeom prst="line">
              <a:avLst/>
            </a:prstGeom>
            <a:noFill/>
            <a:ln w="17463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6" name="Line 1571">
              <a:extLst>
                <a:ext uri="{FF2B5EF4-FFF2-40B4-BE49-F238E27FC236}">
                  <a16:creationId xmlns:a16="http://schemas.microsoft.com/office/drawing/2014/main" id="{6AB0DD8F-3FF4-4055-83D2-A1BF49724D4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04419" y="10729713"/>
              <a:ext cx="0" cy="107950"/>
            </a:xfrm>
            <a:prstGeom prst="line">
              <a:avLst/>
            </a:prstGeom>
            <a:noFill/>
            <a:ln w="17463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7" name="Rectangle 578">
              <a:extLst>
                <a:ext uri="{FF2B5EF4-FFF2-40B4-BE49-F238E27FC236}">
                  <a16:creationId xmlns:a16="http://schemas.microsoft.com/office/drawing/2014/main" id="{32471A2A-826B-4AB0-866D-87A7FDA259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63603" y="10809311"/>
              <a:ext cx="12824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ja-JP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8" name="Rectangle 578">
              <a:extLst>
                <a:ext uri="{FF2B5EF4-FFF2-40B4-BE49-F238E27FC236}">
                  <a16:creationId xmlns:a16="http://schemas.microsoft.com/office/drawing/2014/main" id="{C46CA28E-4AFE-4D69-9952-22698BE9AB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70440" y="10812887"/>
              <a:ext cx="12824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0" lang="ja-JP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9" name="Rectangle 578">
              <a:extLst>
                <a:ext uri="{FF2B5EF4-FFF2-40B4-BE49-F238E27FC236}">
                  <a16:creationId xmlns:a16="http://schemas.microsoft.com/office/drawing/2014/main" id="{88FF0D30-6E06-4576-B766-396DBF79EC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27424" y="10796727"/>
              <a:ext cx="12824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3</a:t>
              </a:r>
              <a:endParaRPr kumimoji="0" lang="ja-JP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0" name="Rectangle 578">
              <a:extLst>
                <a:ext uri="{FF2B5EF4-FFF2-40B4-BE49-F238E27FC236}">
                  <a16:creationId xmlns:a16="http://schemas.microsoft.com/office/drawing/2014/main" id="{C5CE7FF8-1BD9-459E-A8D7-505E3B8604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77156" y="10786608"/>
              <a:ext cx="12824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</a:t>
              </a:r>
              <a:endParaRPr kumimoji="0" lang="ja-JP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1" name="Rectangle 578">
              <a:extLst>
                <a:ext uri="{FF2B5EF4-FFF2-40B4-BE49-F238E27FC236}">
                  <a16:creationId xmlns:a16="http://schemas.microsoft.com/office/drawing/2014/main" id="{672BC08B-1705-484B-955B-FEB6A52CB2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06872" y="10804236"/>
              <a:ext cx="12824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0" lang="ja-JP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C9FDC85A-B3DA-4EEB-A53E-5B4CCE0E5D61}"/>
              </a:ext>
            </a:extLst>
          </p:cNvPr>
          <p:cNvGrpSpPr/>
          <p:nvPr/>
        </p:nvGrpSpPr>
        <p:grpSpPr>
          <a:xfrm>
            <a:off x="11591850" y="2919439"/>
            <a:ext cx="8057434" cy="7232995"/>
            <a:chOff x="11591850" y="4719639"/>
            <a:chExt cx="8057434" cy="7232995"/>
          </a:xfrm>
        </p:grpSpPr>
        <p:sp>
          <p:nvSpPr>
            <p:cNvPr id="447" name="Rectangle 578">
              <a:extLst>
                <a:ext uri="{FF2B5EF4-FFF2-40B4-BE49-F238E27FC236}">
                  <a16:creationId xmlns:a16="http://schemas.microsoft.com/office/drawing/2014/main" id="{AB0E1C44-A0D5-47B7-B5A3-7A1FCEA769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369137" y="9467539"/>
              <a:ext cx="6280147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2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AD2</a:t>
              </a:r>
              <a:r>
                <a:rPr kumimoji="0" lang="en-US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negative and/or </a:t>
              </a:r>
              <a:r>
                <a:rPr kumimoji="0" lang="en-US" altLang="ja-JP" sz="2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</a:t>
              </a:r>
              <a:r>
                <a:rPr kumimoji="0" lang="en-US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negative (n=307)</a:t>
              </a:r>
              <a:endParaRPr kumimoji="0" lang="ja-JP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9" name="Rectangle 578">
              <a:extLst>
                <a:ext uri="{FF2B5EF4-FFF2-40B4-BE49-F238E27FC236}">
                  <a16:creationId xmlns:a16="http://schemas.microsoft.com/office/drawing/2014/main" id="{F47825DA-75B2-4915-9589-2790343994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236458" y="11521747"/>
              <a:ext cx="2708306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2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ears after surgery</a:t>
              </a:r>
              <a:endParaRPr kumimoji="0" lang="ja-JP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0" name="Rectangle 578">
              <a:extLst>
                <a:ext uri="{FF2B5EF4-FFF2-40B4-BE49-F238E27FC236}">
                  <a16:creationId xmlns:a16="http://schemas.microsoft.com/office/drawing/2014/main" id="{2C609FD2-A2A2-4616-ACD3-10992666B21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0646720" y="8170142"/>
              <a:ext cx="2321148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2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 survival</a:t>
              </a:r>
              <a:endParaRPr kumimoji="0" lang="ja-JP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8" name="Line 125">
              <a:extLst>
                <a:ext uri="{FF2B5EF4-FFF2-40B4-BE49-F238E27FC236}">
                  <a16:creationId xmlns:a16="http://schemas.microsoft.com/office/drawing/2014/main" id="{239AF5C2-8348-4E23-8A65-3B394797B35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661111" y="10293385"/>
              <a:ext cx="53975" cy="0"/>
            </a:xfrm>
            <a:prstGeom prst="line">
              <a:avLst/>
            </a:prstGeom>
            <a:noFill/>
            <a:ln w="19050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19" name="Line 126">
              <a:extLst>
                <a:ext uri="{FF2B5EF4-FFF2-40B4-BE49-F238E27FC236}">
                  <a16:creationId xmlns:a16="http://schemas.microsoft.com/office/drawing/2014/main" id="{B727BFD9-5912-4C15-AC52-952632208E7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661111" y="9426610"/>
              <a:ext cx="53975" cy="0"/>
            </a:xfrm>
            <a:prstGeom prst="line">
              <a:avLst/>
            </a:prstGeom>
            <a:noFill/>
            <a:ln w="19050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23" name="Line 130">
              <a:extLst>
                <a:ext uri="{FF2B5EF4-FFF2-40B4-BE49-F238E27FC236}">
                  <a16:creationId xmlns:a16="http://schemas.microsoft.com/office/drawing/2014/main" id="{6E350222-0E4A-4C5D-BD4A-058A35C5C4D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607136" y="10726772"/>
              <a:ext cx="107950" cy="0"/>
            </a:xfrm>
            <a:prstGeom prst="line">
              <a:avLst/>
            </a:prstGeom>
            <a:noFill/>
            <a:ln w="19050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24" name="Line 131">
              <a:extLst>
                <a:ext uri="{FF2B5EF4-FFF2-40B4-BE49-F238E27FC236}">
                  <a16:creationId xmlns:a16="http://schemas.microsoft.com/office/drawing/2014/main" id="{D7A05D8F-0FD0-4E5F-B74A-222978BFE16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607136" y="9859997"/>
              <a:ext cx="107950" cy="0"/>
            </a:xfrm>
            <a:prstGeom prst="line">
              <a:avLst/>
            </a:prstGeom>
            <a:noFill/>
            <a:ln w="19050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25" name="Line 132">
              <a:extLst>
                <a:ext uri="{FF2B5EF4-FFF2-40B4-BE49-F238E27FC236}">
                  <a16:creationId xmlns:a16="http://schemas.microsoft.com/office/drawing/2014/main" id="{9C212430-DBB9-44CF-B711-F085F3F3819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607136" y="8993222"/>
              <a:ext cx="107950" cy="0"/>
            </a:xfrm>
            <a:prstGeom prst="line">
              <a:avLst/>
            </a:prstGeom>
            <a:noFill/>
            <a:ln w="19050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26" name="Line 133">
              <a:extLst>
                <a:ext uri="{FF2B5EF4-FFF2-40B4-BE49-F238E27FC236}">
                  <a16:creationId xmlns:a16="http://schemas.microsoft.com/office/drawing/2014/main" id="{14B5CA3D-9476-4C2D-9D93-74DEFB05C0B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607136" y="8126447"/>
              <a:ext cx="107950" cy="0"/>
            </a:xfrm>
            <a:prstGeom prst="line">
              <a:avLst/>
            </a:prstGeom>
            <a:noFill/>
            <a:ln w="19050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27" name="Line 134">
              <a:extLst>
                <a:ext uri="{FF2B5EF4-FFF2-40B4-BE49-F238E27FC236}">
                  <a16:creationId xmlns:a16="http://schemas.microsoft.com/office/drawing/2014/main" id="{09F9C362-0631-4402-894D-621C59B6096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607136" y="7259672"/>
              <a:ext cx="107950" cy="0"/>
            </a:xfrm>
            <a:prstGeom prst="line">
              <a:avLst/>
            </a:prstGeom>
            <a:noFill/>
            <a:ln w="19050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28" name="Line 135">
              <a:extLst>
                <a:ext uri="{FF2B5EF4-FFF2-40B4-BE49-F238E27FC236}">
                  <a16:creationId xmlns:a16="http://schemas.microsoft.com/office/drawing/2014/main" id="{F784F7BD-2380-4DEB-9742-3375C94B76E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607136" y="6391310"/>
              <a:ext cx="107950" cy="0"/>
            </a:xfrm>
            <a:prstGeom prst="line">
              <a:avLst/>
            </a:prstGeom>
            <a:noFill/>
            <a:ln w="19050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29" name="Rectangle 136">
              <a:extLst>
                <a:ext uri="{FF2B5EF4-FFF2-40B4-BE49-F238E27FC236}">
                  <a16:creationId xmlns:a16="http://schemas.microsoft.com/office/drawing/2014/main" id="{3C3110F4-1975-43F0-9B8B-7ABD55F2E7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14872" y="10526747"/>
              <a:ext cx="32060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2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0" name="Rectangle 137">
              <a:extLst>
                <a:ext uri="{FF2B5EF4-FFF2-40B4-BE49-F238E27FC236}">
                  <a16:creationId xmlns:a16="http://schemas.microsoft.com/office/drawing/2014/main" id="{4FD4E43B-840E-4B18-91C1-6F96162949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14872" y="9659972"/>
              <a:ext cx="32060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2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4" name="Rectangle 138">
              <a:extLst>
                <a:ext uri="{FF2B5EF4-FFF2-40B4-BE49-F238E27FC236}">
                  <a16:creationId xmlns:a16="http://schemas.microsoft.com/office/drawing/2014/main" id="{77E4FE35-BAE2-404A-A0A4-F085A0EE1A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14872" y="8793197"/>
              <a:ext cx="32060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2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5" name="Rectangle 139">
              <a:extLst>
                <a:ext uri="{FF2B5EF4-FFF2-40B4-BE49-F238E27FC236}">
                  <a16:creationId xmlns:a16="http://schemas.microsoft.com/office/drawing/2014/main" id="{D9139DDB-F797-4587-BFB3-7AE8210C5E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14872" y="7926422"/>
              <a:ext cx="32060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2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6" name="Rectangle 140">
              <a:extLst>
                <a:ext uri="{FF2B5EF4-FFF2-40B4-BE49-F238E27FC236}">
                  <a16:creationId xmlns:a16="http://schemas.microsoft.com/office/drawing/2014/main" id="{63F34C4A-635A-433A-80C3-6A7322CC8D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14872" y="7059647"/>
              <a:ext cx="32060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2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2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7" name="Rectangle 141">
              <a:extLst>
                <a:ext uri="{FF2B5EF4-FFF2-40B4-BE49-F238E27FC236}">
                  <a16:creationId xmlns:a16="http://schemas.microsoft.com/office/drawing/2014/main" id="{823BEDFA-9997-4890-BE47-E1887D8296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14872" y="6192872"/>
              <a:ext cx="32060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2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0" name="Freeform 144">
              <a:extLst>
                <a:ext uri="{FF2B5EF4-FFF2-40B4-BE49-F238E27FC236}">
                  <a16:creationId xmlns:a16="http://schemas.microsoft.com/office/drawing/2014/main" id="{B7906F65-C518-4803-8855-CFDE6EE2C69C}"/>
                </a:ext>
              </a:extLst>
            </p:cNvPr>
            <p:cNvSpPr>
              <a:spLocks/>
            </p:cNvSpPr>
            <p:nvPr/>
          </p:nvSpPr>
          <p:spPr bwMode="auto">
            <a:xfrm>
              <a:off x="12707148" y="6383372"/>
              <a:ext cx="6421438" cy="2786063"/>
            </a:xfrm>
            <a:custGeom>
              <a:avLst/>
              <a:gdLst>
                <a:gd name="T0" fmla="*/ 17 w 4045"/>
                <a:gd name="T1" fmla="*/ 9 h 1755"/>
                <a:gd name="T2" fmla="*/ 53 w 4045"/>
                <a:gd name="T3" fmla="*/ 37 h 1755"/>
                <a:gd name="T4" fmla="*/ 100 w 4045"/>
                <a:gd name="T5" fmla="*/ 56 h 1755"/>
                <a:gd name="T6" fmla="*/ 149 w 4045"/>
                <a:gd name="T7" fmla="*/ 84 h 1755"/>
                <a:gd name="T8" fmla="*/ 228 w 4045"/>
                <a:gd name="T9" fmla="*/ 104 h 1755"/>
                <a:gd name="T10" fmla="*/ 270 w 4045"/>
                <a:gd name="T11" fmla="*/ 151 h 1755"/>
                <a:gd name="T12" fmla="*/ 339 w 4045"/>
                <a:gd name="T13" fmla="*/ 190 h 1755"/>
                <a:gd name="T14" fmla="*/ 386 w 4045"/>
                <a:gd name="T15" fmla="*/ 219 h 1755"/>
                <a:gd name="T16" fmla="*/ 410 w 4045"/>
                <a:gd name="T17" fmla="*/ 248 h 1755"/>
                <a:gd name="T18" fmla="*/ 444 w 4045"/>
                <a:gd name="T19" fmla="*/ 297 h 1755"/>
                <a:gd name="T20" fmla="*/ 476 w 4045"/>
                <a:gd name="T21" fmla="*/ 327 h 1755"/>
                <a:gd name="T22" fmla="*/ 539 w 4045"/>
                <a:gd name="T23" fmla="*/ 347 h 1755"/>
                <a:gd name="T24" fmla="*/ 554 w 4045"/>
                <a:gd name="T25" fmla="*/ 377 h 1755"/>
                <a:gd name="T26" fmla="*/ 603 w 4045"/>
                <a:gd name="T27" fmla="*/ 397 h 1755"/>
                <a:gd name="T28" fmla="*/ 620 w 4045"/>
                <a:gd name="T29" fmla="*/ 438 h 1755"/>
                <a:gd name="T30" fmla="*/ 645 w 4045"/>
                <a:gd name="T31" fmla="*/ 479 h 1755"/>
                <a:gd name="T32" fmla="*/ 665 w 4045"/>
                <a:gd name="T33" fmla="*/ 520 h 1755"/>
                <a:gd name="T34" fmla="*/ 745 w 4045"/>
                <a:gd name="T35" fmla="*/ 541 h 1755"/>
                <a:gd name="T36" fmla="*/ 772 w 4045"/>
                <a:gd name="T37" fmla="*/ 593 h 1755"/>
                <a:gd name="T38" fmla="*/ 794 w 4045"/>
                <a:gd name="T39" fmla="*/ 625 h 1755"/>
                <a:gd name="T40" fmla="*/ 829 w 4045"/>
                <a:gd name="T41" fmla="*/ 656 h 1755"/>
                <a:gd name="T42" fmla="*/ 860 w 4045"/>
                <a:gd name="T43" fmla="*/ 678 h 1755"/>
                <a:gd name="T44" fmla="*/ 893 w 4045"/>
                <a:gd name="T45" fmla="*/ 702 h 1755"/>
                <a:gd name="T46" fmla="*/ 936 w 4045"/>
                <a:gd name="T47" fmla="*/ 737 h 1755"/>
                <a:gd name="T48" fmla="*/ 975 w 4045"/>
                <a:gd name="T49" fmla="*/ 761 h 1755"/>
                <a:gd name="T50" fmla="*/ 1013 w 4045"/>
                <a:gd name="T51" fmla="*/ 786 h 1755"/>
                <a:gd name="T52" fmla="*/ 1051 w 4045"/>
                <a:gd name="T53" fmla="*/ 811 h 1755"/>
                <a:gd name="T54" fmla="*/ 1088 w 4045"/>
                <a:gd name="T55" fmla="*/ 836 h 1755"/>
                <a:gd name="T56" fmla="*/ 1124 w 4045"/>
                <a:gd name="T57" fmla="*/ 874 h 1755"/>
                <a:gd name="T58" fmla="*/ 1159 w 4045"/>
                <a:gd name="T59" fmla="*/ 901 h 1755"/>
                <a:gd name="T60" fmla="*/ 1203 w 4045"/>
                <a:gd name="T61" fmla="*/ 927 h 1755"/>
                <a:gd name="T62" fmla="*/ 1237 w 4045"/>
                <a:gd name="T63" fmla="*/ 954 h 1755"/>
                <a:gd name="T64" fmla="*/ 1263 w 4045"/>
                <a:gd name="T65" fmla="*/ 995 h 1755"/>
                <a:gd name="T66" fmla="*/ 1303 w 4045"/>
                <a:gd name="T67" fmla="*/ 1009 h 1755"/>
                <a:gd name="T68" fmla="*/ 1345 w 4045"/>
                <a:gd name="T69" fmla="*/ 1037 h 1755"/>
                <a:gd name="T70" fmla="*/ 1392 w 4045"/>
                <a:gd name="T71" fmla="*/ 1052 h 1755"/>
                <a:gd name="T72" fmla="*/ 1427 w 4045"/>
                <a:gd name="T73" fmla="*/ 1083 h 1755"/>
                <a:gd name="T74" fmla="*/ 1496 w 4045"/>
                <a:gd name="T75" fmla="*/ 1099 h 1755"/>
                <a:gd name="T76" fmla="*/ 1632 w 4045"/>
                <a:gd name="T77" fmla="*/ 1115 h 1755"/>
                <a:gd name="T78" fmla="*/ 1698 w 4045"/>
                <a:gd name="T79" fmla="*/ 1155 h 1755"/>
                <a:gd name="T80" fmla="*/ 1760 w 4045"/>
                <a:gd name="T81" fmla="*/ 1193 h 1755"/>
                <a:gd name="T82" fmla="*/ 1784 w 4045"/>
                <a:gd name="T83" fmla="*/ 1251 h 1755"/>
                <a:gd name="T84" fmla="*/ 1844 w 4045"/>
                <a:gd name="T85" fmla="*/ 1251 h 1755"/>
                <a:gd name="T86" fmla="*/ 1915 w 4045"/>
                <a:gd name="T87" fmla="*/ 1270 h 1755"/>
                <a:gd name="T88" fmla="*/ 1984 w 4045"/>
                <a:gd name="T89" fmla="*/ 1315 h 1755"/>
                <a:gd name="T90" fmla="*/ 2088 w 4045"/>
                <a:gd name="T91" fmla="*/ 1315 h 1755"/>
                <a:gd name="T92" fmla="*/ 2210 w 4045"/>
                <a:gd name="T93" fmla="*/ 1315 h 1755"/>
                <a:gd name="T94" fmla="*/ 2338 w 4045"/>
                <a:gd name="T95" fmla="*/ 1344 h 1755"/>
                <a:gd name="T96" fmla="*/ 2427 w 4045"/>
                <a:gd name="T97" fmla="*/ 1377 h 1755"/>
                <a:gd name="T98" fmla="*/ 2538 w 4045"/>
                <a:gd name="T99" fmla="*/ 1377 h 1755"/>
                <a:gd name="T100" fmla="*/ 2638 w 4045"/>
                <a:gd name="T101" fmla="*/ 1416 h 1755"/>
                <a:gd name="T102" fmla="*/ 2868 w 4045"/>
                <a:gd name="T103" fmla="*/ 1416 h 1755"/>
                <a:gd name="T104" fmla="*/ 3079 w 4045"/>
                <a:gd name="T105" fmla="*/ 1465 h 1755"/>
                <a:gd name="T106" fmla="*/ 3520 w 4045"/>
                <a:gd name="T107" fmla="*/ 1522 h 1755"/>
                <a:gd name="T108" fmla="*/ 3872 w 4045"/>
                <a:gd name="T109" fmla="*/ 1674 h 17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4045" h="1755">
                  <a:moveTo>
                    <a:pt x="0" y="0"/>
                  </a:moveTo>
                  <a:lnTo>
                    <a:pt x="0" y="0"/>
                  </a:lnTo>
                  <a:lnTo>
                    <a:pt x="7" y="0"/>
                  </a:lnTo>
                  <a:lnTo>
                    <a:pt x="7" y="9"/>
                  </a:lnTo>
                  <a:lnTo>
                    <a:pt x="17" y="9"/>
                  </a:lnTo>
                  <a:lnTo>
                    <a:pt x="17" y="18"/>
                  </a:lnTo>
                  <a:lnTo>
                    <a:pt x="31" y="18"/>
                  </a:lnTo>
                  <a:lnTo>
                    <a:pt x="44" y="18"/>
                  </a:lnTo>
                  <a:lnTo>
                    <a:pt x="53" y="27"/>
                  </a:lnTo>
                  <a:lnTo>
                    <a:pt x="53" y="37"/>
                  </a:lnTo>
                  <a:lnTo>
                    <a:pt x="64" y="37"/>
                  </a:lnTo>
                  <a:lnTo>
                    <a:pt x="66" y="47"/>
                  </a:lnTo>
                  <a:lnTo>
                    <a:pt x="69" y="56"/>
                  </a:lnTo>
                  <a:lnTo>
                    <a:pt x="76" y="56"/>
                  </a:lnTo>
                  <a:lnTo>
                    <a:pt x="100" y="56"/>
                  </a:lnTo>
                  <a:lnTo>
                    <a:pt x="100" y="65"/>
                  </a:lnTo>
                  <a:lnTo>
                    <a:pt x="115" y="65"/>
                  </a:lnTo>
                  <a:lnTo>
                    <a:pt x="115" y="75"/>
                  </a:lnTo>
                  <a:lnTo>
                    <a:pt x="135" y="75"/>
                  </a:lnTo>
                  <a:lnTo>
                    <a:pt x="149" y="84"/>
                  </a:lnTo>
                  <a:lnTo>
                    <a:pt x="149" y="94"/>
                  </a:lnTo>
                  <a:lnTo>
                    <a:pt x="169" y="94"/>
                  </a:lnTo>
                  <a:lnTo>
                    <a:pt x="169" y="104"/>
                  </a:lnTo>
                  <a:lnTo>
                    <a:pt x="219" y="104"/>
                  </a:lnTo>
                  <a:lnTo>
                    <a:pt x="228" y="104"/>
                  </a:lnTo>
                  <a:lnTo>
                    <a:pt x="228" y="113"/>
                  </a:lnTo>
                  <a:lnTo>
                    <a:pt x="233" y="132"/>
                  </a:lnTo>
                  <a:lnTo>
                    <a:pt x="250" y="132"/>
                  </a:lnTo>
                  <a:lnTo>
                    <a:pt x="270" y="142"/>
                  </a:lnTo>
                  <a:lnTo>
                    <a:pt x="270" y="151"/>
                  </a:lnTo>
                  <a:lnTo>
                    <a:pt x="274" y="170"/>
                  </a:lnTo>
                  <a:lnTo>
                    <a:pt x="290" y="170"/>
                  </a:lnTo>
                  <a:lnTo>
                    <a:pt x="292" y="180"/>
                  </a:lnTo>
                  <a:lnTo>
                    <a:pt x="339" y="180"/>
                  </a:lnTo>
                  <a:lnTo>
                    <a:pt x="339" y="190"/>
                  </a:lnTo>
                  <a:lnTo>
                    <a:pt x="346" y="200"/>
                  </a:lnTo>
                  <a:lnTo>
                    <a:pt x="368" y="200"/>
                  </a:lnTo>
                  <a:lnTo>
                    <a:pt x="372" y="209"/>
                  </a:lnTo>
                  <a:lnTo>
                    <a:pt x="372" y="219"/>
                  </a:lnTo>
                  <a:lnTo>
                    <a:pt x="386" y="219"/>
                  </a:lnTo>
                  <a:lnTo>
                    <a:pt x="386" y="228"/>
                  </a:lnTo>
                  <a:lnTo>
                    <a:pt x="399" y="228"/>
                  </a:lnTo>
                  <a:lnTo>
                    <a:pt x="399" y="238"/>
                  </a:lnTo>
                  <a:lnTo>
                    <a:pt x="406" y="238"/>
                  </a:lnTo>
                  <a:lnTo>
                    <a:pt x="410" y="248"/>
                  </a:lnTo>
                  <a:lnTo>
                    <a:pt x="417" y="248"/>
                  </a:lnTo>
                  <a:lnTo>
                    <a:pt x="417" y="258"/>
                  </a:lnTo>
                  <a:lnTo>
                    <a:pt x="426" y="277"/>
                  </a:lnTo>
                  <a:lnTo>
                    <a:pt x="439" y="277"/>
                  </a:lnTo>
                  <a:lnTo>
                    <a:pt x="444" y="297"/>
                  </a:lnTo>
                  <a:lnTo>
                    <a:pt x="446" y="307"/>
                  </a:lnTo>
                  <a:lnTo>
                    <a:pt x="470" y="307"/>
                  </a:lnTo>
                  <a:lnTo>
                    <a:pt x="470" y="317"/>
                  </a:lnTo>
                  <a:lnTo>
                    <a:pt x="476" y="317"/>
                  </a:lnTo>
                  <a:lnTo>
                    <a:pt x="476" y="327"/>
                  </a:lnTo>
                  <a:lnTo>
                    <a:pt x="483" y="327"/>
                  </a:lnTo>
                  <a:lnTo>
                    <a:pt x="483" y="337"/>
                  </a:lnTo>
                  <a:lnTo>
                    <a:pt x="497" y="337"/>
                  </a:lnTo>
                  <a:lnTo>
                    <a:pt x="507" y="337"/>
                  </a:lnTo>
                  <a:lnTo>
                    <a:pt x="539" y="347"/>
                  </a:lnTo>
                  <a:lnTo>
                    <a:pt x="539" y="357"/>
                  </a:lnTo>
                  <a:lnTo>
                    <a:pt x="543" y="357"/>
                  </a:lnTo>
                  <a:lnTo>
                    <a:pt x="543" y="367"/>
                  </a:lnTo>
                  <a:lnTo>
                    <a:pt x="554" y="367"/>
                  </a:lnTo>
                  <a:lnTo>
                    <a:pt x="554" y="377"/>
                  </a:lnTo>
                  <a:lnTo>
                    <a:pt x="565" y="377"/>
                  </a:lnTo>
                  <a:lnTo>
                    <a:pt x="565" y="387"/>
                  </a:lnTo>
                  <a:lnTo>
                    <a:pt x="574" y="387"/>
                  </a:lnTo>
                  <a:lnTo>
                    <a:pt x="574" y="397"/>
                  </a:lnTo>
                  <a:lnTo>
                    <a:pt x="603" y="397"/>
                  </a:lnTo>
                  <a:lnTo>
                    <a:pt x="603" y="407"/>
                  </a:lnTo>
                  <a:lnTo>
                    <a:pt x="605" y="418"/>
                  </a:lnTo>
                  <a:lnTo>
                    <a:pt x="608" y="428"/>
                  </a:lnTo>
                  <a:lnTo>
                    <a:pt x="612" y="428"/>
                  </a:lnTo>
                  <a:lnTo>
                    <a:pt x="620" y="438"/>
                  </a:lnTo>
                  <a:lnTo>
                    <a:pt x="622" y="448"/>
                  </a:lnTo>
                  <a:lnTo>
                    <a:pt x="625" y="458"/>
                  </a:lnTo>
                  <a:lnTo>
                    <a:pt x="630" y="469"/>
                  </a:lnTo>
                  <a:lnTo>
                    <a:pt x="645" y="469"/>
                  </a:lnTo>
                  <a:lnTo>
                    <a:pt x="645" y="479"/>
                  </a:lnTo>
                  <a:lnTo>
                    <a:pt x="647" y="490"/>
                  </a:lnTo>
                  <a:lnTo>
                    <a:pt x="656" y="490"/>
                  </a:lnTo>
                  <a:lnTo>
                    <a:pt x="656" y="500"/>
                  </a:lnTo>
                  <a:lnTo>
                    <a:pt x="665" y="500"/>
                  </a:lnTo>
                  <a:lnTo>
                    <a:pt x="665" y="520"/>
                  </a:lnTo>
                  <a:lnTo>
                    <a:pt x="691" y="520"/>
                  </a:lnTo>
                  <a:lnTo>
                    <a:pt x="691" y="530"/>
                  </a:lnTo>
                  <a:lnTo>
                    <a:pt x="716" y="530"/>
                  </a:lnTo>
                  <a:lnTo>
                    <a:pt x="745" y="530"/>
                  </a:lnTo>
                  <a:lnTo>
                    <a:pt x="745" y="541"/>
                  </a:lnTo>
                  <a:lnTo>
                    <a:pt x="756" y="541"/>
                  </a:lnTo>
                  <a:lnTo>
                    <a:pt x="758" y="561"/>
                  </a:lnTo>
                  <a:lnTo>
                    <a:pt x="762" y="572"/>
                  </a:lnTo>
                  <a:lnTo>
                    <a:pt x="772" y="572"/>
                  </a:lnTo>
                  <a:lnTo>
                    <a:pt x="772" y="593"/>
                  </a:lnTo>
                  <a:lnTo>
                    <a:pt x="782" y="593"/>
                  </a:lnTo>
                  <a:lnTo>
                    <a:pt x="782" y="603"/>
                  </a:lnTo>
                  <a:lnTo>
                    <a:pt x="784" y="614"/>
                  </a:lnTo>
                  <a:lnTo>
                    <a:pt x="789" y="625"/>
                  </a:lnTo>
                  <a:lnTo>
                    <a:pt x="794" y="625"/>
                  </a:lnTo>
                  <a:lnTo>
                    <a:pt x="794" y="635"/>
                  </a:lnTo>
                  <a:lnTo>
                    <a:pt x="796" y="645"/>
                  </a:lnTo>
                  <a:lnTo>
                    <a:pt x="813" y="645"/>
                  </a:lnTo>
                  <a:lnTo>
                    <a:pt x="820" y="656"/>
                  </a:lnTo>
                  <a:lnTo>
                    <a:pt x="829" y="656"/>
                  </a:lnTo>
                  <a:lnTo>
                    <a:pt x="833" y="667"/>
                  </a:lnTo>
                  <a:lnTo>
                    <a:pt x="836" y="667"/>
                  </a:lnTo>
                  <a:lnTo>
                    <a:pt x="838" y="678"/>
                  </a:lnTo>
                  <a:lnTo>
                    <a:pt x="849" y="678"/>
                  </a:lnTo>
                  <a:lnTo>
                    <a:pt x="860" y="678"/>
                  </a:lnTo>
                  <a:lnTo>
                    <a:pt x="873" y="678"/>
                  </a:lnTo>
                  <a:lnTo>
                    <a:pt x="889" y="678"/>
                  </a:lnTo>
                  <a:lnTo>
                    <a:pt x="889" y="690"/>
                  </a:lnTo>
                  <a:lnTo>
                    <a:pt x="893" y="690"/>
                  </a:lnTo>
                  <a:lnTo>
                    <a:pt x="893" y="702"/>
                  </a:lnTo>
                  <a:lnTo>
                    <a:pt x="900" y="725"/>
                  </a:lnTo>
                  <a:lnTo>
                    <a:pt x="904" y="725"/>
                  </a:lnTo>
                  <a:lnTo>
                    <a:pt x="915" y="725"/>
                  </a:lnTo>
                  <a:lnTo>
                    <a:pt x="936" y="725"/>
                  </a:lnTo>
                  <a:lnTo>
                    <a:pt x="936" y="737"/>
                  </a:lnTo>
                  <a:lnTo>
                    <a:pt x="944" y="737"/>
                  </a:lnTo>
                  <a:lnTo>
                    <a:pt x="944" y="749"/>
                  </a:lnTo>
                  <a:lnTo>
                    <a:pt x="948" y="761"/>
                  </a:lnTo>
                  <a:lnTo>
                    <a:pt x="956" y="761"/>
                  </a:lnTo>
                  <a:lnTo>
                    <a:pt x="975" y="761"/>
                  </a:lnTo>
                  <a:lnTo>
                    <a:pt x="988" y="761"/>
                  </a:lnTo>
                  <a:lnTo>
                    <a:pt x="988" y="773"/>
                  </a:lnTo>
                  <a:lnTo>
                    <a:pt x="995" y="773"/>
                  </a:lnTo>
                  <a:lnTo>
                    <a:pt x="1013" y="773"/>
                  </a:lnTo>
                  <a:lnTo>
                    <a:pt x="1013" y="786"/>
                  </a:lnTo>
                  <a:lnTo>
                    <a:pt x="1027" y="786"/>
                  </a:lnTo>
                  <a:lnTo>
                    <a:pt x="1033" y="786"/>
                  </a:lnTo>
                  <a:lnTo>
                    <a:pt x="1033" y="798"/>
                  </a:lnTo>
                  <a:lnTo>
                    <a:pt x="1051" y="798"/>
                  </a:lnTo>
                  <a:lnTo>
                    <a:pt x="1051" y="811"/>
                  </a:lnTo>
                  <a:lnTo>
                    <a:pt x="1055" y="811"/>
                  </a:lnTo>
                  <a:lnTo>
                    <a:pt x="1055" y="824"/>
                  </a:lnTo>
                  <a:lnTo>
                    <a:pt x="1057" y="836"/>
                  </a:lnTo>
                  <a:lnTo>
                    <a:pt x="1075" y="836"/>
                  </a:lnTo>
                  <a:lnTo>
                    <a:pt x="1088" y="836"/>
                  </a:lnTo>
                  <a:lnTo>
                    <a:pt x="1088" y="862"/>
                  </a:lnTo>
                  <a:lnTo>
                    <a:pt x="1100" y="862"/>
                  </a:lnTo>
                  <a:lnTo>
                    <a:pt x="1100" y="874"/>
                  </a:lnTo>
                  <a:lnTo>
                    <a:pt x="1108" y="874"/>
                  </a:lnTo>
                  <a:lnTo>
                    <a:pt x="1124" y="874"/>
                  </a:lnTo>
                  <a:lnTo>
                    <a:pt x="1124" y="887"/>
                  </a:lnTo>
                  <a:lnTo>
                    <a:pt x="1132" y="887"/>
                  </a:lnTo>
                  <a:lnTo>
                    <a:pt x="1137" y="901"/>
                  </a:lnTo>
                  <a:lnTo>
                    <a:pt x="1150" y="901"/>
                  </a:lnTo>
                  <a:lnTo>
                    <a:pt x="1159" y="901"/>
                  </a:lnTo>
                  <a:lnTo>
                    <a:pt x="1166" y="901"/>
                  </a:lnTo>
                  <a:lnTo>
                    <a:pt x="1166" y="914"/>
                  </a:lnTo>
                  <a:lnTo>
                    <a:pt x="1181" y="914"/>
                  </a:lnTo>
                  <a:lnTo>
                    <a:pt x="1181" y="927"/>
                  </a:lnTo>
                  <a:lnTo>
                    <a:pt x="1203" y="927"/>
                  </a:lnTo>
                  <a:lnTo>
                    <a:pt x="1217" y="927"/>
                  </a:lnTo>
                  <a:lnTo>
                    <a:pt x="1217" y="940"/>
                  </a:lnTo>
                  <a:lnTo>
                    <a:pt x="1223" y="940"/>
                  </a:lnTo>
                  <a:lnTo>
                    <a:pt x="1223" y="954"/>
                  </a:lnTo>
                  <a:lnTo>
                    <a:pt x="1237" y="954"/>
                  </a:lnTo>
                  <a:lnTo>
                    <a:pt x="1237" y="968"/>
                  </a:lnTo>
                  <a:lnTo>
                    <a:pt x="1241" y="981"/>
                  </a:lnTo>
                  <a:lnTo>
                    <a:pt x="1246" y="981"/>
                  </a:lnTo>
                  <a:lnTo>
                    <a:pt x="1246" y="995"/>
                  </a:lnTo>
                  <a:lnTo>
                    <a:pt x="1263" y="995"/>
                  </a:lnTo>
                  <a:lnTo>
                    <a:pt x="1263" y="1009"/>
                  </a:lnTo>
                  <a:lnTo>
                    <a:pt x="1268" y="1009"/>
                  </a:lnTo>
                  <a:lnTo>
                    <a:pt x="1284" y="1009"/>
                  </a:lnTo>
                  <a:lnTo>
                    <a:pt x="1290" y="1009"/>
                  </a:lnTo>
                  <a:lnTo>
                    <a:pt x="1303" y="1009"/>
                  </a:lnTo>
                  <a:lnTo>
                    <a:pt x="1303" y="1023"/>
                  </a:lnTo>
                  <a:lnTo>
                    <a:pt x="1316" y="1023"/>
                  </a:lnTo>
                  <a:lnTo>
                    <a:pt x="1330" y="1023"/>
                  </a:lnTo>
                  <a:lnTo>
                    <a:pt x="1345" y="1023"/>
                  </a:lnTo>
                  <a:lnTo>
                    <a:pt x="1345" y="1037"/>
                  </a:lnTo>
                  <a:lnTo>
                    <a:pt x="1359" y="1037"/>
                  </a:lnTo>
                  <a:lnTo>
                    <a:pt x="1370" y="1037"/>
                  </a:lnTo>
                  <a:lnTo>
                    <a:pt x="1370" y="1052"/>
                  </a:lnTo>
                  <a:lnTo>
                    <a:pt x="1385" y="1052"/>
                  </a:lnTo>
                  <a:lnTo>
                    <a:pt x="1392" y="1052"/>
                  </a:lnTo>
                  <a:lnTo>
                    <a:pt x="1403" y="1068"/>
                  </a:lnTo>
                  <a:lnTo>
                    <a:pt x="1407" y="1068"/>
                  </a:lnTo>
                  <a:lnTo>
                    <a:pt x="1407" y="1083"/>
                  </a:lnTo>
                  <a:lnTo>
                    <a:pt x="1421" y="1083"/>
                  </a:lnTo>
                  <a:lnTo>
                    <a:pt x="1427" y="1083"/>
                  </a:lnTo>
                  <a:lnTo>
                    <a:pt x="1441" y="1083"/>
                  </a:lnTo>
                  <a:lnTo>
                    <a:pt x="1465" y="1083"/>
                  </a:lnTo>
                  <a:lnTo>
                    <a:pt x="1465" y="1099"/>
                  </a:lnTo>
                  <a:lnTo>
                    <a:pt x="1472" y="1099"/>
                  </a:lnTo>
                  <a:lnTo>
                    <a:pt x="1496" y="1099"/>
                  </a:lnTo>
                  <a:lnTo>
                    <a:pt x="1496" y="1115"/>
                  </a:lnTo>
                  <a:lnTo>
                    <a:pt x="1529" y="1115"/>
                  </a:lnTo>
                  <a:lnTo>
                    <a:pt x="1549" y="1115"/>
                  </a:lnTo>
                  <a:lnTo>
                    <a:pt x="1605" y="1115"/>
                  </a:lnTo>
                  <a:lnTo>
                    <a:pt x="1632" y="1115"/>
                  </a:lnTo>
                  <a:lnTo>
                    <a:pt x="1644" y="1115"/>
                  </a:lnTo>
                  <a:lnTo>
                    <a:pt x="1667" y="1115"/>
                  </a:lnTo>
                  <a:lnTo>
                    <a:pt x="1689" y="1115"/>
                  </a:lnTo>
                  <a:lnTo>
                    <a:pt x="1689" y="1135"/>
                  </a:lnTo>
                  <a:lnTo>
                    <a:pt x="1698" y="1155"/>
                  </a:lnTo>
                  <a:lnTo>
                    <a:pt x="1727" y="1155"/>
                  </a:lnTo>
                  <a:lnTo>
                    <a:pt x="1727" y="1174"/>
                  </a:lnTo>
                  <a:lnTo>
                    <a:pt x="1733" y="1174"/>
                  </a:lnTo>
                  <a:lnTo>
                    <a:pt x="1733" y="1193"/>
                  </a:lnTo>
                  <a:lnTo>
                    <a:pt x="1760" y="1193"/>
                  </a:lnTo>
                  <a:lnTo>
                    <a:pt x="1760" y="1212"/>
                  </a:lnTo>
                  <a:lnTo>
                    <a:pt x="1775" y="1212"/>
                  </a:lnTo>
                  <a:lnTo>
                    <a:pt x="1775" y="1231"/>
                  </a:lnTo>
                  <a:lnTo>
                    <a:pt x="1784" y="1231"/>
                  </a:lnTo>
                  <a:lnTo>
                    <a:pt x="1784" y="1251"/>
                  </a:lnTo>
                  <a:lnTo>
                    <a:pt x="1800" y="1251"/>
                  </a:lnTo>
                  <a:lnTo>
                    <a:pt x="1802" y="1251"/>
                  </a:lnTo>
                  <a:lnTo>
                    <a:pt x="1815" y="1251"/>
                  </a:lnTo>
                  <a:lnTo>
                    <a:pt x="1828" y="1251"/>
                  </a:lnTo>
                  <a:lnTo>
                    <a:pt x="1844" y="1251"/>
                  </a:lnTo>
                  <a:lnTo>
                    <a:pt x="1844" y="1270"/>
                  </a:lnTo>
                  <a:lnTo>
                    <a:pt x="1857" y="1270"/>
                  </a:lnTo>
                  <a:lnTo>
                    <a:pt x="1897" y="1270"/>
                  </a:lnTo>
                  <a:lnTo>
                    <a:pt x="1911" y="1270"/>
                  </a:lnTo>
                  <a:lnTo>
                    <a:pt x="1915" y="1270"/>
                  </a:lnTo>
                  <a:lnTo>
                    <a:pt x="1926" y="1270"/>
                  </a:lnTo>
                  <a:lnTo>
                    <a:pt x="1926" y="1292"/>
                  </a:lnTo>
                  <a:lnTo>
                    <a:pt x="1937" y="1315"/>
                  </a:lnTo>
                  <a:lnTo>
                    <a:pt x="1953" y="1315"/>
                  </a:lnTo>
                  <a:lnTo>
                    <a:pt x="1984" y="1315"/>
                  </a:lnTo>
                  <a:lnTo>
                    <a:pt x="1994" y="1315"/>
                  </a:lnTo>
                  <a:lnTo>
                    <a:pt x="2021" y="1315"/>
                  </a:lnTo>
                  <a:lnTo>
                    <a:pt x="2057" y="1315"/>
                  </a:lnTo>
                  <a:lnTo>
                    <a:pt x="2083" y="1315"/>
                  </a:lnTo>
                  <a:lnTo>
                    <a:pt x="2088" y="1315"/>
                  </a:lnTo>
                  <a:lnTo>
                    <a:pt x="2097" y="1315"/>
                  </a:lnTo>
                  <a:lnTo>
                    <a:pt x="2108" y="1315"/>
                  </a:lnTo>
                  <a:lnTo>
                    <a:pt x="2154" y="1315"/>
                  </a:lnTo>
                  <a:lnTo>
                    <a:pt x="2174" y="1315"/>
                  </a:lnTo>
                  <a:lnTo>
                    <a:pt x="2210" y="1315"/>
                  </a:lnTo>
                  <a:lnTo>
                    <a:pt x="2239" y="1315"/>
                  </a:lnTo>
                  <a:lnTo>
                    <a:pt x="2301" y="1315"/>
                  </a:lnTo>
                  <a:lnTo>
                    <a:pt x="2312" y="1315"/>
                  </a:lnTo>
                  <a:lnTo>
                    <a:pt x="2312" y="1344"/>
                  </a:lnTo>
                  <a:lnTo>
                    <a:pt x="2338" y="1344"/>
                  </a:lnTo>
                  <a:lnTo>
                    <a:pt x="2376" y="1344"/>
                  </a:lnTo>
                  <a:lnTo>
                    <a:pt x="2401" y="1344"/>
                  </a:lnTo>
                  <a:lnTo>
                    <a:pt x="2416" y="1344"/>
                  </a:lnTo>
                  <a:lnTo>
                    <a:pt x="2427" y="1344"/>
                  </a:lnTo>
                  <a:lnTo>
                    <a:pt x="2427" y="1377"/>
                  </a:lnTo>
                  <a:lnTo>
                    <a:pt x="2438" y="1377"/>
                  </a:lnTo>
                  <a:lnTo>
                    <a:pt x="2451" y="1377"/>
                  </a:lnTo>
                  <a:lnTo>
                    <a:pt x="2492" y="1377"/>
                  </a:lnTo>
                  <a:lnTo>
                    <a:pt x="2509" y="1377"/>
                  </a:lnTo>
                  <a:lnTo>
                    <a:pt x="2538" y="1377"/>
                  </a:lnTo>
                  <a:lnTo>
                    <a:pt x="2555" y="1377"/>
                  </a:lnTo>
                  <a:lnTo>
                    <a:pt x="2555" y="1416"/>
                  </a:lnTo>
                  <a:lnTo>
                    <a:pt x="2571" y="1416"/>
                  </a:lnTo>
                  <a:lnTo>
                    <a:pt x="2624" y="1416"/>
                  </a:lnTo>
                  <a:lnTo>
                    <a:pt x="2638" y="1416"/>
                  </a:lnTo>
                  <a:lnTo>
                    <a:pt x="2660" y="1416"/>
                  </a:lnTo>
                  <a:lnTo>
                    <a:pt x="2682" y="1416"/>
                  </a:lnTo>
                  <a:lnTo>
                    <a:pt x="2711" y="1416"/>
                  </a:lnTo>
                  <a:lnTo>
                    <a:pt x="2739" y="1416"/>
                  </a:lnTo>
                  <a:lnTo>
                    <a:pt x="2868" y="1416"/>
                  </a:lnTo>
                  <a:lnTo>
                    <a:pt x="2868" y="1465"/>
                  </a:lnTo>
                  <a:lnTo>
                    <a:pt x="2874" y="1465"/>
                  </a:lnTo>
                  <a:lnTo>
                    <a:pt x="2923" y="1465"/>
                  </a:lnTo>
                  <a:lnTo>
                    <a:pt x="3030" y="1465"/>
                  </a:lnTo>
                  <a:lnTo>
                    <a:pt x="3079" y="1465"/>
                  </a:lnTo>
                  <a:lnTo>
                    <a:pt x="3119" y="1465"/>
                  </a:lnTo>
                  <a:lnTo>
                    <a:pt x="3119" y="1522"/>
                  </a:lnTo>
                  <a:lnTo>
                    <a:pt x="3172" y="1522"/>
                  </a:lnTo>
                  <a:lnTo>
                    <a:pt x="3289" y="1522"/>
                  </a:lnTo>
                  <a:lnTo>
                    <a:pt x="3520" y="1522"/>
                  </a:lnTo>
                  <a:lnTo>
                    <a:pt x="3646" y="1522"/>
                  </a:lnTo>
                  <a:lnTo>
                    <a:pt x="3737" y="1522"/>
                  </a:lnTo>
                  <a:lnTo>
                    <a:pt x="3737" y="1598"/>
                  </a:lnTo>
                  <a:lnTo>
                    <a:pt x="3872" y="1598"/>
                  </a:lnTo>
                  <a:lnTo>
                    <a:pt x="3872" y="1674"/>
                  </a:lnTo>
                  <a:lnTo>
                    <a:pt x="3912" y="1674"/>
                  </a:lnTo>
                  <a:lnTo>
                    <a:pt x="4014" y="1674"/>
                  </a:lnTo>
                  <a:lnTo>
                    <a:pt x="4014" y="1755"/>
                  </a:lnTo>
                  <a:lnTo>
                    <a:pt x="4045" y="1755"/>
                  </a:lnTo>
                </a:path>
              </a:pathLst>
            </a:custGeom>
            <a:noFill/>
            <a:ln w="12700" cap="flat">
              <a:solidFill>
                <a:schemeClr val="tx1"/>
              </a:solidFill>
              <a:prstDash val="sys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71" name="Oval 145">
              <a:extLst>
                <a:ext uri="{FF2B5EF4-FFF2-40B4-BE49-F238E27FC236}">
                  <a16:creationId xmlns:a16="http://schemas.microsoft.com/office/drawing/2014/main" id="{44DB9AF1-E65E-4903-A1D0-635E0B7044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05937" y="900193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76" name="Oval 146">
              <a:extLst>
                <a:ext uri="{FF2B5EF4-FFF2-40B4-BE49-F238E27FC236}">
                  <a16:creationId xmlns:a16="http://schemas.microsoft.com/office/drawing/2014/main" id="{67C48B5F-AA31-48AD-8B47-ADFDD9D036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553137" y="83304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82" name="Oval 147">
              <a:extLst>
                <a:ext uri="{FF2B5EF4-FFF2-40B4-BE49-F238E27FC236}">
                  <a16:creationId xmlns:a16="http://schemas.microsoft.com/office/drawing/2014/main" id="{C916F0A2-16FE-43F4-ADE4-94D2770486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948175" y="732077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86" name="Oval 148">
              <a:extLst>
                <a:ext uri="{FF2B5EF4-FFF2-40B4-BE49-F238E27FC236}">
                  <a16:creationId xmlns:a16="http://schemas.microsoft.com/office/drawing/2014/main" id="{0E9A2A34-05C8-4DE2-8596-8EB8628832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89550" y="797006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02" name="Oval 156">
              <a:extLst>
                <a:ext uri="{FF2B5EF4-FFF2-40B4-BE49-F238E27FC236}">
                  <a16:creationId xmlns:a16="http://schemas.microsoft.com/office/drawing/2014/main" id="{FC623254-EDF5-4E66-9406-7E033FDDF3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07212" y="847965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03" name="Oval 157">
              <a:extLst>
                <a:ext uri="{FF2B5EF4-FFF2-40B4-BE49-F238E27FC236}">
                  <a16:creationId xmlns:a16="http://schemas.microsoft.com/office/drawing/2014/main" id="{03A0B554-08B6-4CF5-9214-1E21DAFB1C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02200" y="767320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10" name="Oval 160">
              <a:extLst>
                <a:ext uri="{FF2B5EF4-FFF2-40B4-BE49-F238E27FC236}">
                  <a16:creationId xmlns:a16="http://schemas.microsoft.com/office/drawing/2014/main" id="{2C03D175-0F01-474C-B2A5-6F0ADB968B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159312" y="749698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12" name="Oval 162">
              <a:extLst>
                <a:ext uri="{FF2B5EF4-FFF2-40B4-BE49-F238E27FC236}">
                  <a16:creationId xmlns:a16="http://schemas.microsoft.com/office/drawing/2014/main" id="{D1F32943-3BF8-4B74-8190-4CF5753757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881875" y="859395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19" name="Oval 164">
              <a:extLst>
                <a:ext uri="{FF2B5EF4-FFF2-40B4-BE49-F238E27FC236}">
                  <a16:creationId xmlns:a16="http://schemas.microsoft.com/office/drawing/2014/main" id="{4DE82683-80B6-4D65-B3B5-4310AD8425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204012" y="84320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22" name="Oval 167">
              <a:extLst>
                <a:ext uri="{FF2B5EF4-FFF2-40B4-BE49-F238E27FC236}">
                  <a16:creationId xmlns:a16="http://schemas.microsoft.com/office/drawing/2014/main" id="{937E293D-0FE4-4481-8CEE-CC4704C017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22837" y="767320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25" name="Oval 169">
              <a:extLst>
                <a:ext uri="{FF2B5EF4-FFF2-40B4-BE49-F238E27FC236}">
                  <a16:creationId xmlns:a16="http://schemas.microsoft.com/office/drawing/2014/main" id="{B76BB25C-7014-4BA3-BCB9-5186E36ECA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97762" y="859395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32" name="Oval 170">
              <a:extLst>
                <a:ext uri="{FF2B5EF4-FFF2-40B4-BE49-F238E27FC236}">
                  <a16:creationId xmlns:a16="http://schemas.microsoft.com/office/drawing/2014/main" id="{6F76E643-0679-4EC8-ACC6-D3E2F361D1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002400" y="84320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33" name="Oval 171">
              <a:extLst>
                <a:ext uri="{FF2B5EF4-FFF2-40B4-BE49-F238E27FC236}">
                  <a16:creationId xmlns:a16="http://schemas.microsoft.com/office/drawing/2014/main" id="{49D59E09-7F93-4C52-B9B5-6D171BA78F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034150" y="84320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34" name="Oval 172">
              <a:extLst>
                <a:ext uri="{FF2B5EF4-FFF2-40B4-BE49-F238E27FC236}">
                  <a16:creationId xmlns:a16="http://schemas.microsoft.com/office/drawing/2014/main" id="{51064DA9-F47A-40E7-BE8A-35E1D95B3C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505762" y="867015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41" name="Oval 173">
              <a:extLst>
                <a:ext uri="{FF2B5EF4-FFF2-40B4-BE49-F238E27FC236}">
                  <a16:creationId xmlns:a16="http://schemas.microsoft.com/office/drawing/2014/main" id="{C9BBC3D9-2644-4335-84E9-51F00D0C14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38787" y="809071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43" name="Oval 174">
              <a:extLst>
                <a:ext uri="{FF2B5EF4-FFF2-40B4-BE49-F238E27FC236}">
                  <a16:creationId xmlns:a16="http://schemas.microsoft.com/office/drawing/2014/main" id="{6E50DA8E-891C-4FA6-8071-2B2CA0B90B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681475" y="704137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45" name="Oval 175">
              <a:extLst>
                <a:ext uri="{FF2B5EF4-FFF2-40B4-BE49-F238E27FC236}">
                  <a16:creationId xmlns:a16="http://schemas.microsoft.com/office/drawing/2014/main" id="{2D320152-61C2-418E-A44E-5D013A49F5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65962" y="85336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49" name="Oval 176">
              <a:extLst>
                <a:ext uri="{FF2B5EF4-FFF2-40B4-BE49-F238E27FC236}">
                  <a16:creationId xmlns:a16="http://schemas.microsoft.com/office/drawing/2014/main" id="{3FC01335-A7E9-424F-86C5-94FFA0E649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67537" y="847965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50" name="Oval 177">
              <a:extLst>
                <a:ext uri="{FF2B5EF4-FFF2-40B4-BE49-F238E27FC236}">
                  <a16:creationId xmlns:a16="http://schemas.microsoft.com/office/drawing/2014/main" id="{806544F8-A999-4A96-92DD-949FA3B703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31037" y="847965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55" name="Oval 178">
              <a:extLst>
                <a:ext uri="{FF2B5EF4-FFF2-40B4-BE49-F238E27FC236}">
                  <a16:creationId xmlns:a16="http://schemas.microsoft.com/office/drawing/2014/main" id="{E97FAE30-BD56-4904-B2CE-3F2E564064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53312" y="859395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85" name="Oval 184">
              <a:extLst>
                <a:ext uri="{FF2B5EF4-FFF2-40B4-BE49-F238E27FC236}">
                  <a16:creationId xmlns:a16="http://schemas.microsoft.com/office/drawing/2014/main" id="{06AD5A18-31A7-402D-9E3A-40EE94BA50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857937" y="84320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87" name="Oval 185">
              <a:extLst>
                <a:ext uri="{FF2B5EF4-FFF2-40B4-BE49-F238E27FC236}">
                  <a16:creationId xmlns:a16="http://schemas.microsoft.com/office/drawing/2014/main" id="{FF9F3A96-F757-41C3-98FA-7F1FBA98FE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250050" y="84320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88" name="Oval 186">
              <a:extLst>
                <a:ext uri="{FF2B5EF4-FFF2-40B4-BE49-F238E27FC236}">
                  <a16:creationId xmlns:a16="http://schemas.microsoft.com/office/drawing/2014/main" id="{F6B2E540-6C73-4066-83E1-8B70421462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81850" y="85336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5" name="Oval 188">
              <a:extLst>
                <a:ext uri="{FF2B5EF4-FFF2-40B4-BE49-F238E27FC236}">
                  <a16:creationId xmlns:a16="http://schemas.microsoft.com/office/drawing/2014/main" id="{0EF44DEA-92D9-4DCA-86DE-261DF7F129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862700" y="84320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3" name="Oval 190">
              <a:extLst>
                <a:ext uri="{FF2B5EF4-FFF2-40B4-BE49-F238E27FC236}">
                  <a16:creationId xmlns:a16="http://schemas.microsoft.com/office/drawing/2014/main" id="{B3FD2CCC-B4FF-4E9B-87E5-2200B9EED9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46862" y="84320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0" name="Oval 192">
              <a:extLst>
                <a:ext uri="{FF2B5EF4-FFF2-40B4-BE49-F238E27FC236}">
                  <a16:creationId xmlns:a16="http://schemas.microsoft.com/office/drawing/2014/main" id="{86E52B06-9215-489F-BADB-AB5ADD12F2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845237" y="84320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1" name="Oval 196">
              <a:extLst>
                <a:ext uri="{FF2B5EF4-FFF2-40B4-BE49-F238E27FC236}">
                  <a16:creationId xmlns:a16="http://schemas.microsoft.com/office/drawing/2014/main" id="{9B5BC5B7-62A8-4350-A4C5-478FA17AC1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86212" y="688103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9" name="Oval 197">
              <a:extLst>
                <a:ext uri="{FF2B5EF4-FFF2-40B4-BE49-F238E27FC236}">
                  <a16:creationId xmlns:a16="http://schemas.microsoft.com/office/drawing/2014/main" id="{40FA62F3-1FE3-4D77-B735-60E47933C7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024625" y="84320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1" name="Oval 199">
              <a:extLst>
                <a:ext uri="{FF2B5EF4-FFF2-40B4-BE49-F238E27FC236}">
                  <a16:creationId xmlns:a16="http://schemas.microsoft.com/office/drawing/2014/main" id="{C893BA2F-71B0-437A-BEA4-D56EB1A940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70537" y="809071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8" name="Oval 202">
              <a:extLst>
                <a:ext uri="{FF2B5EF4-FFF2-40B4-BE49-F238E27FC236}">
                  <a16:creationId xmlns:a16="http://schemas.microsoft.com/office/drawing/2014/main" id="{6E6730C7-92C6-448D-95BA-D3B4A1E124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156012" y="66159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1" name="Oval 203">
              <a:extLst>
                <a:ext uri="{FF2B5EF4-FFF2-40B4-BE49-F238E27FC236}">
                  <a16:creationId xmlns:a16="http://schemas.microsoft.com/office/drawing/2014/main" id="{5FD31CAF-2C19-4C26-99EE-7DDE099C50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197412" y="753508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5" name="Oval 205">
              <a:extLst>
                <a:ext uri="{FF2B5EF4-FFF2-40B4-BE49-F238E27FC236}">
                  <a16:creationId xmlns:a16="http://schemas.microsoft.com/office/drawing/2014/main" id="{E0715A52-29B1-4F40-B5FC-505C839F23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042087" y="84320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6" name="Oval 206">
              <a:extLst>
                <a:ext uri="{FF2B5EF4-FFF2-40B4-BE49-F238E27FC236}">
                  <a16:creationId xmlns:a16="http://schemas.microsoft.com/office/drawing/2014/main" id="{BF796608-3361-456E-8A49-CB3200443E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83037" y="688103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63" name="Oval 208">
              <a:extLst>
                <a:ext uri="{FF2B5EF4-FFF2-40B4-BE49-F238E27FC236}">
                  <a16:creationId xmlns:a16="http://schemas.microsoft.com/office/drawing/2014/main" id="{D3803DCA-002F-4E1A-9AE0-A5EEE96EB9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094100" y="655560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71" name="Oval 210">
              <a:extLst>
                <a:ext uri="{FF2B5EF4-FFF2-40B4-BE49-F238E27FC236}">
                  <a16:creationId xmlns:a16="http://schemas.microsoft.com/office/drawing/2014/main" id="{4D9CF282-0271-4FBD-A016-62D263EDD2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681475" y="704137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75" name="Oval 211">
              <a:extLst>
                <a:ext uri="{FF2B5EF4-FFF2-40B4-BE49-F238E27FC236}">
                  <a16:creationId xmlns:a16="http://schemas.microsoft.com/office/drawing/2014/main" id="{D1D6C511-E133-49C3-A258-D02C0390F1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859400" y="799228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81" name="Oval 212">
              <a:extLst>
                <a:ext uri="{FF2B5EF4-FFF2-40B4-BE49-F238E27FC236}">
                  <a16:creationId xmlns:a16="http://schemas.microsoft.com/office/drawing/2014/main" id="{73825E61-B1B2-4389-829D-B7F3E70680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814700" y="643495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88" name="Oval 213">
              <a:extLst>
                <a:ext uri="{FF2B5EF4-FFF2-40B4-BE49-F238E27FC236}">
                  <a16:creationId xmlns:a16="http://schemas.microsoft.com/office/drawing/2014/main" id="{232125F2-BECB-4952-ACE6-268B18363F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64062" y="742237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89" name="Oval 214">
              <a:extLst>
                <a:ext uri="{FF2B5EF4-FFF2-40B4-BE49-F238E27FC236}">
                  <a16:creationId xmlns:a16="http://schemas.microsoft.com/office/drawing/2014/main" id="{0A11B76A-F5EC-4D34-8EA2-60C7B9226F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597587" y="83304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1" name="Oval 215">
              <a:extLst>
                <a:ext uri="{FF2B5EF4-FFF2-40B4-BE49-F238E27FC236}">
                  <a16:creationId xmlns:a16="http://schemas.microsoft.com/office/drawing/2014/main" id="{5105AA74-81FF-47B9-B31B-7747E0572A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707125" y="836217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4" name="Oval 217">
              <a:extLst>
                <a:ext uri="{FF2B5EF4-FFF2-40B4-BE49-F238E27FC236}">
                  <a16:creationId xmlns:a16="http://schemas.microsoft.com/office/drawing/2014/main" id="{80271E7C-2A87-4553-BD92-C469948555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2087" y="688103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5" name="Oval 218">
              <a:extLst>
                <a:ext uri="{FF2B5EF4-FFF2-40B4-BE49-F238E27FC236}">
                  <a16:creationId xmlns:a16="http://schemas.microsoft.com/office/drawing/2014/main" id="{DD13F441-3656-4C3B-A879-FD996A5F0A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556312" y="83304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6" name="Oval 219">
              <a:extLst>
                <a:ext uri="{FF2B5EF4-FFF2-40B4-BE49-F238E27FC236}">
                  <a16:creationId xmlns:a16="http://schemas.microsoft.com/office/drawing/2014/main" id="{5BDB8BA7-F2CA-4C15-92F3-E875FA8FC6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49937" y="811770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8" name="Oval 220">
              <a:extLst>
                <a:ext uri="{FF2B5EF4-FFF2-40B4-BE49-F238E27FC236}">
                  <a16:creationId xmlns:a16="http://schemas.microsoft.com/office/drawing/2014/main" id="{3B1BC396-5664-49B8-94D4-4872B59FF1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15112" y="84320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14" name="Oval 224">
              <a:extLst>
                <a:ext uri="{FF2B5EF4-FFF2-40B4-BE49-F238E27FC236}">
                  <a16:creationId xmlns:a16="http://schemas.microsoft.com/office/drawing/2014/main" id="{296EE864-0FD0-4297-A095-F70692B4F5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840225" y="718901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17" name="Oval 225">
              <a:extLst>
                <a:ext uri="{FF2B5EF4-FFF2-40B4-BE49-F238E27FC236}">
                  <a16:creationId xmlns:a16="http://schemas.microsoft.com/office/drawing/2014/main" id="{B026AE87-A349-49B0-9DBB-BD7AA0CE5E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48475" y="84320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25" name="Oval 229">
              <a:extLst>
                <a:ext uri="{FF2B5EF4-FFF2-40B4-BE49-F238E27FC236}">
                  <a16:creationId xmlns:a16="http://schemas.microsoft.com/office/drawing/2014/main" id="{82478334-8E5E-416B-8942-430ACE708D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45212" y="836217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44" name="Oval 231">
              <a:extLst>
                <a:ext uri="{FF2B5EF4-FFF2-40B4-BE49-F238E27FC236}">
                  <a16:creationId xmlns:a16="http://schemas.microsoft.com/office/drawing/2014/main" id="{9BBDD37B-7983-496D-B668-EF546773FA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75175" y="742237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52" name="Oval 234">
              <a:extLst>
                <a:ext uri="{FF2B5EF4-FFF2-40B4-BE49-F238E27FC236}">
                  <a16:creationId xmlns:a16="http://schemas.microsoft.com/office/drawing/2014/main" id="{5AE7D4E3-09C2-4594-84B2-EE068ACC95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211700" y="755413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54" name="Oval 235">
              <a:extLst>
                <a:ext uri="{FF2B5EF4-FFF2-40B4-BE49-F238E27FC236}">
                  <a16:creationId xmlns:a16="http://schemas.microsoft.com/office/drawing/2014/main" id="{B20E13AD-A94F-4AC0-954C-3ABDCE28A0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729350" y="836217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56" name="Oval 236">
              <a:extLst>
                <a:ext uri="{FF2B5EF4-FFF2-40B4-BE49-F238E27FC236}">
                  <a16:creationId xmlns:a16="http://schemas.microsoft.com/office/drawing/2014/main" id="{B8224B96-EDD4-4BE5-AA28-65767A0975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141850" y="749698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59" name="Oval 237">
              <a:extLst>
                <a:ext uri="{FF2B5EF4-FFF2-40B4-BE49-F238E27FC236}">
                  <a16:creationId xmlns:a16="http://schemas.microsoft.com/office/drawing/2014/main" id="{39AE8BFB-64D1-460F-9D13-8DA38B17E8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905437" y="801610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61" name="Oval 238">
              <a:extLst>
                <a:ext uri="{FF2B5EF4-FFF2-40B4-BE49-F238E27FC236}">
                  <a16:creationId xmlns:a16="http://schemas.microsoft.com/office/drawing/2014/main" id="{4C208050-CA03-4013-AD17-FC12DE429A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817875" y="643495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67" name="Oval 240">
              <a:extLst>
                <a:ext uri="{FF2B5EF4-FFF2-40B4-BE49-F238E27FC236}">
                  <a16:creationId xmlns:a16="http://schemas.microsoft.com/office/drawing/2014/main" id="{35396DAD-6641-4E98-B952-A10958B972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244912" y="664608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68" name="Oval 241">
              <a:extLst>
                <a:ext uri="{FF2B5EF4-FFF2-40B4-BE49-F238E27FC236}">
                  <a16:creationId xmlns:a16="http://schemas.microsoft.com/office/drawing/2014/main" id="{7F94C578-5197-4F76-B414-6E4C80BA17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132325" y="749698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78" name="Oval 244">
              <a:extLst>
                <a:ext uri="{FF2B5EF4-FFF2-40B4-BE49-F238E27FC236}">
                  <a16:creationId xmlns:a16="http://schemas.microsoft.com/office/drawing/2014/main" id="{F830D908-D4CC-499A-B710-A23991C97A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60887" y="742237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79" name="Oval 245">
              <a:extLst>
                <a:ext uri="{FF2B5EF4-FFF2-40B4-BE49-F238E27FC236}">
                  <a16:creationId xmlns:a16="http://schemas.microsoft.com/office/drawing/2014/main" id="{B1C1EC4F-D91C-4D09-B19E-759A05A203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43425" y="742237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82" name="Oval 246">
              <a:extLst>
                <a:ext uri="{FF2B5EF4-FFF2-40B4-BE49-F238E27FC236}">
                  <a16:creationId xmlns:a16="http://schemas.microsoft.com/office/drawing/2014/main" id="{8BC3901A-8AF1-4BBC-AAFE-62446F6FF5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35487" y="742237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84" name="Oval 248">
              <a:extLst>
                <a:ext uri="{FF2B5EF4-FFF2-40B4-BE49-F238E27FC236}">
                  <a16:creationId xmlns:a16="http://schemas.microsoft.com/office/drawing/2014/main" id="{B725BEE5-8877-4DA1-AC97-A87E0B79FF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14850" y="738745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87" name="Oval 249">
              <a:extLst>
                <a:ext uri="{FF2B5EF4-FFF2-40B4-BE49-F238E27FC236}">
                  <a16:creationId xmlns:a16="http://schemas.microsoft.com/office/drawing/2014/main" id="{17F24437-BDAB-475B-B4F0-0D8371EE53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11675" y="738745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91" name="Oval 250">
              <a:extLst>
                <a:ext uri="{FF2B5EF4-FFF2-40B4-BE49-F238E27FC236}">
                  <a16:creationId xmlns:a16="http://schemas.microsoft.com/office/drawing/2014/main" id="{F55D83A8-4AEE-4754-8A70-85E3AF0ED9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22787" y="740491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92" name="Oval 251">
              <a:extLst>
                <a:ext uri="{FF2B5EF4-FFF2-40B4-BE49-F238E27FC236}">
                  <a16:creationId xmlns:a16="http://schemas.microsoft.com/office/drawing/2014/main" id="{04FA313C-8B2F-4F56-B71F-21A27E567A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43425" y="742237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99" name="Oval 253">
              <a:extLst>
                <a:ext uri="{FF2B5EF4-FFF2-40B4-BE49-F238E27FC236}">
                  <a16:creationId xmlns:a16="http://schemas.microsoft.com/office/drawing/2014/main" id="{739B15B8-E8BD-46A7-9FF2-3EA9424876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341875" y="761287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02" name="Oval 254">
              <a:extLst>
                <a:ext uri="{FF2B5EF4-FFF2-40B4-BE49-F238E27FC236}">
                  <a16:creationId xmlns:a16="http://schemas.microsoft.com/office/drawing/2014/main" id="{57C7854F-27B3-4700-B1CC-35D7436930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987862" y="736998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04" name="Oval 255">
              <a:extLst>
                <a:ext uri="{FF2B5EF4-FFF2-40B4-BE49-F238E27FC236}">
                  <a16:creationId xmlns:a16="http://schemas.microsoft.com/office/drawing/2014/main" id="{598CFF84-4DB4-4079-9F57-C3FDC79948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67237" y="742237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07" name="Oval 256">
              <a:extLst>
                <a:ext uri="{FF2B5EF4-FFF2-40B4-BE49-F238E27FC236}">
                  <a16:creationId xmlns:a16="http://schemas.microsoft.com/office/drawing/2014/main" id="{608C3E92-3994-41D6-ACBC-9915FD2333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25962" y="740491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15" name="Oval 258">
              <a:extLst>
                <a:ext uri="{FF2B5EF4-FFF2-40B4-BE49-F238E27FC236}">
                  <a16:creationId xmlns:a16="http://schemas.microsoft.com/office/drawing/2014/main" id="{1106D15F-2DAC-49F3-9BCE-9B5054A8CE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11675" y="738745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18" name="Oval 260">
              <a:extLst>
                <a:ext uri="{FF2B5EF4-FFF2-40B4-BE49-F238E27FC236}">
                  <a16:creationId xmlns:a16="http://schemas.microsoft.com/office/drawing/2014/main" id="{79857F37-7B38-40A7-8DCD-1CA2C82D56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25962" y="740491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25" name="Oval 263">
              <a:extLst>
                <a:ext uri="{FF2B5EF4-FFF2-40B4-BE49-F238E27FC236}">
                  <a16:creationId xmlns:a16="http://schemas.microsoft.com/office/drawing/2014/main" id="{A8542036-FE9D-49CF-B847-6B8C86094E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00562" y="738745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38" name="Oval 265">
              <a:extLst>
                <a:ext uri="{FF2B5EF4-FFF2-40B4-BE49-F238E27FC236}">
                  <a16:creationId xmlns:a16="http://schemas.microsoft.com/office/drawing/2014/main" id="{06F40DE1-E67E-4FCB-BAEC-1724B12E3D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46600" y="742237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44" name="Oval 266">
              <a:extLst>
                <a:ext uri="{FF2B5EF4-FFF2-40B4-BE49-F238E27FC236}">
                  <a16:creationId xmlns:a16="http://schemas.microsoft.com/office/drawing/2014/main" id="{59512521-C505-420B-AB63-A32FF15E44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02200" y="767320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47" name="Oval 268">
              <a:extLst>
                <a:ext uri="{FF2B5EF4-FFF2-40B4-BE49-F238E27FC236}">
                  <a16:creationId xmlns:a16="http://schemas.microsoft.com/office/drawing/2014/main" id="{21D7632C-2FF5-48D2-886C-DA1ADD3823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51300" y="689691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48" name="Oval 269">
              <a:extLst>
                <a:ext uri="{FF2B5EF4-FFF2-40B4-BE49-F238E27FC236}">
                  <a16:creationId xmlns:a16="http://schemas.microsoft.com/office/drawing/2014/main" id="{60C285DA-9E36-49ED-A516-B9E7CA4587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57650" y="691278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62" name="Oval 270">
              <a:extLst>
                <a:ext uri="{FF2B5EF4-FFF2-40B4-BE49-F238E27FC236}">
                  <a16:creationId xmlns:a16="http://schemas.microsoft.com/office/drawing/2014/main" id="{6E30A6B0-18A0-4384-9F43-759D40F13F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83662" y="87622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73" name="Oval 273">
              <a:extLst>
                <a:ext uri="{FF2B5EF4-FFF2-40B4-BE49-F238E27FC236}">
                  <a16:creationId xmlns:a16="http://schemas.microsoft.com/office/drawing/2014/main" id="{D938FE60-74EA-4F2C-8E4B-51BEA2C9D8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905562" y="84320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77" name="Oval 274">
              <a:extLst>
                <a:ext uri="{FF2B5EF4-FFF2-40B4-BE49-F238E27FC236}">
                  <a16:creationId xmlns:a16="http://schemas.microsoft.com/office/drawing/2014/main" id="{1960643E-E9E5-42EF-80FA-31FD28A633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29600" y="87622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82" name="Oval 277">
              <a:extLst>
                <a:ext uri="{FF2B5EF4-FFF2-40B4-BE49-F238E27FC236}">
                  <a16:creationId xmlns:a16="http://schemas.microsoft.com/office/drawing/2014/main" id="{6F04E1A3-4080-41BA-B2EE-4377AC58F6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154675" y="811770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85" name="Oval 278">
              <a:extLst>
                <a:ext uri="{FF2B5EF4-FFF2-40B4-BE49-F238E27FC236}">
                  <a16:creationId xmlns:a16="http://schemas.microsoft.com/office/drawing/2014/main" id="{C10343D0-8230-4261-B6F2-61F1B31CD8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010337" y="84320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01" name="Oval 281">
              <a:extLst>
                <a:ext uri="{FF2B5EF4-FFF2-40B4-BE49-F238E27FC236}">
                  <a16:creationId xmlns:a16="http://schemas.microsoft.com/office/drawing/2014/main" id="{77CAAD48-5535-4DE1-B45F-8D68E16FAF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805175" y="642066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09" name="Oval 283">
              <a:extLst>
                <a:ext uri="{FF2B5EF4-FFF2-40B4-BE49-F238E27FC236}">
                  <a16:creationId xmlns:a16="http://schemas.microsoft.com/office/drawing/2014/main" id="{C1D783DE-F6F5-4CBC-BF30-C5BE23C438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338575" y="672387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18" name="Oval 284">
              <a:extLst>
                <a:ext uri="{FF2B5EF4-FFF2-40B4-BE49-F238E27FC236}">
                  <a16:creationId xmlns:a16="http://schemas.microsoft.com/office/drawing/2014/main" id="{01F5E614-FECE-4F5C-8451-0CBF549AF2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17075" y="913211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25" name="Oval 288">
              <a:extLst>
                <a:ext uri="{FF2B5EF4-FFF2-40B4-BE49-F238E27FC236}">
                  <a16:creationId xmlns:a16="http://schemas.microsoft.com/office/drawing/2014/main" id="{C6BA3328-4CD1-4CC3-BA06-6F90C22617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49775" y="742237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27" name="Oval 289">
              <a:extLst>
                <a:ext uri="{FF2B5EF4-FFF2-40B4-BE49-F238E27FC236}">
                  <a16:creationId xmlns:a16="http://schemas.microsoft.com/office/drawing/2014/main" id="{5AAD6CCC-7000-4C41-BC2D-BEA32293C7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43512" y="794783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28" name="Oval 290">
              <a:extLst>
                <a:ext uri="{FF2B5EF4-FFF2-40B4-BE49-F238E27FC236}">
                  <a16:creationId xmlns:a16="http://schemas.microsoft.com/office/drawing/2014/main" id="{60A7D932-7CAB-457C-831F-EB9A6CD127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894325" y="801610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29" name="Oval 291">
              <a:extLst>
                <a:ext uri="{FF2B5EF4-FFF2-40B4-BE49-F238E27FC236}">
                  <a16:creationId xmlns:a16="http://schemas.microsoft.com/office/drawing/2014/main" id="{254385BC-D4A6-4865-99D3-E37C0217EC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80012" y="79240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30" name="Oval 292">
              <a:extLst>
                <a:ext uri="{FF2B5EF4-FFF2-40B4-BE49-F238E27FC236}">
                  <a16:creationId xmlns:a16="http://schemas.microsoft.com/office/drawing/2014/main" id="{54C66F25-EFE2-448B-B58B-D8B4A71B7F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87950" y="79240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31" name="Oval 293">
              <a:extLst>
                <a:ext uri="{FF2B5EF4-FFF2-40B4-BE49-F238E27FC236}">
                  <a16:creationId xmlns:a16="http://schemas.microsoft.com/office/drawing/2014/main" id="{C597DF30-07B7-417F-A82D-F1E495B46A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06987" y="781925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52" name="Oval 296">
              <a:extLst>
                <a:ext uri="{FF2B5EF4-FFF2-40B4-BE49-F238E27FC236}">
                  <a16:creationId xmlns:a16="http://schemas.microsoft.com/office/drawing/2014/main" id="{1A5891CC-2E15-4A19-A675-5010A5709E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324412" y="75938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54" name="Oval 298">
              <a:extLst>
                <a:ext uri="{FF2B5EF4-FFF2-40B4-BE49-F238E27FC236}">
                  <a16:creationId xmlns:a16="http://schemas.microsoft.com/office/drawing/2014/main" id="{DA12417E-1941-45D9-98DC-8D18EB7E0C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14850" y="738745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55" name="Oval 299">
              <a:extLst>
                <a:ext uri="{FF2B5EF4-FFF2-40B4-BE49-F238E27FC236}">
                  <a16:creationId xmlns:a16="http://schemas.microsoft.com/office/drawing/2014/main" id="{D5BC0903-905B-4E0D-93B3-37CB7ECA53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42000" y="811770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56" name="Oval 300">
              <a:extLst>
                <a:ext uri="{FF2B5EF4-FFF2-40B4-BE49-F238E27FC236}">
                  <a16:creationId xmlns:a16="http://schemas.microsoft.com/office/drawing/2014/main" id="{831030D0-332F-45A6-B791-AC88F2DED1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94275" y="775575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57" name="Oval 301">
              <a:extLst>
                <a:ext uri="{FF2B5EF4-FFF2-40B4-BE49-F238E27FC236}">
                  <a16:creationId xmlns:a16="http://schemas.microsoft.com/office/drawing/2014/main" id="{0C6CEB97-325C-41EF-983F-4F2AB16544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537137" y="777638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59" name="Oval 303">
              <a:extLst>
                <a:ext uri="{FF2B5EF4-FFF2-40B4-BE49-F238E27FC236}">
                  <a16:creationId xmlns:a16="http://schemas.microsoft.com/office/drawing/2014/main" id="{598FC756-0977-4C7C-99C3-217E1FE4C5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957825" y="806531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60" name="Oval 304">
              <a:extLst>
                <a:ext uri="{FF2B5EF4-FFF2-40B4-BE49-F238E27FC236}">
                  <a16:creationId xmlns:a16="http://schemas.microsoft.com/office/drawing/2014/main" id="{1283C691-1528-4DF0-8E80-0A2967DED2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54587" y="77335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62" name="Oval 306">
              <a:extLst>
                <a:ext uri="{FF2B5EF4-FFF2-40B4-BE49-F238E27FC236}">
                  <a16:creationId xmlns:a16="http://schemas.microsoft.com/office/drawing/2014/main" id="{5587C5B1-11F0-436D-B05C-717BD2261F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275200" y="757477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63" name="Oval 307">
              <a:extLst>
                <a:ext uri="{FF2B5EF4-FFF2-40B4-BE49-F238E27FC236}">
                  <a16:creationId xmlns:a16="http://schemas.microsoft.com/office/drawing/2014/main" id="{58FC37F6-10A6-4BA8-837B-4DB9256183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906900" y="723663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68" name="Oval 312">
              <a:extLst>
                <a:ext uri="{FF2B5EF4-FFF2-40B4-BE49-F238E27FC236}">
                  <a16:creationId xmlns:a16="http://schemas.microsoft.com/office/drawing/2014/main" id="{F95D3E90-FAB3-4080-AD05-73A17A2E4F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832412" y="797006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69" name="Oval 313">
              <a:extLst>
                <a:ext uri="{FF2B5EF4-FFF2-40B4-BE49-F238E27FC236}">
                  <a16:creationId xmlns:a16="http://schemas.microsoft.com/office/drawing/2014/main" id="{531EDD0F-1C5D-4882-B49E-8EA241C304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33950" y="771288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70" name="Oval 314">
              <a:extLst>
                <a:ext uri="{FF2B5EF4-FFF2-40B4-BE49-F238E27FC236}">
                  <a16:creationId xmlns:a16="http://schemas.microsoft.com/office/drawing/2014/main" id="{4945266C-E0F8-40E8-8FFC-CB20897F5D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245037" y="755413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71" name="Oval 315">
              <a:extLst>
                <a:ext uri="{FF2B5EF4-FFF2-40B4-BE49-F238E27FC236}">
                  <a16:creationId xmlns:a16="http://schemas.microsoft.com/office/drawing/2014/main" id="{4A947511-0B27-4C4D-9E4B-53B0336F5B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17075" y="913211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72" name="Oval 316">
              <a:extLst>
                <a:ext uri="{FF2B5EF4-FFF2-40B4-BE49-F238E27FC236}">
                  <a16:creationId xmlns:a16="http://schemas.microsoft.com/office/drawing/2014/main" id="{EF5E206F-DA12-4205-86A4-3EC740DF6B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972112" y="806531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73" name="Oval 317">
              <a:extLst>
                <a:ext uri="{FF2B5EF4-FFF2-40B4-BE49-F238E27FC236}">
                  <a16:creationId xmlns:a16="http://schemas.microsoft.com/office/drawing/2014/main" id="{BBD69B58-CDF8-4E49-AFD2-B7E23DBAE3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913250" y="725410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74" name="Oval 318">
              <a:extLst>
                <a:ext uri="{FF2B5EF4-FFF2-40B4-BE49-F238E27FC236}">
                  <a16:creationId xmlns:a16="http://schemas.microsoft.com/office/drawing/2014/main" id="{51F96804-8732-4574-87E4-6F7DA8DA6F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84787" y="797006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76" name="Oval 320">
              <a:extLst>
                <a:ext uri="{FF2B5EF4-FFF2-40B4-BE49-F238E27FC236}">
                  <a16:creationId xmlns:a16="http://schemas.microsoft.com/office/drawing/2014/main" id="{6BD9867F-B2C5-4D0D-B892-21FE861C9A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81650" y="811770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77" name="Oval 321">
              <a:extLst>
                <a:ext uri="{FF2B5EF4-FFF2-40B4-BE49-F238E27FC236}">
                  <a16:creationId xmlns:a16="http://schemas.microsoft.com/office/drawing/2014/main" id="{5D576514-5F10-4B1A-BD6C-7BC26470B7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521262" y="777638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1" name="Oval 325">
              <a:extLst>
                <a:ext uri="{FF2B5EF4-FFF2-40B4-BE49-F238E27FC236}">
                  <a16:creationId xmlns:a16="http://schemas.microsoft.com/office/drawing/2014/main" id="{FBCFF09C-F89C-4854-B071-C9F661A28F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148200" y="749698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3" name="Oval 327">
              <a:extLst>
                <a:ext uri="{FF2B5EF4-FFF2-40B4-BE49-F238E27FC236}">
                  <a16:creationId xmlns:a16="http://schemas.microsoft.com/office/drawing/2014/main" id="{CD62AF62-6741-4413-82EA-8AB9ABB4DD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360800" y="67556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4" name="Oval 328">
              <a:extLst>
                <a:ext uri="{FF2B5EF4-FFF2-40B4-BE49-F238E27FC236}">
                  <a16:creationId xmlns:a16="http://schemas.microsoft.com/office/drawing/2014/main" id="{B9899AE4-F467-454D-ADD0-F5E0D59020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17075" y="913211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5" name="Oval 329">
              <a:extLst>
                <a:ext uri="{FF2B5EF4-FFF2-40B4-BE49-F238E27FC236}">
                  <a16:creationId xmlns:a16="http://schemas.microsoft.com/office/drawing/2014/main" id="{A5BDFB83-E1BE-4F82-8642-A49CC31E56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17075" y="913211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6" name="Oval 330">
              <a:extLst>
                <a:ext uri="{FF2B5EF4-FFF2-40B4-BE49-F238E27FC236}">
                  <a16:creationId xmlns:a16="http://schemas.microsoft.com/office/drawing/2014/main" id="{343D6742-8187-4BC5-B306-DBDDB0F09F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82050" y="87622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7" name="Oval 331">
              <a:extLst>
                <a:ext uri="{FF2B5EF4-FFF2-40B4-BE49-F238E27FC236}">
                  <a16:creationId xmlns:a16="http://schemas.microsoft.com/office/drawing/2014/main" id="{211C4FE8-51CB-4B84-9DA4-70FB85F12D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961125" y="84320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9" name="Oval 333">
              <a:extLst>
                <a:ext uri="{FF2B5EF4-FFF2-40B4-BE49-F238E27FC236}">
                  <a16:creationId xmlns:a16="http://schemas.microsoft.com/office/drawing/2014/main" id="{D5189BFC-C9A0-428D-A041-02854D8707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857562" y="644923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0" name="Oval 334">
              <a:extLst>
                <a:ext uri="{FF2B5EF4-FFF2-40B4-BE49-F238E27FC236}">
                  <a16:creationId xmlns:a16="http://schemas.microsoft.com/office/drawing/2014/main" id="{162A327D-F2EB-4B86-8B6E-F9DB7D4135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07075" y="811770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1" name="Oval 335">
              <a:extLst>
                <a:ext uri="{FF2B5EF4-FFF2-40B4-BE49-F238E27FC236}">
                  <a16:creationId xmlns:a16="http://schemas.microsoft.com/office/drawing/2014/main" id="{5B84F269-4BD6-400F-AF6B-7A03066D11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796025" y="84320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2" name="Oval 336">
              <a:extLst>
                <a:ext uri="{FF2B5EF4-FFF2-40B4-BE49-F238E27FC236}">
                  <a16:creationId xmlns:a16="http://schemas.microsoft.com/office/drawing/2014/main" id="{A22DC9D1-08B7-4DBF-B285-EDCC3C5F3E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84825" y="811770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3" name="Oval 337">
              <a:extLst>
                <a:ext uri="{FF2B5EF4-FFF2-40B4-BE49-F238E27FC236}">
                  <a16:creationId xmlns:a16="http://schemas.microsoft.com/office/drawing/2014/main" id="{4E7BEFCF-3A13-4FF2-AFDB-80B17C1FB6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137212" y="811770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4" name="Oval 338">
              <a:extLst>
                <a:ext uri="{FF2B5EF4-FFF2-40B4-BE49-F238E27FC236}">
                  <a16:creationId xmlns:a16="http://schemas.microsoft.com/office/drawing/2014/main" id="{39EAAA24-CE2D-4735-B70A-3E6BAF35DB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951475" y="806531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5" name="Oval 339">
              <a:extLst>
                <a:ext uri="{FF2B5EF4-FFF2-40B4-BE49-F238E27FC236}">
                  <a16:creationId xmlns:a16="http://schemas.microsoft.com/office/drawing/2014/main" id="{06BDEC59-B9BD-4FD1-A31E-B42FC2CBD1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295962" y="811770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6" name="Oval 340">
              <a:extLst>
                <a:ext uri="{FF2B5EF4-FFF2-40B4-BE49-F238E27FC236}">
                  <a16:creationId xmlns:a16="http://schemas.microsoft.com/office/drawing/2014/main" id="{184200EE-06D5-47D1-B2D3-AE0F42936F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294125" y="669371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7" name="Oval 341">
              <a:extLst>
                <a:ext uri="{FF2B5EF4-FFF2-40B4-BE49-F238E27FC236}">
                  <a16:creationId xmlns:a16="http://schemas.microsoft.com/office/drawing/2014/main" id="{0BC741FF-CE8A-4973-8755-3416180588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122925" y="811770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8" name="Oval 342">
              <a:extLst>
                <a:ext uri="{FF2B5EF4-FFF2-40B4-BE49-F238E27FC236}">
                  <a16:creationId xmlns:a16="http://schemas.microsoft.com/office/drawing/2014/main" id="{A90D6865-1767-43BE-86EC-F1AE561E65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284850" y="811770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9" name="Oval 343">
              <a:extLst>
                <a:ext uri="{FF2B5EF4-FFF2-40B4-BE49-F238E27FC236}">
                  <a16:creationId xmlns:a16="http://schemas.microsoft.com/office/drawing/2014/main" id="{C21E8DB8-86D8-4DE7-AACD-0C1EF9B66F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043300" y="650956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0" name="Oval 344">
              <a:extLst>
                <a:ext uri="{FF2B5EF4-FFF2-40B4-BE49-F238E27FC236}">
                  <a16:creationId xmlns:a16="http://schemas.microsoft.com/office/drawing/2014/main" id="{0338C7A0-2C5A-4EB9-969B-EF2F553F53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130862" y="811770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1" name="Oval 345">
              <a:extLst>
                <a:ext uri="{FF2B5EF4-FFF2-40B4-BE49-F238E27FC236}">
                  <a16:creationId xmlns:a16="http://schemas.microsoft.com/office/drawing/2014/main" id="{4F5991BC-2709-4D25-ADE8-F2D56EEC8C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983225" y="806531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2" name="Oval 346">
              <a:extLst>
                <a:ext uri="{FF2B5EF4-FFF2-40B4-BE49-F238E27FC236}">
                  <a16:creationId xmlns:a16="http://schemas.microsoft.com/office/drawing/2014/main" id="{892069D7-DC80-4554-9CA2-F139BD03A2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905562" y="84320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3" name="Oval 347">
              <a:extLst>
                <a:ext uri="{FF2B5EF4-FFF2-40B4-BE49-F238E27FC236}">
                  <a16:creationId xmlns:a16="http://schemas.microsoft.com/office/drawing/2014/main" id="{EE4F25FD-ED4C-4827-9A96-9374896B79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656075" y="699375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5" name="Oval 349">
              <a:extLst>
                <a:ext uri="{FF2B5EF4-FFF2-40B4-BE49-F238E27FC236}">
                  <a16:creationId xmlns:a16="http://schemas.microsoft.com/office/drawing/2014/main" id="{51245597-BB6A-4A7A-A889-A52E5674BC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392550" y="678578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6" name="Oval 350">
              <a:extLst>
                <a:ext uri="{FF2B5EF4-FFF2-40B4-BE49-F238E27FC236}">
                  <a16:creationId xmlns:a16="http://schemas.microsoft.com/office/drawing/2014/main" id="{C2953FC2-C6E1-4776-BEFD-7D6D1126B2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398900" y="678578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7" name="Oval 351">
              <a:extLst>
                <a:ext uri="{FF2B5EF4-FFF2-40B4-BE49-F238E27FC236}">
                  <a16:creationId xmlns:a16="http://schemas.microsoft.com/office/drawing/2014/main" id="{0CE442D7-5FF6-40E0-A225-6173F0D3F8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862575" y="799228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8" name="Oval 352">
              <a:extLst>
                <a:ext uri="{FF2B5EF4-FFF2-40B4-BE49-F238E27FC236}">
                  <a16:creationId xmlns:a16="http://schemas.microsoft.com/office/drawing/2014/main" id="{1BC4BBC6-762B-4F6E-9DBD-61588207EF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81525" y="742237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9" name="Oval 353">
              <a:extLst>
                <a:ext uri="{FF2B5EF4-FFF2-40B4-BE49-F238E27FC236}">
                  <a16:creationId xmlns:a16="http://schemas.microsoft.com/office/drawing/2014/main" id="{F46C6187-494B-4ECC-851C-A0439E094B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246750" y="811770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0" name="Oval 354">
              <a:extLst>
                <a:ext uri="{FF2B5EF4-FFF2-40B4-BE49-F238E27FC236}">
                  <a16:creationId xmlns:a16="http://schemas.microsoft.com/office/drawing/2014/main" id="{AD2FE08B-7089-4D09-8144-BAD1F5BA56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243575" y="811770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1" name="Oval 355">
              <a:extLst>
                <a:ext uri="{FF2B5EF4-FFF2-40B4-BE49-F238E27FC236}">
                  <a16:creationId xmlns:a16="http://schemas.microsoft.com/office/drawing/2014/main" id="{9F9CD3F5-2274-47C0-BB89-BBCAF483CC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961000" y="806531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3" name="Oval 357">
              <a:extLst>
                <a:ext uri="{FF2B5EF4-FFF2-40B4-BE49-F238E27FC236}">
                  <a16:creationId xmlns:a16="http://schemas.microsoft.com/office/drawing/2014/main" id="{5D5E07E5-2133-4647-B2B5-234A5E6522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86600" y="85336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5" name="Oval 359">
              <a:extLst>
                <a:ext uri="{FF2B5EF4-FFF2-40B4-BE49-F238E27FC236}">
                  <a16:creationId xmlns:a16="http://schemas.microsoft.com/office/drawing/2014/main" id="{111AA424-B80F-4991-813E-9141FC8FC7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07000" y="794783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7" name="Oval 361">
              <a:extLst>
                <a:ext uri="{FF2B5EF4-FFF2-40B4-BE49-F238E27FC236}">
                  <a16:creationId xmlns:a16="http://schemas.microsoft.com/office/drawing/2014/main" id="{240B6720-ABD9-43C8-8A30-081DE7C141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62550" y="788116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9" name="Oval 363">
              <a:extLst>
                <a:ext uri="{FF2B5EF4-FFF2-40B4-BE49-F238E27FC236}">
                  <a16:creationId xmlns:a16="http://schemas.microsoft.com/office/drawing/2014/main" id="{A413EE14-18CC-4937-A7D0-22866B0E5B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84787" y="797006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0" name="Oval 364">
              <a:extLst>
                <a:ext uri="{FF2B5EF4-FFF2-40B4-BE49-F238E27FC236}">
                  <a16:creationId xmlns:a16="http://schemas.microsoft.com/office/drawing/2014/main" id="{80B5940B-E6F0-4E72-A4C2-037D880B04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392550" y="678578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1" name="Oval 365">
              <a:extLst>
                <a:ext uri="{FF2B5EF4-FFF2-40B4-BE49-F238E27FC236}">
                  <a16:creationId xmlns:a16="http://schemas.microsoft.com/office/drawing/2014/main" id="{DB5DC1A0-4E84-411F-953F-BF9098A230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832287" y="718901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2" name="Oval 366">
              <a:extLst>
                <a:ext uri="{FF2B5EF4-FFF2-40B4-BE49-F238E27FC236}">
                  <a16:creationId xmlns:a16="http://schemas.microsoft.com/office/drawing/2014/main" id="{AA4D846F-DBCF-4EA9-A4A1-93C7ACC079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948175" y="732077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3" name="Oval 367">
              <a:extLst>
                <a:ext uri="{FF2B5EF4-FFF2-40B4-BE49-F238E27FC236}">
                  <a16:creationId xmlns:a16="http://schemas.microsoft.com/office/drawing/2014/main" id="{94C53EF6-C097-4365-9084-470B7CD010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141850" y="749698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4" name="Oval 368">
              <a:extLst>
                <a:ext uri="{FF2B5EF4-FFF2-40B4-BE49-F238E27FC236}">
                  <a16:creationId xmlns:a16="http://schemas.microsoft.com/office/drawing/2014/main" id="{25AE91C0-CEA2-4C06-B8A3-D3CCF0E228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17075" y="913211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5" name="Oval 369">
              <a:extLst>
                <a:ext uri="{FF2B5EF4-FFF2-40B4-BE49-F238E27FC236}">
                  <a16:creationId xmlns:a16="http://schemas.microsoft.com/office/drawing/2014/main" id="{C73B62C8-7D62-4896-A245-226FA05F48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851462" y="799228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6" name="Oval 370">
              <a:extLst>
                <a:ext uri="{FF2B5EF4-FFF2-40B4-BE49-F238E27FC236}">
                  <a16:creationId xmlns:a16="http://schemas.microsoft.com/office/drawing/2014/main" id="{BF3DD285-B406-4164-9DB3-108970DA86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24712" y="85336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7" name="Oval 371">
              <a:extLst>
                <a:ext uri="{FF2B5EF4-FFF2-40B4-BE49-F238E27FC236}">
                  <a16:creationId xmlns:a16="http://schemas.microsoft.com/office/drawing/2014/main" id="{623C30E2-90F9-4124-9F97-38686EBC1A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50100" y="85336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9" name="Oval 373">
              <a:extLst>
                <a:ext uri="{FF2B5EF4-FFF2-40B4-BE49-F238E27FC236}">
                  <a16:creationId xmlns:a16="http://schemas.microsoft.com/office/drawing/2014/main" id="{75473FD4-F7DD-4080-B3B8-CB1F288B66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807012" y="797006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1" name="Oval 375">
              <a:extLst>
                <a:ext uri="{FF2B5EF4-FFF2-40B4-BE49-F238E27FC236}">
                  <a16:creationId xmlns:a16="http://schemas.microsoft.com/office/drawing/2014/main" id="{C8BE168C-5820-4C3E-979B-6EBE1A8800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581962" y="867015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3" name="Oval 377">
              <a:extLst>
                <a:ext uri="{FF2B5EF4-FFF2-40B4-BE49-F238E27FC236}">
                  <a16:creationId xmlns:a16="http://schemas.microsoft.com/office/drawing/2014/main" id="{C8824FFF-4762-4E5D-88C4-A73CABE355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17075" y="913211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8" name="Oval 382">
              <a:extLst>
                <a:ext uri="{FF2B5EF4-FFF2-40B4-BE49-F238E27FC236}">
                  <a16:creationId xmlns:a16="http://schemas.microsoft.com/office/drawing/2014/main" id="{254A74FC-DE12-4A9D-9E76-E7C897D475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17075" y="913211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0" name="Oval 384">
              <a:extLst>
                <a:ext uri="{FF2B5EF4-FFF2-40B4-BE49-F238E27FC236}">
                  <a16:creationId xmlns:a16="http://schemas.microsoft.com/office/drawing/2014/main" id="{8EA29342-CE4A-4B2F-9496-2AC10C4F7B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45387" y="859395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1" name="Oval 385">
              <a:extLst>
                <a:ext uri="{FF2B5EF4-FFF2-40B4-BE49-F238E27FC236}">
                  <a16:creationId xmlns:a16="http://schemas.microsoft.com/office/drawing/2014/main" id="{6F2CA34E-BA5F-4FB7-9186-ABE513A63B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17075" y="913211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2" name="Oval 386">
              <a:extLst>
                <a:ext uri="{FF2B5EF4-FFF2-40B4-BE49-F238E27FC236}">
                  <a16:creationId xmlns:a16="http://schemas.microsoft.com/office/drawing/2014/main" id="{4996F942-E410-4DE5-A90D-18C030FF43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17075" y="913211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3" name="Oval 387">
              <a:extLst>
                <a:ext uri="{FF2B5EF4-FFF2-40B4-BE49-F238E27FC236}">
                  <a16:creationId xmlns:a16="http://schemas.microsoft.com/office/drawing/2014/main" id="{D2A50AD7-2D34-4A58-AA0B-B2E90AF41C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17075" y="913211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6" name="Oval 390">
              <a:extLst>
                <a:ext uri="{FF2B5EF4-FFF2-40B4-BE49-F238E27FC236}">
                  <a16:creationId xmlns:a16="http://schemas.microsoft.com/office/drawing/2014/main" id="{FCF6C824-A0F8-41A1-AA30-96DD63C310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05637" y="847965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8" name="Oval 392">
              <a:extLst>
                <a:ext uri="{FF2B5EF4-FFF2-40B4-BE49-F238E27FC236}">
                  <a16:creationId xmlns:a16="http://schemas.microsoft.com/office/drawing/2014/main" id="{D8EE8632-2868-4690-ADFE-653F2C5071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32400" y="794783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6" name="Oval 393">
              <a:extLst>
                <a:ext uri="{FF2B5EF4-FFF2-40B4-BE49-F238E27FC236}">
                  <a16:creationId xmlns:a16="http://schemas.microsoft.com/office/drawing/2014/main" id="{CEB22FBC-03C1-4F5A-A7AF-B93E5D00D2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314762" y="670958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7" name="Oval 394">
              <a:extLst>
                <a:ext uri="{FF2B5EF4-FFF2-40B4-BE49-F238E27FC236}">
                  <a16:creationId xmlns:a16="http://schemas.microsoft.com/office/drawing/2014/main" id="{3C617CF6-2CAE-4D88-A3A0-76240B6B6F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16925" y="87622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1" name="Oval 398">
              <a:extLst>
                <a:ext uri="{FF2B5EF4-FFF2-40B4-BE49-F238E27FC236}">
                  <a16:creationId xmlns:a16="http://schemas.microsoft.com/office/drawing/2014/main" id="{27765564-F69E-41BD-B9F6-4B4306BCBE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335900" y="867015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0" name="Oval 400">
              <a:extLst>
                <a:ext uri="{FF2B5EF4-FFF2-40B4-BE49-F238E27FC236}">
                  <a16:creationId xmlns:a16="http://schemas.microsoft.com/office/drawing/2014/main" id="{44C9FE59-BD8B-4FCF-A227-B6AC4AC5A3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77100" y="859395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4" name="Oval 401">
              <a:extLst>
                <a:ext uri="{FF2B5EF4-FFF2-40B4-BE49-F238E27FC236}">
                  <a16:creationId xmlns:a16="http://schemas.microsoft.com/office/drawing/2014/main" id="{96C77F8A-AADE-44DE-A2E1-7D3E3D6E45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78675" y="85336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7" name="Oval 402">
              <a:extLst>
                <a:ext uri="{FF2B5EF4-FFF2-40B4-BE49-F238E27FC236}">
                  <a16:creationId xmlns:a16="http://schemas.microsoft.com/office/drawing/2014/main" id="{5AF98B48-8C99-4BC9-8550-41B0AD5A27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010337" y="84320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17" name="Oval 411">
              <a:extLst>
                <a:ext uri="{FF2B5EF4-FFF2-40B4-BE49-F238E27FC236}">
                  <a16:creationId xmlns:a16="http://schemas.microsoft.com/office/drawing/2014/main" id="{26098D54-06E0-40F9-9A23-093ACBC840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17075" y="913211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18" name="Oval 412">
              <a:extLst>
                <a:ext uri="{FF2B5EF4-FFF2-40B4-BE49-F238E27FC236}">
                  <a16:creationId xmlns:a16="http://schemas.microsoft.com/office/drawing/2014/main" id="{67F36345-8F11-45F0-B030-D8D5ECA9F0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18387" y="859395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0" name="Oval 414">
              <a:extLst>
                <a:ext uri="{FF2B5EF4-FFF2-40B4-BE49-F238E27FC236}">
                  <a16:creationId xmlns:a16="http://schemas.microsoft.com/office/drawing/2014/main" id="{9E98EBE0-9FA0-408C-9A73-D39737ED2D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32437" y="809071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5" name="Oval 418">
              <a:extLst>
                <a:ext uri="{FF2B5EF4-FFF2-40B4-BE49-F238E27FC236}">
                  <a16:creationId xmlns:a16="http://schemas.microsoft.com/office/drawing/2014/main" id="{87B93026-8B20-4A1C-8721-971D3B4638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258112" y="867015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6" name="Oval 419">
              <a:extLst>
                <a:ext uri="{FF2B5EF4-FFF2-40B4-BE49-F238E27FC236}">
                  <a16:creationId xmlns:a16="http://schemas.microsoft.com/office/drawing/2014/main" id="{5517AF38-F098-4B57-8C72-E122AACFA1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17075" y="9132112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34" name="Oval 427">
              <a:extLst>
                <a:ext uri="{FF2B5EF4-FFF2-40B4-BE49-F238E27FC236}">
                  <a16:creationId xmlns:a16="http://schemas.microsoft.com/office/drawing/2014/main" id="{4E611097-7883-4C67-B771-1F909212BA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576950" y="83304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36" name="Oval 429">
              <a:extLst>
                <a:ext uri="{FF2B5EF4-FFF2-40B4-BE49-F238E27FC236}">
                  <a16:creationId xmlns:a16="http://schemas.microsoft.com/office/drawing/2014/main" id="{54A3EF8A-DAA9-450A-AEA3-C8918AF631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735700" y="836217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37" name="Oval 430">
              <a:extLst>
                <a:ext uri="{FF2B5EF4-FFF2-40B4-BE49-F238E27FC236}">
                  <a16:creationId xmlns:a16="http://schemas.microsoft.com/office/drawing/2014/main" id="{971D706F-602A-465C-9180-6ACAC8FEE5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862825" y="8593950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38" name="Oval 431">
              <a:extLst>
                <a:ext uri="{FF2B5EF4-FFF2-40B4-BE49-F238E27FC236}">
                  <a16:creationId xmlns:a16="http://schemas.microsoft.com/office/drawing/2014/main" id="{1261057F-DBFC-4AAD-93E8-95C7BAC1E1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88425" y="876222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88" name="Oval 433">
              <a:extLst>
                <a:ext uri="{FF2B5EF4-FFF2-40B4-BE49-F238E27FC236}">
                  <a16:creationId xmlns:a16="http://schemas.microsoft.com/office/drawing/2014/main" id="{17A67C4E-B14C-44EE-9126-8D9DAF9D35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45212" y="8362175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90" name="Oval 435">
              <a:extLst>
                <a:ext uri="{FF2B5EF4-FFF2-40B4-BE49-F238E27FC236}">
                  <a16:creationId xmlns:a16="http://schemas.microsoft.com/office/drawing/2014/main" id="{4BEC978E-AC17-40B5-AC75-BBF6902FCF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543487" y="7776387"/>
              <a:ext cx="0" cy="72000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92" name="Rectangle 437">
              <a:extLst>
                <a:ext uri="{FF2B5EF4-FFF2-40B4-BE49-F238E27FC236}">
                  <a16:creationId xmlns:a16="http://schemas.microsoft.com/office/drawing/2014/main" id="{606D51D6-0201-4D71-8CC3-EE45B7E9C0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15086" y="6391311"/>
              <a:ext cx="6421438" cy="4338670"/>
            </a:xfrm>
            <a:custGeom>
              <a:avLst/>
              <a:gdLst>
                <a:gd name="connsiteX0" fmla="*/ 0 w 6421438"/>
                <a:gd name="connsiteY0" fmla="*/ 0 h 4335463"/>
                <a:gd name="connsiteX1" fmla="*/ 6421438 w 6421438"/>
                <a:gd name="connsiteY1" fmla="*/ 0 h 4335463"/>
                <a:gd name="connsiteX2" fmla="*/ 6421438 w 6421438"/>
                <a:gd name="connsiteY2" fmla="*/ 4335463 h 4335463"/>
                <a:gd name="connsiteX3" fmla="*/ 0 w 6421438"/>
                <a:gd name="connsiteY3" fmla="*/ 4335463 h 4335463"/>
                <a:gd name="connsiteX4" fmla="*/ 0 w 6421438"/>
                <a:gd name="connsiteY4" fmla="*/ 0 h 4335463"/>
                <a:gd name="connsiteX0" fmla="*/ 0 w 6421438"/>
                <a:gd name="connsiteY0" fmla="*/ 0 h 4338670"/>
                <a:gd name="connsiteX1" fmla="*/ 1720 w 6421438"/>
                <a:gd name="connsiteY1" fmla="*/ 4338670 h 4338670"/>
                <a:gd name="connsiteX2" fmla="*/ 6421438 w 6421438"/>
                <a:gd name="connsiteY2" fmla="*/ 4335463 h 4338670"/>
                <a:gd name="connsiteX3" fmla="*/ 0 w 6421438"/>
                <a:gd name="connsiteY3" fmla="*/ 4335463 h 4338670"/>
                <a:gd name="connsiteX4" fmla="*/ 0 w 6421438"/>
                <a:gd name="connsiteY4" fmla="*/ 0 h 43386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6421438" h="4338670">
                  <a:moveTo>
                    <a:pt x="0" y="0"/>
                  </a:moveTo>
                  <a:cubicBezTo>
                    <a:pt x="573" y="1446223"/>
                    <a:pt x="1147" y="2892447"/>
                    <a:pt x="1720" y="4338670"/>
                  </a:cubicBezTo>
                  <a:lnTo>
                    <a:pt x="6421438" y="4335463"/>
                  </a:lnTo>
                  <a:lnTo>
                    <a:pt x="0" y="4335463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9050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99" name="Line 444">
              <a:extLst>
                <a:ext uri="{FF2B5EF4-FFF2-40B4-BE49-F238E27FC236}">
                  <a16:creationId xmlns:a16="http://schemas.microsoft.com/office/drawing/2014/main" id="{BD6192B2-A823-46E9-B12B-0A5561ED02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715086" y="10726772"/>
              <a:ext cx="0" cy="107950"/>
            </a:xfrm>
            <a:prstGeom prst="line">
              <a:avLst/>
            </a:prstGeom>
            <a:noFill/>
            <a:ln w="19050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06" name="Rectangle 451">
              <a:extLst>
                <a:ext uri="{FF2B5EF4-FFF2-40B4-BE49-F238E27FC236}">
                  <a16:creationId xmlns:a16="http://schemas.microsoft.com/office/drawing/2014/main" id="{9FCB8FEC-3BF3-4EEE-A4A3-4007EBDECA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631036" y="10828416"/>
              <a:ext cx="12824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2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2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1" name="Line 126">
              <a:extLst>
                <a:ext uri="{FF2B5EF4-FFF2-40B4-BE49-F238E27FC236}">
                  <a16:creationId xmlns:a16="http://schemas.microsoft.com/office/drawing/2014/main" id="{0D711B90-1C60-40E5-9D77-592258A91EC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653173" y="8569625"/>
              <a:ext cx="53975" cy="0"/>
            </a:xfrm>
            <a:prstGeom prst="line">
              <a:avLst/>
            </a:prstGeom>
            <a:noFill/>
            <a:ln w="19050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2" name="Line 126">
              <a:extLst>
                <a:ext uri="{FF2B5EF4-FFF2-40B4-BE49-F238E27FC236}">
                  <a16:creationId xmlns:a16="http://schemas.microsoft.com/office/drawing/2014/main" id="{C895387D-0DFD-407B-A28F-F87D03C875B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670635" y="6845063"/>
              <a:ext cx="53975" cy="0"/>
            </a:xfrm>
            <a:prstGeom prst="line">
              <a:avLst/>
            </a:prstGeom>
            <a:noFill/>
            <a:ln w="19050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3" name="Line 126">
              <a:extLst>
                <a:ext uri="{FF2B5EF4-FFF2-40B4-BE49-F238E27FC236}">
                  <a16:creationId xmlns:a16="http://schemas.microsoft.com/office/drawing/2014/main" id="{97A5F59A-C2C0-41B8-99D3-4D8277A0747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651886" y="7691890"/>
              <a:ext cx="53975" cy="0"/>
            </a:xfrm>
            <a:prstGeom prst="line">
              <a:avLst/>
            </a:prstGeom>
            <a:noFill/>
            <a:ln w="19050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6" name="Rectangle 578">
              <a:extLst>
                <a:ext uri="{FF2B5EF4-FFF2-40B4-BE49-F238E27FC236}">
                  <a16:creationId xmlns:a16="http://schemas.microsoft.com/office/drawing/2014/main" id="{123FB386-DC69-4E2D-A1F7-9328B13540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927002" y="4719639"/>
              <a:ext cx="4738477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2800" b="1" i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RBB2</a:t>
              </a:r>
              <a:r>
                <a:rPr kumimoji="0" lang="en-US" altLang="ja-JP" sz="28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-negative </a:t>
              </a:r>
              <a:r>
                <a:rPr kumimoji="0" lang="en-US" altLang="ja-JP" sz="2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s (n=307)</a:t>
              </a:r>
              <a:endParaRPr kumimoji="0" lang="ja-JP" altLang="ja-JP" sz="2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2" name="Line 1570">
              <a:extLst>
                <a:ext uri="{FF2B5EF4-FFF2-40B4-BE49-F238E27FC236}">
                  <a16:creationId xmlns:a16="http://schemas.microsoft.com/office/drawing/2014/main" id="{F46C0A10-C108-4CB1-A495-36B87A2F325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958592" y="10730609"/>
              <a:ext cx="0" cy="107950"/>
            </a:xfrm>
            <a:prstGeom prst="line">
              <a:avLst/>
            </a:prstGeom>
            <a:noFill/>
            <a:ln w="17463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3" name="Line 1571">
              <a:extLst>
                <a:ext uri="{FF2B5EF4-FFF2-40B4-BE49-F238E27FC236}">
                  <a16:creationId xmlns:a16="http://schemas.microsoft.com/office/drawing/2014/main" id="{938545A1-92D1-4DE6-9968-FEE40D90D50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275990" y="10715284"/>
              <a:ext cx="0" cy="107950"/>
            </a:xfrm>
            <a:prstGeom prst="line">
              <a:avLst/>
            </a:prstGeom>
            <a:noFill/>
            <a:ln w="17463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4" name="Line 1572">
              <a:extLst>
                <a:ext uri="{FF2B5EF4-FFF2-40B4-BE49-F238E27FC236}">
                  <a16:creationId xmlns:a16="http://schemas.microsoft.com/office/drawing/2014/main" id="{202B9DBF-C955-48A0-BA7F-8AD0337DDD7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907383" y="10730886"/>
              <a:ext cx="0" cy="107950"/>
            </a:xfrm>
            <a:prstGeom prst="line">
              <a:avLst/>
            </a:prstGeom>
            <a:noFill/>
            <a:ln w="17463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5" name="Line 1573">
              <a:extLst>
                <a:ext uri="{FF2B5EF4-FFF2-40B4-BE49-F238E27FC236}">
                  <a16:creationId xmlns:a16="http://schemas.microsoft.com/office/drawing/2014/main" id="{E5C975F6-7A29-4C28-BD05-7E169D116D4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130607" y="10732937"/>
              <a:ext cx="0" cy="107950"/>
            </a:xfrm>
            <a:prstGeom prst="line">
              <a:avLst/>
            </a:prstGeom>
            <a:noFill/>
            <a:ln w="17463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6" name="Line 1571">
              <a:extLst>
                <a:ext uri="{FF2B5EF4-FFF2-40B4-BE49-F238E27FC236}">
                  <a16:creationId xmlns:a16="http://schemas.microsoft.com/office/drawing/2014/main" id="{B13F45B7-2FEB-45E0-A4DE-71A680A6928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545150" y="10733399"/>
              <a:ext cx="0" cy="107950"/>
            </a:xfrm>
            <a:prstGeom prst="line">
              <a:avLst/>
            </a:prstGeom>
            <a:noFill/>
            <a:ln w="17463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7" name="Rectangle 578">
              <a:extLst>
                <a:ext uri="{FF2B5EF4-FFF2-40B4-BE49-F238E27FC236}">
                  <a16:creationId xmlns:a16="http://schemas.microsoft.com/office/drawing/2014/main" id="{345085A7-D4E8-48EE-AA81-59DB7858DB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899830" y="10803245"/>
              <a:ext cx="12824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ja-JP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8" name="Rectangle 578">
              <a:extLst>
                <a:ext uri="{FF2B5EF4-FFF2-40B4-BE49-F238E27FC236}">
                  <a16:creationId xmlns:a16="http://schemas.microsoft.com/office/drawing/2014/main" id="{CBCA1ADE-DBF7-4A07-8FAF-BE1C747BE1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207057" y="10790294"/>
              <a:ext cx="12824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0" lang="ja-JP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9" name="Rectangle 578">
              <a:extLst>
                <a:ext uri="{FF2B5EF4-FFF2-40B4-BE49-F238E27FC236}">
                  <a16:creationId xmlns:a16="http://schemas.microsoft.com/office/drawing/2014/main" id="{865074BF-BB08-4E91-9157-B94C3964B9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68155" y="10800413"/>
              <a:ext cx="12824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3</a:t>
              </a:r>
              <a:endParaRPr kumimoji="0" lang="ja-JP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0" name="Rectangle 578">
              <a:extLst>
                <a:ext uri="{FF2B5EF4-FFF2-40B4-BE49-F238E27FC236}">
                  <a16:creationId xmlns:a16="http://schemas.microsoft.com/office/drawing/2014/main" id="{52983088-DABA-41D0-AC34-94D8F7CED0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17887" y="10790294"/>
              <a:ext cx="12824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2000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</a:t>
              </a:r>
              <a:endParaRPr kumimoji="0" lang="ja-JP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1" name="Rectangle 578">
              <a:extLst>
                <a:ext uri="{FF2B5EF4-FFF2-40B4-BE49-F238E27FC236}">
                  <a16:creationId xmlns:a16="http://schemas.microsoft.com/office/drawing/2014/main" id="{6F3812C5-2D81-4317-A510-F82D11ACDE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48303" y="10804236"/>
              <a:ext cx="12824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ja-JP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0" lang="ja-JP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95" name="Rectangle 578">
            <a:extLst>
              <a:ext uri="{FF2B5EF4-FFF2-40B4-BE49-F238E27FC236}">
                <a16:creationId xmlns:a16="http://schemas.microsoft.com/office/drawing/2014/main" id="{9BE8AEC2-A14A-A132-2D7F-B6655AA7DDA4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1052" y="10509580"/>
            <a:ext cx="19808286" cy="20997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l">
              <a:lnSpc>
                <a:spcPct val="200000"/>
              </a:lnSpc>
            </a:pPr>
            <a:r>
              <a:rPr lang="en-US" altLang="ja-JP" sz="24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Survival curves of TCGA patients in accordance to </a:t>
            </a:r>
            <a:r>
              <a:rPr lang="en-US" altLang="ja-JP" sz="2400" b="1" i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ERBB2</a:t>
            </a:r>
            <a:r>
              <a:rPr lang="en-US" altLang="ja-JP" sz="24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. </a:t>
            </a:r>
            <a:r>
              <a:rPr lang="en-US" altLang="ja-JP" sz="24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A:</a:t>
            </a:r>
            <a:r>
              <a:rPr lang="en-US" altLang="ja-JP" sz="24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The overall survival of the </a:t>
            </a:r>
            <a:r>
              <a:rPr lang="en-US" altLang="ja-JP" sz="2400" i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ERBB2</a:t>
            </a:r>
            <a:r>
              <a:rPr lang="en-US" altLang="ja-JP" sz="24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-positive gastric cancer patients (n=76) was not different between a </a:t>
            </a:r>
            <a:r>
              <a:rPr lang="en-US" altLang="ja-JP" sz="2400" i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SMAD2</a:t>
            </a:r>
            <a:r>
              <a:rPr lang="en-US" altLang="ja-JP" sz="24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-positive / </a:t>
            </a:r>
            <a:r>
              <a:rPr lang="en-US" altLang="ja-JP" sz="2400" i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MET</a:t>
            </a:r>
            <a:r>
              <a:rPr lang="en-US" altLang="ja-JP" sz="24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positive tumor (n=2) and the other tumor (n=74). B</a:t>
            </a:r>
            <a:r>
              <a:rPr lang="en-US" altLang="ja-JP" sz="24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:</a:t>
            </a:r>
            <a:r>
              <a:rPr lang="en-US" altLang="ja-JP" sz="24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There was no patients with a </a:t>
            </a:r>
            <a:r>
              <a:rPr lang="en-US" altLang="ja-JP" sz="2400" i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SMAD2</a:t>
            </a:r>
            <a:r>
              <a:rPr lang="en-US" altLang="ja-JP" sz="24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-positive and </a:t>
            </a:r>
            <a:r>
              <a:rPr lang="en-US" altLang="ja-JP" sz="2400" i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MET</a:t>
            </a:r>
            <a:r>
              <a:rPr lang="en-US" altLang="ja-JP" sz="24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positive tumor in </a:t>
            </a:r>
            <a:r>
              <a:rPr lang="en-US" altLang="ja-JP" sz="2400" i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ERBB2</a:t>
            </a:r>
            <a:r>
              <a:rPr lang="en-US" altLang="ja-JP" sz="24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-negative gastric cancer patients (n=307).</a:t>
            </a:r>
            <a:endParaRPr lang="ja-JP" altLang="ja-JP" sz="3200" kern="100" dirty="0">
              <a:effectLst/>
              <a:latin typeface="ＭＳ 明朝" panose="02020609040205080304" pitchFamily="17" charset="-128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99577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 rtlCol="0" anchor="ctr"/>
      <a:lstStyle>
        <a:defPPr algn="ctr">
          <a:defRPr kumimoji="1">
            <a:solidFill>
              <a:schemeClr val="tx1"/>
            </a:solidFill>
          </a:defRPr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124</TotalTime>
  <Words>163</Words>
  <Application>Microsoft Office PowerPoint</Application>
  <PresentationFormat>ユーザー設定</PresentationFormat>
  <Paragraphs>3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明朝</vt:lpstr>
      <vt:lpstr>Arial</vt:lpstr>
      <vt:lpstr>Calibri</vt:lpstr>
      <vt:lpstr>Times New Roman</vt:lpstr>
      <vt:lpstr>Office テーマ</vt:lpstr>
      <vt:lpstr>PowerPoint プレゼンテーション</vt:lpstr>
    </vt:vector>
  </TitlesOfParts>
  <Company>Osaka City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講演タイトル</dc:title>
  <dc:creator>iakai</dc:creator>
  <cp:lastModifiedBy>辻尾 元</cp:lastModifiedBy>
  <cp:revision>1755</cp:revision>
  <cp:lastPrinted>2018-03-25T13:04:50Z</cp:lastPrinted>
  <dcterms:created xsi:type="dcterms:W3CDTF">2006-03-15T01:08:44Z</dcterms:created>
  <dcterms:modified xsi:type="dcterms:W3CDTF">2022-05-06T01:46:32Z</dcterms:modified>
</cp:coreProperties>
</file>